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7" r:id="rId3"/>
    <p:sldId id="258" r:id="rId4"/>
    <p:sldId id="256" r:id="rId5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4" d="100"/>
          <a:sy n="84" d="100"/>
        </p:scale>
        <p:origin x="1382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8094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6965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92520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141766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28958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2972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3031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580326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13645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606527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758452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E155F8-D7BB-4BFA-ADD6-DCB83B1C55E5}" type="datetimeFigureOut">
              <a:rPr lang="zh-TW" altLang="en-US" smtClean="0"/>
              <a:t>2021/8/18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EA2F8A-1AE6-4316-9B23-FCFC6A342F6D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567642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圖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10730" y="843650"/>
            <a:ext cx="6122540" cy="5170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552439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文字方塊 159"/>
          <p:cNvSpPr txBox="1"/>
          <p:nvPr/>
        </p:nvSpPr>
        <p:spPr>
          <a:xfrm>
            <a:off x="7042419" y="0"/>
            <a:ext cx="2101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upplementary Fig 1</a:t>
            </a:r>
            <a:endParaRPr lang="zh-TW" altLang="en-US" dirty="0"/>
          </a:p>
        </p:txBody>
      </p:sp>
      <p:grpSp>
        <p:nvGrpSpPr>
          <p:cNvPr id="165" name="群組 164"/>
          <p:cNvGrpSpPr/>
          <p:nvPr/>
        </p:nvGrpSpPr>
        <p:grpSpPr>
          <a:xfrm>
            <a:off x="1876704" y="1430656"/>
            <a:ext cx="5062577" cy="4038402"/>
            <a:chOff x="1876704" y="1430656"/>
            <a:chExt cx="5062577" cy="4038402"/>
          </a:xfrm>
        </p:grpSpPr>
        <p:grpSp>
          <p:nvGrpSpPr>
            <p:cNvPr id="162" name="群組 161"/>
            <p:cNvGrpSpPr/>
            <p:nvPr/>
          </p:nvGrpSpPr>
          <p:grpSpPr>
            <a:xfrm>
              <a:off x="2238693" y="1430656"/>
              <a:ext cx="4700588" cy="3788291"/>
              <a:chOff x="1598613" y="1476376"/>
              <a:chExt cx="4700588" cy="3788291"/>
            </a:xfrm>
          </p:grpSpPr>
          <p:sp>
            <p:nvSpPr>
              <p:cNvPr id="9" name="Line 7"/>
              <p:cNvSpPr>
                <a:spLocks noChangeShapeType="1"/>
              </p:cNvSpPr>
              <p:nvPr/>
            </p:nvSpPr>
            <p:spPr bwMode="auto">
              <a:xfrm flipV="1">
                <a:off x="2005013" y="1574801"/>
                <a:ext cx="0" cy="3395663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" name="Freeform 8"/>
              <p:cNvSpPr>
                <a:spLocks noEditPoints="1"/>
              </p:cNvSpPr>
              <p:nvPr/>
            </p:nvSpPr>
            <p:spPr bwMode="auto">
              <a:xfrm>
                <a:off x="1949451" y="1574801"/>
                <a:ext cx="55563" cy="3395663"/>
              </a:xfrm>
              <a:custGeom>
                <a:avLst/>
                <a:gdLst>
                  <a:gd name="T0" fmla="*/ 0 w 35"/>
                  <a:gd name="T1" fmla="*/ 2139 h 2139"/>
                  <a:gd name="T2" fmla="*/ 35 w 35"/>
                  <a:gd name="T3" fmla="*/ 2139 h 2139"/>
                  <a:gd name="T4" fmla="*/ 0 w 35"/>
                  <a:gd name="T5" fmla="*/ 1924 h 2139"/>
                  <a:gd name="T6" fmla="*/ 35 w 35"/>
                  <a:gd name="T7" fmla="*/ 1924 h 2139"/>
                  <a:gd name="T8" fmla="*/ 0 w 35"/>
                  <a:gd name="T9" fmla="*/ 1709 h 2139"/>
                  <a:gd name="T10" fmla="*/ 35 w 35"/>
                  <a:gd name="T11" fmla="*/ 1709 h 2139"/>
                  <a:gd name="T12" fmla="*/ 0 w 35"/>
                  <a:gd name="T13" fmla="*/ 1494 h 2139"/>
                  <a:gd name="T14" fmla="*/ 35 w 35"/>
                  <a:gd name="T15" fmla="*/ 1494 h 2139"/>
                  <a:gd name="T16" fmla="*/ 0 w 35"/>
                  <a:gd name="T17" fmla="*/ 1285 h 2139"/>
                  <a:gd name="T18" fmla="*/ 35 w 35"/>
                  <a:gd name="T19" fmla="*/ 1285 h 2139"/>
                  <a:gd name="T20" fmla="*/ 0 w 35"/>
                  <a:gd name="T21" fmla="*/ 1070 h 2139"/>
                  <a:gd name="T22" fmla="*/ 35 w 35"/>
                  <a:gd name="T23" fmla="*/ 1070 h 2139"/>
                  <a:gd name="T24" fmla="*/ 0 w 35"/>
                  <a:gd name="T25" fmla="*/ 855 h 2139"/>
                  <a:gd name="T26" fmla="*/ 35 w 35"/>
                  <a:gd name="T27" fmla="*/ 855 h 2139"/>
                  <a:gd name="T28" fmla="*/ 0 w 35"/>
                  <a:gd name="T29" fmla="*/ 639 h 2139"/>
                  <a:gd name="T30" fmla="*/ 35 w 35"/>
                  <a:gd name="T31" fmla="*/ 639 h 2139"/>
                  <a:gd name="T32" fmla="*/ 0 w 35"/>
                  <a:gd name="T33" fmla="*/ 424 h 2139"/>
                  <a:gd name="T34" fmla="*/ 35 w 35"/>
                  <a:gd name="T35" fmla="*/ 424 h 2139"/>
                  <a:gd name="T36" fmla="*/ 0 w 35"/>
                  <a:gd name="T37" fmla="*/ 209 h 2139"/>
                  <a:gd name="T38" fmla="*/ 35 w 35"/>
                  <a:gd name="T39" fmla="*/ 209 h 2139"/>
                  <a:gd name="T40" fmla="*/ 0 w 35"/>
                  <a:gd name="T41" fmla="*/ 0 h 2139"/>
                  <a:gd name="T42" fmla="*/ 35 w 35"/>
                  <a:gd name="T43" fmla="*/ 0 h 21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35" h="2139">
                    <a:moveTo>
                      <a:pt x="0" y="2139"/>
                    </a:moveTo>
                    <a:lnTo>
                      <a:pt x="35" y="2139"/>
                    </a:lnTo>
                    <a:moveTo>
                      <a:pt x="0" y="1924"/>
                    </a:moveTo>
                    <a:lnTo>
                      <a:pt x="35" y="1924"/>
                    </a:lnTo>
                    <a:moveTo>
                      <a:pt x="0" y="1709"/>
                    </a:moveTo>
                    <a:lnTo>
                      <a:pt x="35" y="1709"/>
                    </a:lnTo>
                    <a:moveTo>
                      <a:pt x="0" y="1494"/>
                    </a:moveTo>
                    <a:lnTo>
                      <a:pt x="35" y="1494"/>
                    </a:lnTo>
                    <a:moveTo>
                      <a:pt x="0" y="1285"/>
                    </a:moveTo>
                    <a:lnTo>
                      <a:pt x="35" y="1285"/>
                    </a:lnTo>
                    <a:moveTo>
                      <a:pt x="0" y="1070"/>
                    </a:moveTo>
                    <a:lnTo>
                      <a:pt x="35" y="1070"/>
                    </a:lnTo>
                    <a:moveTo>
                      <a:pt x="0" y="855"/>
                    </a:moveTo>
                    <a:lnTo>
                      <a:pt x="35" y="855"/>
                    </a:lnTo>
                    <a:moveTo>
                      <a:pt x="0" y="639"/>
                    </a:moveTo>
                    <a:lnTo>
                      <a:pt x="35" y="639"/>
                    </a:lnTo>
                    <a:moveTo>
                      <a:pt x="0" y="424"/>
                    </a:moveTo>
                    <a:lnTo>
                      <a:pt x="35" y="424"/>
                    </a:lnTo>
                    <a:moveTo>
                      <a:pt x="0" y="209"/>
                    </a:moveTo>
                    <a:lnTo>
                      <a:pt x="35" y="209"/>
                    </a:lnTo>
                    <a:moveTo>
                      <a:pt x="0" y="0"/>
                    </a:moveTo>
                    <a:lnTo>
                      <a:pt x="35" y="0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" name="Line 9"/>
              <p:cNvSpPr>
                <a:spLocks noChangeShapeType="1"/>
              </p:cNvSpPr>
              <p:nvPr/>
            </p:nvSpPr>
            <p:spPr bwMode="auto">
              <a:xfrm>
                <a:off x="2005013" y="4970463"/>
                <a:ext cx="4294188" cy="0"/>
              </a:xfrm>
              <a:prstGeom prst="line">
                <a:avLst/>
              </a:pr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" name="Freeform 10"/>
              <p:cNvSpPr>
                <a:spLocks noEditPoints="1"/>
              </p:cNvSpPr>
              <p:nvPr/>
            </p:nvSpPr>
            <p:spPr bwMode="auto">
              <a:xfrm>
                <a:off x="2005013" y="4970463"/>
                <a:ext cx="3957638" cy="49213"/>
              </a:xfrm>
              <a:custGeom>
                <a:avLst/>
                <a:gdLst>
                  <a:gd name="T0" fmla="*/ 0 w 2493"/>
                  <a:gd name="T1" fmla="*/ 0 h 31"/>
                  <a:gd name="T2" fmla="*/ 0 w 2493"/>
                  <a:gd name="T3" fmla="*/ 31 h 31"/>
                  <a:gd name="T4" fmla="*/ 829 w 2493"/>
                  <a:gd name="T5" fmla="*/ 0 h 31"/>
                  <a:gd name="T6" fmla="*/ 829 w 2493"/>
                  <a:gd name="T7" fmla="*/ 31 h 31"/>
                  <a:gd name="T8" fmla="*/ 1664 w 2493"/>
                  <a:gd name="T9" fmla="*/ 0 h 31"/>
                  <a:gd name="T10" fmla="*/ 1664 w 2493"/>
                  <a:gd name="T11" fmla="*/ 31 h 31"/>
                  <a:gd name="T12" fmla="*/ 2493 w 2493"/>
                  <a:gd name="T13" fmla="*/ 0 h 31"/>
                  <a:gd name="T14" fmla="*/ 2493 w 2493"/>
                  <a:gd name="T15" fmla="*/ 31 h 3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2493" h="31">
                    <a:moveTo>
                      <a:pt x="0" y="0"/>
                    </a:moveTo>
                    <a:lnTo>
                      <a:pt x="0" y="31"/>
                    </a:lnTo>
                    <a:moveTo>
                      <a:pt x="829" y="0"/>
                    </a:moveTo>
                    <a:lnTo>
                      <a:pt x="829" y="31"/>
                    </a:lnTo>
                    <a:moveTo>
                      <a:pt x="1664" y="0"/>
                    </a:moveTo>
                    <a:lnTo>
                      <a:pt x="1664" y="31"/>
                    </a:lnTo>
                    <a:moveTo>
                      <a:pt x="2493" y="0"/>
                    </a:moveTo>
                    <a:lnTo>
                      <a:pt x="2493" y="31"/>
                    </a:lnTo>
                  </a:path>
                </a:pathLst>
              </a:custGeom>
              <a:noFill/>
              <a:ln w="9525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3" name="Freeform 11"/>
              <p:cNvSpPr>
                <a:spLocks/>
              </p:cNvSpPr>
              <p:nvPr/>
            </p:nvSpPr>
            <p:spPr bwMode="auto">
              <a:xfrm>
                <a:off x="2070101" y="1574801"/>
                <a:ext cx="4089400" cy="3395663"/>
              </a:xfrm>
              <a:custGeom>
                <a:avLst/>
                <a:gdLst>
                  <a:gd name="T0" fmla="*/ 0 w 2576"/>
                  <a:gd name="T1" fmla="*/ 0 h 2139"/>
                  <a:gd name="T2" fmla="*/ 247 w 2576"/>
                  <a:gd name="T3" fmla="*/ 0 h 2139"/>
                  <a:gd name="T4" fmla="*/ 371 w 2576"/>
                  <a:gd name="T5" fmla="*/ 0 h 2139"/>
                  <a:gd name="T6" fmla="*/ 541 w 2576"/>
                  <a:gd name="T7" fmla="*/ 0 h 2139"/>
                  <a:gd name="T8" fmla="*/ 665 w 2576"/>
                  <a:gd name="T9" fmla="*/ 19 h 2139"/>
                  <a:gd name="T10" fmla="*/ 829 w 2576"/>
                  <a:gd name="T11" fmla="*/ 135 h 2139"/>
                  <a:gd name="T12" fmla="*/ 953 w 2576"/>
                  <a:gd name="T13" fmla="*/ 314 h 2139"/>
                  <a:gd name="T14" fmla="*/ 1123 w 2576"/>
                  <a:gd name="T15" fmla="*/ 381 h 2139"/>
                  <a:gd name="T16" fmla="*/ 1288 w 2576"/>
                  <a:gd name="T17" fmla="*/ 609 h 2139"/>
                  <a:gd name="T18" fmla="*/ 1411 w 2576"/>
                  <a:gd name="T19" fmla="*/ 922 h 2139"/>
                  <a:gd name="T20" fmla="*/ 1535 w 2576"/>
                  <a:gd name="T21" fmla="*/ 1100 h 2139"/>
                  <a:gd name="T22" fmla="*/ 1705 w 2576"/>
                  <a:gd name="T23" fmla="*/ 1574 h 2139"/>
                  <a:gd name="T24" fmla="*/ 1829 w 2576"/>
                  <a:gd name="T25" fmla="*/ 1844 h 2139"/>
                  <a:gd name="T26" fmla="*/ 1993 w 2576"/>
                  <a:gd name="T27" fmla="*/ 1979 h 2139"/>
                  <a:gd name="T28" fmla="*/ 2123 w 2576"/>
                  <a:gd name="T29" fmla="*/ 2071 h 2139"/>
                  <a:gd name="T30" fmla="*/ 2246 w 2576"/>
                  <a:gd name="T31" fmla="*/ 2114 h 2139"/>
                  <a:gd name="T32" fmla="*/ 2287 w 2576"/>
                  <a:gd name="T33" fmla="*/ 2114 h 2139"/>
                  <a:gd name="T34" fmla="*/ 2411 w 2576"/>
                  <a:gd name="T35" fmla="*/ 2114 h 2139"/>
                  <a:gd name="T36" fmla="*/ 2576 w 2576"/>
                  <a:gd name="T37" fmla="*/ 2139 h 21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2576" h="2139">
                    <a:moveTo>
                      <a:pt x="0" y="0"/>
                    </a:moveTo>
                    <a:lnTo>
                      <a:pt x="247" y="0"/>
                    </a:lnTo>
                    <a:lnTo>
                      <a:pt x="371" y="0"/>
                    </a:lnTo>
                    <a:lnTo>
                      <a:pt x="541" y="0"/>
                    </a:lnTo>
                    <a:lnTo>
                      <a:pt x="665" y="19"/>
                    </a:lnTo>
                    <a:lnTo>
                      <a:pt x="829" y="135"/>
                    </a:lnTo>
                    <a:lnTo>
                      <a:pt x="953" y="314"/>
                    </a:lnTo>
                    <a:lnTo>
                      <a:pt x="1123" y="381"/>
                    </a:lnTo>
                    <a:lnTo>
                      <a:pt x="1288" y="609"/>
                    </a:lnTo>
                    <a:lnTo>
                      <a:pt x="1411" y="922"/>
                    </a:lnTo>
                    <a:lnTo>
                      <a:pt x="1535" y="1100"/>
                    </a:lnTo>
                    <a:lnTo>
                      <a:pt x="1705" y="1574"/>
                    </a:lnTo>
                    <a:lnTo>
                      <a:pt x="1829" y="1844"/>
                    </a:lnTo>
                    <a:lnTo>
                      <a:pt x="1993" y="1979"/>
                    </a:lnTo>
                    <a:lnTo>
                      <a:pt x="2123" y="2071"/>
                    </a:lnTo>
                    <a:lnTo>
                      <a:pt x="2246" y="2114"/>
                    </a:lnTo>
                    <a:lnTo>
                      <a:pt x="2287" y="2114"/>
                    </a:lnTo>
                    <a:lnTo>
                      <a:pt x="2411" y="2114"/>
                    </a:lnTo>
                    <a:lnTo>
                      <a:pt x="2576" y="2139"/>
                    </a:lnTo>
                  </a:path>
                </a:pathLst>
              </a:custGeom>
              <a:noFill/>
              <a:ln w="460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4" name="Rectangle 12"/>
              <p:cNvSpPr>
                <a:spLocks noChangeArrowheads="1"/>
              </p:cNvSpPr>
              <p:nvPr/>
            </p:nvSpPr>
            <p:spPr bwMode="auto">
              <a:xfrm>
                <a:off x="2024063" y="1527176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" name="Rectangle 13"/>
              <p:cNvSpPr>
                <a:spLocks noChangeArrowheads="1"/>
              </p:cNvSpPr>
              <p:nvPr/>
            </p:nvSpPr>
            <p:spPr bwMode="auto">
              <a:xfrm>
                <a:off x="2024063" y="1527176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6" name="Rectangle 14"/>
              <p:cNvSpPr>
                <a:spLocks noChangeArrowheads="1"/>
              </p:cNvSpPr>
              <p:nvPr/>
            </p:nvSpPr>
            <p:spPr bwMode="auto">
              <a:xfrm>
                <a:off x="2416176" y="1527176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7" name="Rectangle 15"/>
              <p:cNvSpPr>
                <a:spLocks noChangeArrowheads="1"/>
              </p:cNvSpPr>
              <p:nvPr/>
            </p:nvSpPr>
            <p:spPr bwMode="auto">
              <a:xfrm>
                <a:off x="2416176" y="1527176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8" name="Rectangle 16"/>
              <p:cNvSpPr>
                <a:spLocks noChangeArrowheads="1"/>
              </p:cNvSpPr>
              <p:nvPr/>
            </p:nvSpPr>
            <p:spPr bwMode="auto">
              <a:xfrm>
                <a:off x="2611438" y="1527176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9" name="Rectangle 17"/>
              <p:cNvSpPr>
                <a:spLocks noChangeArrowheads="1"/>
              </p:cNvSpPr>
              <p:nvPr/>
            </p:nvSpPr>
            <p:spPr bwMode="auto">
              <a:xfrm>
                <a:off x="2611438" y="1527176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0" name="Rectangle 18"/>
              <p:cNvSpPr>
                <a:spLocks noChangeArrowheads="1"/>
              </p:cNvSpPr>
              <p:nvPr/>
            </p:nvSpPr>
            <p:spPr bwMode="auto">
              <a:xfrm>
                <a:off x="2882901" y="1527176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1" name="Rectangle 19"/>
              <p:cNvSpPr>
                <a:spLocks noChangeArrowheads="1"/>
              </p:cNvSpPr>
              <p:nvPr/>
            </p:nvSpPr>
            <p:spPr bwMode="auto">
              <a:xfrm>
                <a:off x="2882901" y="1527176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2" name="Rectangle 20"/>
              <p:cNvSpPr>
                <a:spLocks noChangeArrowheads="1"/>
              </p:cNvSpPr>
              <p:nvPr/>
            </p:nvSpPr>
            <p:spPr bwMode="auto">
              <a:xfrm>
                <a:off x="3078163" y="1557338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3" name="Rectangle 21"/>
              <p:cNvSpPr>
                <a:spLocks noChangeArrowheads="1"/>
              </p:cNvSpPr>
              <p:nvPr/>
            </p:nvSpPr>
            <p:spPr bwMode="auto">
              <a:xfrm>
                <a:off x="3078163" y="1557338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4" name="Rectangle 22"/>
              <p:cNvSpPr>
                <a:spLocks noChangeArrowheads="1"/>
              </p:cNvSpPr>
              <p:nvPr/>
            </p:nvSpPr>
            <p:spPr bwMode="auto">
              <a:xfrm>
                <a:off x="3340101" y="1743076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5" name="Rectangle 23"/>
              <p:cNvSpPr>
                <a:spLocks noChangeArrowheads="1"/>
              </p:cNvSpPr>
              <p:nvPr/>
            </p:nvSpPr>
            <p:spPr bwMode="auto">
              <a:xfrm>
                <a:off x="3340101" y="1743076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6" name="Rectangle 24"/>
              <p:cNvSpPr>
                <a:spLocks noChangeArrowheads="1"/>
              </p:cNvSpPr>
              <p:nvPr/>
            </p:nvSpPr>
            <p:spPr bwMode="auto">
              <a:xfrm>
                <a:off x="3535363" y="2025651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7" name="Rectangle 25"/>
              <p:cNvSpPr>
                <a:spLocks noChangeArrowheads="1"/>
              </p:cNvSpPr>
              <p:nvPr/>
            </p:nvSpPr>
            <p:spPr bwMode="auto">
              <a:xfrm>
                <a:off x="3535363" y="2025651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8" name="Rectangle 26"/>
              <p:cNvSpPr>
                <a:spLocks noChangeArrowheads="1"/>
              </p:cNvSpPr>
              <p:nvPr/>
            </p:nvSpPr>
            <p:spPr bwMode="auto">
              <a:xfrm>
                <a:off x="3806826" y="2132013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29" name="Rectangle 27"/>
              <p:cNvSpPr>
                <a:spLocks noChangeArrowheads="1"/>
              </p:cNvSpPr>
              <p:nvPr/>
            </p:nvSpPr>
            <p:spPr bwMode="auto">
              <a:xfrm>
                <a:off x="3806826" y="2132013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0" name="Rectangle 28"/>
              <p:cNvSpPr>
                <a:spLocks noChangeArrowheads="1"/>
              </p:cNvSpPr>
              <p:nvPr/>
            </p:nvSpPr>
            <p:spPr bwMode="auto">
              <a:xfrm>
                <a:off x="4068763" y="2493963"/>
                <a:ext cx="82550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1" name="Rectangle 29"/>
              <p:cNvSpPr>
                <a:spLocks noChangeArrowheads="1"/>
              </p:cNvSpPr>
              <p:nvPr/>
            </p:nvSpPr>
            <p:spPr bwMode="auto">
              <a:xfrm>
                <a:off x="4068763" y="2493963"/>
                <a:ext cx="82550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2" name="Rectangle 30"/>
              <p:cNvSpPr>
                <a:spLocks noChangeArrowheads="1"/>
              </p:cNvSpPr>
              <p:nvPr/>
            </p:nvSpPr>
            <p:spPr bwMode="auto">
              <a:xfrm>
                <a:off x="4264026" y="2990851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3" name="Rectangle 31"/>
              <p:cNvSpPr>
                <a:spLocks noChangeArrowheads="1"/>
              </p:cNvSpPr>
              <p:nvPr/>
            </p:nvSpPr>
            <p:spPr bwMode="auto">
              <a:xfrm>
                <a:off x="4264026" y="2990851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4" name="Rectangle 32"/>
              <p:cNvSpPr>
                <a:spLocks noChangeArrowheads="1"/>
              </p:cNvSpPr>
              <p:nvPr/>
            </p:nvSpPr>
            <p:spPr bwMode="auto">
              <a:xfrm>
                <a:off x="4459288" y="3273426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5" name="Rectangle 33"/>
              <p:cNvSpPr>
                <a:spLocks noChangeArrowheads="1"/>
              </p:cNvSpPr>
              <p:nvPr/>
            </p:nvSpPr>
            <p:spPr bwMode="auto">
              <a:xfrm>
                <a:off x="4459288" y="3273426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6" name="Rectangle 34"/>
              <p:cNvSpPr>
                <a:spLocks noChangeArrowheads="1"/>
              </p:cNvSpPr>
              <p:nvPr/>
            </p:nvSpPr>
            <p:spPr bwMode="auto">
              <a:xfrm>
                <a:off x="4730751" y="4025901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7" name="Rectangle 35"/>
              <p:cNvSpPr>
                <a:spLocks noChangeArrowheads="1"/>
              </p:cNvSpPr>
              <p:nvPr/>
            </p:nvSpPr>
            <p:spPr bwMode="auto">
              <a:xfrm>
                <a:off x="4730751" y="4025901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8" name="Rectangle 36"/>
              <p:cNvSpPr>
                <a:spLocks noChangeArrowheads="1"/>
              </p:cNvSpPr>
              <p:nvPr/>
            </p:nvSpPr>
            <p:spPr bwMode="auto">
              <a:xfrm>
                <a:off x="4926013" y="4454526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39" name="Rectangle 37"/>
              <p:cNvSpPr>
                <a:spLocks noChangeArrowheads="1"/>
              </p:cNvSpPr>
              <p:nvPr/>
            </p:nvSpPr>
            <p:spPr bwMode="auto">
              <a:xfrm>
                <a:off x="4926013" y="4454526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0" name="Rectangle 38"/>
              <p:cNvSpPr>
                <a:spLocks noChangeArrowheads="1"/>
              </p:cNvSpPr>
              <p:nvPr/>
            </p:nvSpPr>
            <p:spPr bwMode="auto">
              <a:xfrm>
                <a:off x="5187951" y="4668838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1" name="Rectangle 39"/>
              <p:cNvSpPr>
                <a:spLocks noChangeArrowheads="1"/>
              </p:cNvSpPr>
              <p:nvPr/>
            </p:nvSpPr>
            <p:spPr bwMode="auto">
              <a:xfrm>
                <a:off x="5187951" y="4668838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2" name="Rectangle 40"/>
              <p:cNvSpPr>
                <a:spLocks noChangeArrowheads="1"/>
              </p:cNvSpPr>
              <p:nvPr/>
            </p:nvSpPr>
            <p:spPr bwMode="auto">
              <a:xfrm>
                <a:off x="5392738" y="4814888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3" name="Rectangle 41"/>
              <p:cNvSpPr>
                <a:spLocks noChangeArrowheads="1"/>
              </p:cNvSpPr>
              <p:nvPr/>
            </p:nvSpPr>
            <p:spPr bwMode="auto">
              <a:xfrm>
                <a:off x="5392738" y="4814888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4" name="Rectangle 42"/>
              <p:cNvSpPr>
                <a:spLocks noChangeArrowheads="1"/>
              </p:cNvSpPr>
              <p:nvPr/>
            </p:nvSpPr>
            <p:spPr bwMode="auto">
              <a:xfrm>
                <a:off x="5589588" y="4884738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5" name="Rectangle 43"/>
              <p:cNvSpPr>
                <a:spLocks noChangeArrowheads="1"/>
              </p:cNvSpPr>
              <p:nvPr/>
            </p:nvSpPr>
            <p:spPr bwMode="auto">
              <a:xfrm>
                <a:off x="5589588" y="4884738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6" name="Rectangle 44"/>
              <p:cNvSpPr>
                <a:spLocks noChangeArrowheads="1"/>
              </p:cNvSpPr>
              <p:nvPr/>
            </p:nvSpPr>
            <p:spPr bwMode="auto">
              <a:xfrm>
                <a:off x="5654676" y="4884738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7" name="Rectangle 45"/>
              <p:cNvSpPr>
                <a:spLocks noChangeArrowheads="1"/>
              </p:cNvSpPr>
              <p:nvPr/>
            </p:nvSpPr>
            <p:spPr bwMode="auto">
              <a:xfrm>
                <a:off x="5654676" y="4884738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8" name="Rectangle 46"/>
              <p:cNvSpPr>
                <a:spLocks noChangeArrowheads="1"/>
              </p:cNvSpPr>
              <p:nvPr/>
            </p:nvSpPr>
            <p:spPr bwMode="auto">
              <a:xfrm>
                <a:off x="5851526" y="4884738"/>
                <a:ext cx="82550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49" name="Rectangle 47"/>
              <p:cNvSpPr>
                <a:spLocks noChangeArrowheads="1"/>
              </p:cNvSpPr>
              <p:nvPr/>
            </p:nvSpPr>
            <p:spPr bwMode="auto">
              <a:xfrm>
                <a:off x="5851526" y="4884738"/>
                <a:ext cx="82550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0" name="Rectangle 48"/>
              <p:cNvSpPr>
                <a:spLocks noChangeArrowheads="1"/>
              </p:cNvSpPr>
              <p:nvPr/>
            </p:nvSpPr>
            <p:spPr bwMode="auto">
              <a:xfrm>
                <a:off x="6111876" y="4922838"/>
                <a:ext cx="84138" cy="87313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1" name="Rectangle 49"/>
              <p:cNvSpPr>
                <a:spLocks noChangeArrowheads="1"/>
              </p:cNvSpPr>
              <p:nvPr/>
            </p:nvSpPr>
            <p:spPr bwMode="auto">
              <a:xfrm>
                <a:off x="6111876" y="4922838"/>
                <a:ext cx="84138" cy="87313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2" name="Freeform 50"/>
              <p:cNvSpPr>
                <a:spLocks noEditPoints="1"/>
              </p:cNvSpPr>
              <p:nvPr/>
            </p:nvSpPr>
            <p:spPr bwMode="auto">
              <a:xfrm>
                <a:off x="2047876" y="1550988"/>
                <a:ext cx="4133850" cy="3443288"/>
              </a:xfrm>
              <a:custGeom>
                <a:avLst/>
                <a:gdLst>
                  <a:gd name="T0" fmla="*/ 200 w 7088"/>
                  <a:gd name="T1" fmla="*/ 80 h 5648"/>
                  <a:gd name="T2" fmla="*/ 360 w 7088"/>
                  <a:gd name="T3" fmla="*/ 0 h 5648"/>
                  <a:gd name="T4" fmla="*/ 360 w 7088"/>
                  <a:gd name="T5" fmla="*/ 80 h 5648"/>
                  <a:gd name="T6" fmla="*/ 712 w 7088"/>
                  <a:gd name="T7" fmla="*/ 0 h 5648"/>
                  <a:gd name="T8" fmla="*/ 712 w 7088"/>
                  <a:gd name="T9" fmla="*/ 80 h 5648"/>
                  <a:gd name="T10" fmla="*/ 1000 w 7088"/>
                  <a:gd name="T11" fmla="*/ 0 h 5648"/>
                  <a:gd name="T12" fmla="*/ 1160 w 7088"/>
                  <a:gd name="T13" fmla="*/ 80 h 5648"/>
                  <a:gd name="T14" fmla="*/ 1000 w 7088"/>
                  <a:gd name="T15" fmla="*/ 0 h 5648"/>
                  <a:gd name="T16" fmla="*/ 1480 w 7088"/>
                  <a:gd name="T17" fmla="*/ 80 h 5648"/>
                  <a:gd name="T18" fmla="*/ 1640 w 7088"/>
                  <a:gd name="T19" fmla="*/ 0 h 5648"/>
                  <a:gd name="T20" fmla="*/ 1640 w 7088"/>
                  <a:gd name="T21" fmla="*/ 80 h 5648"/>
                  <a:gd name="T22" fmla="*/ 2122 w 7088"/>
                  <a:gd name="T23" fmla="*/ 68 h 5648"/>
                  <a:gd name="T24" fmla="*/ 1947 w 7088"/>
                  <a:gd name="T25" fmla="*/ 106 h 5648"/>
                  <a:gd name="T26" fmla="*/ 2277 w 7088"/>
                  <a:gd name="T27" fmla="*/ 106 h 5648"/>
                  <a:gd name="T28" fmla="*/ 2417 w 7088"/>
                  <a:gd name="T29" fmla="*/ 216 h 5648"/>
                  <a:gd name="T30" fmla="*/ 2277 w 7088"/>
                  <a:gd name="T31" fmla="*/ 106 h 5648"/>
                  <a:gd name="T32" fmla="*/ 2733 w 7088"/>
                  <a:gd name="T33" fmla="*/ 273 h 5648"/>
                  <a:gd name="T34" fmla="*/ 2602 w 7088"/>
                  <a:gd name="T35" fmla="*/ 242 h 5648"/>
                  <a:gd name="T36" fmla="*/ 2589 w 7088"/>
                  <a:gd name="T37" fmla="*/ 167 h 5648"/>
                  <a:gd name="T38" fmla="*/ 2880 w 7088"/>
                  <a:gd name="T39" fmla="*/ 568 h 5648"/>
                  <a:gd name="T40" fmla="*/ 3045 w 7088"/>
                  <a:gd name="T41" fmla="*/ 638 h 5648"/>
                  <a:gd name="T42" fmla="*/ 3127 w 7088"/>
                  <a:gd name="T43" fmla="*/ 827 h 5648"/>
                  <a:gd name="T44" fmla="*/ 2984 w 7088"/>
                  <a:gd name="T45" fmla="*/ 690 h 5648"/>
                  <a:gd name="T46" fmla="*/ 3278 w 7088"/>
                  <a:gd name="T47" fmla="*/ 1066 h 5648"/>
                  <a:gd name="T48" fmla="*/ 3160 w 7088"/>
                  <a:gd name="T49" fmla="*/ 900 h 5648"/>
                  <a:gd name="T50" fmla="*/ 3390 w 7088"/>
                  <a:gd name="T51" fmla="*/ 1410 h 5648"/>
                  <a:gd name="T52" fmla="*/ 3344 w 7088"/>
                  <a:gd name="T53" fmla="*/ 1212 h 5648"/>
                  <a:gd name="T54" fmla="*/ 3469 w 7088"/>
                  <a:gd name="T55" fmla="*/ 1682 h 5648"/>
                  <a:gd name="T56" fmla="*/ 3612 w 7088"/>
                  <a:gd name="T57" fmla="*/ 1786 h 5648"/>
                  <a:gd name="T58" fmla="*/ 3544 w 7088"/>
                  <a:gd name="T59" fmla="*/ 1829 h 5648"/>
                  <a:gd name="T60" fmla="*/ 3865 w 7088"/>
                  <a:gd name="T61" fmla="*/ 2195 h 5648"/>
                  <a:gd name="T62" fmla="*/ 3726 w 7088"/>
                  <a:gd name="T63" fmla="*/ 2046 h 5648"/>
                  <a:gd name="T64" fmla="*/ 4017 w 7088"/>
                  <a:gd name="T65" fmla="*/ 2524 h 5648"/>
                  <a:gd name="T66" fmla="*/ 3948 w 7088"/>
                  <a:gd name="T67" fmla="*/ 2332 h 5648"/>
                  <a:gd name="T68" fmla="*/ 4127 w 7088"/>
                  <a:gd name="T69" fmla="*/ 2785 h 5648"/>
                  <a:gd name="T70" fmla="*/ 4277 w 7088"/>
                  <a:gd name="T71" fmla="*/ 2883 h 5648"/>
                  <a:gd name="T72" fmla="*/ 4206 w 7088"/>
                  <a:gd name="T73" fmla="*/ 2921 h 5648"/>
                  <a:gd name="T74" fmla="*/ 4507 w 7088"/>
                  <a:gd name="T75" fmla="*/ 3304 h 5648"/>
                  <a:gd name="T76" fmla="*/ 4376 w 7088"/>
                  <a:gd name="T77" fmla="*/ 3148 h 5648"/>
                  <a:gd name="T78" fmla="*/ 4645 w 7088"/>
                  <a:gd name="T79" fmla="*/ 3639 h 5648"/>
                  <a:gd name="T80" fmla="*/ 4584 w 7088"/>
                  <a:gd name="T81" fmla="*/ 3445 h 5648"/>
                  <a:gd name="T82" fmla="*/ 4752 w 7088"/>
                  <a:gd name="T83" fmla="*/ 3901 h 5648"/>
                  <a:gd name="T84" fmla="*/ 4903 w 7088"/>
                  <a:gd name="T85" fmla="*/ 3997 h 5648"/>
                  <a:gd name="T86" fmla="*/ 4834 w 7088"/>
                  <a:gd name="T87" fmla="*/ 4039 h 5648"/>
                  <a:gd name="T88" fmla="*/ 5157 w 7088"/>
                  <a:gd name="T89" fmla="*/ 4402 h 5648"/>
                  <a:gd name="T90" fmla="*/ 5012 w 7088"/>
                  <a:gd name="T91" fmla="*/ 4258 h 5648"/>
                  <a:gd name="T92" fmla="*/ 5323 w 7088"/>
                  <a:gd name="T93" fmla="*/ 4724 h 5648"/>
                  <a:gd name="T94" fmla="*/ 5245 w 7088"/>
                  <a:gd name="T95" fmla="*/ 4536 h 5648"/>
                  <a:gd name="T96" fmla="*/ 5508 w 7088"/>
                  <a:gd name="T97" fmla="*/ 4917 h 5648"/>
                  <a:gd name="T98" fmla="*/ 5431 w 7088"/>
                  <a:gd name="T99" fmla="*/ 4959 h 5648"/>
                  <a:gd name="T100" fmla="*/ 5640 w 7088"/>
                  <a:gd name="T101" fmla="*/ 5008 h 5648"/>
                  <a:gd name="T102" fmla="*/ 5595 w 7088"/>
                  <a:gd name="T103" fmla="*/ 5074 h 5648"/>
                  <a:gd name="T104" fmla="*/ 6031 w 7088"/>
                  <a:gd name="T105" fmla="*/ 5289 h 5648"/>
                  <a:gd name="T106" fmla="*/ 5847 w 7088"/>
                  <a:gd name="T107" fmla="*/ 5200 h 5648"/>
                  <a:gd name="T108" fmla="*/ 6152 w 7088"/>
                  <a:gd name="T109" fmla="*/ 5392 h 5648"/>
                  <a:gd name="T110" fmla="*/ 6322 w 7088"/>
                  <a:gd name="T111" fmla="*/ 5462 h 5648"/>
                  <a:gd name="T112" fmla="*/ 6152 w 7088"/>
                  <a:gd name="T113" fmla="*/ 5472 h 5648"/>
                  <a:gd name="T114" fmla="*/ 6158 w 7088"/>
                  <a:gd name="T115" fmla="*/ 5386 h 5648"/>
                  <a:gd name="T116" fmla="*/ 6551 w 7088"/>
                  <a:gd name="T117" fmla="*/ 5628 h 5648"/>
                  <a:gd name="T118" fmla="*/ 6726 w 7088"/>
                  <a:gd name="T119" fmla="*/ 5568 h 5648"/>
                  <a:gd name="T120" fmla="*/ 6726 w 7088"/>
                  <a:gd name="T121" fmla="*/ 5648 h 5648"/>
                  <a:gd name="T122" fmla="*/ 7048 w 7088"/>
                  <a:gd name="T123" fmla="*/ 5568 h 5648"/>
                  <a:gd name="T124" fmla="*/ 7006 w 7088"/>
                  <a:gd name="T125" fmla="*/ 5608 h 56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  <a:cxn ang="0">
                    <a:pos x="T114" y="T115"/>
                  </a:cxn>
                  <a:cxn ang="0">
                    <a:pos x="T116" y="T117"/>
                  </a:cxn>
                  <a:cxn ang="0">
                    <a:pos x="T118" y="T119"/>
                  </a:cxn>
                  <a:cxn ang="0">
                    <a:pos x="T120" y="T121"/>
                  </a:cxn>
                  <a:cxn ang="0">
                    <a:pos x="T122" y="T123"/>
                  </a:cxn>
                  <a:cxn ang="0">
                    <a:pos x="T124" y="T125"/>
                  </a:cxn>
                </a:cxnLst>
                <a:rect l="0" t="0" r="r" b="b"/>
                <a:pathLst>
                  <a:path w="7088" h="5648">
                    <a:moveTo>
                      <a:pt x="40" y="0"/>
                    </a:moveTo>
                    <a:lnTo>
                      <a:pt x="200" y="0"/>
                    </a:lnTo>
                    <a:cubicBezTo>
                      <a:pt x="223" y="0"/>
                      <a:pt x="240" y="18"/>
                      <a:pt x="240" y="40"/>
                    </a:cubicBezTo>
                    <a:cubicBezTo>
                      <a:pt x="240" y="63"/>
                      <a:pt x="223" y="80"/>
                      <a:pt x="200" y="80"/>
                    </a:cubicBezTo>
                    <a:lnTo>
                      <a:pt x="40" y="80"/>
                    </a:lnTo>
                    <a:cubicBezTo>
                      <a:pt x="18" y="80"/>
                      <a:pt x="0" y="63"/>
                      <a:pt x="0" y="40"/>
                    </a:cubicBezTo>
                    <a:cubicBezTo>
                      <a:pt x="0" y="18"/>
                      <a:pt x="18" y="0"/>
                      <a:pt x="40" y="0"/>
                    </a:cubicBezTo>
                    <a:close/>
                    <a:moveTo>
                      <a:pt x="360" y="0"/>
                    </a:moveTo>
                    <a:lnTo>
                      <a:pt x="520" y="0"/>
                    </a:lnTo>
                    <a:cubicBezTo>
                      <a:pt x="543" y="0"/>
                      <a:pt x="560" y="18"/>
                      <a:pt x="560" y="40"/>
                    </a:cubicBezTo>
                    <a:cubicBezTo>
                      <a:pt x="560" y="63"/>
                      <a:pt x="543" y="80"/>
                      <a:pt x="520" y="80"/>
                    </a:cubicBezTo>
                    <a:lnTo>
                      <a:pt x="360" y="80"/>
                    </a:lnTo>
                    <a:cubicBezTo>
                      <a:pt x="338" y="80"/>
                      <a:pt x="320" y="63"/>
                      <a:pt x="320" y="40"/>
                    </a:cubicBezTo>
                    <a:cubicBezTo>
                      <a:pt x="320" y="18"/>
                      <a:pt x="338" y="0"/>
                      <a:pt x="360" y="0"/>
                    </a:cubicBezTo>
                    <a:close/>
                    <a:moveTo>
                      <a:pt x="680" y="0"/>
                    </a:moveTo>
                    <a:lnTo>
                      <a:pt x="712" y="0"/>
                    </a:lnTo>
                    <a:lnTo>
                      <a:pt x="840" y="0"/>
                    </a:lnTo>
                    <a:cubicBezTo>
                      <a:pt x="863" y="0"/>
                      <a:pt x="880" y="18"/>
                      <a:pt x="880" y="40"/>
                    </a:cubicBezTo>
                    <a:cubicBezTo>
                      <a:pt x="880" y="63"/>
                      <a:pt x="863" y="80"/>
                      <a:pt x="840" y="80"/>
                    </a:cubicBezTo>
                    <a:lnTo>
                      <a:pt x="712" y="80"/>
                    </a:lnTo>
                    <a:lnTo>
                      <a:pt x="680" y="80"/>
                    </a:lnTo>
                    <a:cubicBezTo>
                      <a:pt x="658" y="80"/>
                      <a:pt x="640" y="63"/>
                      <a:pt x="640" y="40"/>
                    </a:cubicBezTo>
                    <a:cubicBezTo>
                      <a:pt x="640" y="18"/>
                      <a:pt x="658" y="0"/>
                      <a:pt x="680" y="0"/>
                    </a:cubicBezTo>
                    <a:close/>
                    <a:moveTo>
                      <a:pt x="1000" y="0"/>
                    </a:moveTo>
                    <a:lnTo>
                      <a:pt x="1048" y="0"/>
                    </a:lnTo>
                    <a:lnTo>
                      <a:pt x="1160" y="0"/>
                    </a:lnTo>
                    <a:cubicBezTo>
                      <a:pt x="1183" y="0"/>
                      <a:pt x="1200" y="18"/>
                      <a:pt x="1200" y="40"/>
                    </a:cubicBezTo>
                    <a:cubicBezTo>
                      <a:pt x="1200" y="63"/>
                      <a:pt x="1183" y="80"/>
                      <a:pt x="1160" y="80"/>
                    </a:cubicBezTo>
                    <a:lnTo>
                      <a:pt x="1048" y="80"/>
                    </a:lnTo>
                    <a:lnTo>
                      <a:pt x="1000" y="80"/>
                    </a:lnTo>
                    <a:cubicBezTo>
                      <a:pt x="978" y="80"/>
                      <a:pt x="960" y="63"/>
                      <a:pt x="960" y="40"/>
                    </a:cubicBezTo>
                    <a:cubicBezTo>
                      <a:pt x="960" y="18"/>
                      <a:pt x="978" y="0"/>
                      <a:pt x="1000" y="0"/>
                    </a:cubicBezTo>
                    <a:close/>
                    <a:moveTo>
                      <a:pt x="1320" y="0"/>
                    </a:moveTo>
                    <a:lnTo>
                      <a:pt x="1480" y="0"/>
                    </a:lnTo>
                    <a:cubicBezTo>
                      <a:pt x="1503" y="0"/>
                      <a:pt x="1520" y="18"/>
                      <a:pt x="1520" y="40"/>
                    </a:cubicBezTo>
                    <a:cubicBezTo>
                      <a:pt x="1520" y="63"/>
                      <a:pt x="1503" y="80"/>
                      <a:pt x="1480" y="80"/>
                    </a:cubicBezTo>
                    <a:lnTo>
                      <a:pt x="1320" y="80"/>
                    </a:lnTo>
                    <a:cubicBezTo>
                      <a:pt x="1298" y="80"/>
                      <a:pt x="1280" y="63"/>
                      <a:pt x="1280" y="40"/>
                    </a:cubicBezTo>
                    <a:cubicBezTo>
                      <a:pt x="1280" y="18"/>
                      <a:pt x="1298" y="0"/>
                      <a:pt x="1320" y="0"/>
                    </a:cubicBezTo>
                    <a:close/>
                    <a:moveTo>
                      <a:pt x="1640" y="0"/>
                    </a:moveTo>
                    <a:lnTo>
                      <a:pt x="1800" y="0"/>
                    </a:lnTo>
                    <a:cubicBezTo>
                      <a:pt x="1823" y="0"/>
                      <a:pt x="1840" y="18"/>
                      <a:pt x="1840" y="40"/>
                    </a:cubicBezTo>
                    <a:cubicBezTo>
                      <a:pt x="1840" y="63"/>
                      <a:pt x="1823" y="80"/>
                      <a:pt x="1800" y="80"/>
                    </a:cubicBezTo>
                    <a:lnTo>
                      <a:pt x="1640" y="80"/>
                    </a:lnTo>
                    <a:cubicBezTo>
                      <a:pt x="1618" y="80"/>
                      <a:pt x="1600" y="63"/>
                      <a:pt x="1600" y="40"/>
                    </a:cubicBezTo>
                    <a:cubicBezTo>
                      <a:pt x="1600" y="18"/>
                      <a:pt x="1618" y="0"/>
                      <a:pt x="1640" y="0"/>
                    </a:cubicBezTo>
                    <a:close/>
                    <a:moveTo>
                      <a:pt x="1967" y="29"/>
                    </a:moveTo>
                    <a:lnTo>
                      <a:pt x="2122" y="68"/>
                    </a:lnTo>
                    <a:lnTo>
                      <a:pt x="2122" y="68"/>
                    </a:lnTo>
                    <a:cubicBezTo>
                      <a:pt x="2143" y="73"/>
                      <a:pt x="2157" y="95"/>
                      <a:pt x="2151" y="116"/>
                    </a:cubicBezTo>
                    <a:cubicBezTo>
                      <a:pt x="2146" y="138"/>
                      <a:pt x="2124" y="151"/>
                      <a:pt x="2103" y="145"/>
                    </a:cubicBezTo>
                    <a:lnTo>
                      <a:pt x="1947" y="106"/>
                    </a:lnTo>
                    <a:lnTo>
                      <a:pt x="1947" y="106"/>
                    </a:lnTo>
                    <a:cubicBezTo>
                      <a:pt x="1926" y="101"/>
                      <a:pt x="1913" y="79"/>
                      <a:pt x="1918" y="58"/>
                    </a:cubicBezTo>
                    <a:cubicBezTo>
                      <a:pt x="1924" y="36"/>
                      <a:pt x="1945" y="23"/>
                      <a:pt x="1967" y="29"/>
                    </a:cubicBezTo>
                    <a:close/>
                    <a:moveTo>
                      <a:pt x="2277" y="106"/>
                    </a:moveTo>
                    <a:lnTo>
                      <a:pt x="2306" y="114"/>
                    </a:lnTo>
                    <a:lnTo>
                      <a:pt x="2432" y="138"/>
                    </a:lnTo>
                    <a:cubicBezTo>
                      <a:pt x="2454" y="142"/>
                      <a:pt x="2468" y="163"/>
                      <a:pt x="2464" y="184"/>
                    </a:cubicBezTo>
                    <a:cubicBezTo>
                      <a:pt x="2460" y="206"/>
                      <a:pt x="2439" y="220"/>
                      <a:pt x="2417" y="216"/>
                    </a:cubicBezTo>
                    <a:lnTo>
                      <a:pt x="2287" y="191"/>
                    </a:lnTo>
                    <a:lnTo>
                      <a:pt x="2258" y="184"/>
                    </a:lnTo>
                    <a:cubicBezTo>
                      <a:pt x="2236" y="179"/>
                      <a:pt x="2223" y="157"/>
                      <a:pt x="2229" y="136"/>
                    </a:cubicBezTo>
                    <a:cubicBezTo>
                      <a:pt x="2234" y="114"/>
                      <a:pt x="2256" y="101"/>
                      <a:pt x="2277" y="106"/>
                    </a:cubicBezTo>
                    <a:close/>
                    <a:moveTo>
                      <a:pt x="2589" y="167"/>
                    </a:moveTo>
                    <a:lnTo>
                      <a:pt x="2640" y="177"/>
                    </a:lnTo>
                    <a:cubicBezTo>
                      <a:pt x="2649" y="179"/>
                      <a:pt x="2657" y="184"/>
                      <a:pt x="2663" y="191"/>
                    </a:cubicBezTo>
                    <a:lnTo>
                      <a:pt x="2733" y="273"/>
                    </a:lnTo>
                    <a:lnTo>
                      <a:pt x="2733" y="273"/>
                    </a:lnTo>
                    <a:cubicBezTo>
                      <a:pt x="2747" y="290"/>
                      <a:pt x="2745" y="315"/>
                      <a:pt x="2729" y="329"/>
                    </a:cubicBezTo>
                    <a:cubicBezTo>
                      <a:pt x="2712" y="344"/>
                      <a:pt x="2687" y="342"/>
                      <a:pt x="2672" y="325"/>
                    </a:cubicBezTo>
                    <a:lnTo>
                      <a:pt x="2602" y="242"/>
                    </a:lnTo>
                    <a:lnTo>
                      <a:pt x="2625" y="256"/>
                    </a:lnTo>
                    <a:lnTo>
                      <a:pt x="2574" y="246"/>
                    </a:lnTo>
                    <a:cubicBezTo>
                      <a:pt x="2552" y="242"/>
                      <a:pt x="2538" y="221"/>
                      <a:pt x="2542" y="199"/>
                    </a:cubicBezTo>
                    <a:cubicBezTo>
                      <a:pt x="2546" y="178"/>
                      <a:pt x="2567" y="163"/>
                      <a:pt x="2589" y="167"/>
                    </a:cubicBezTo>
                    <a:close/>
                    <a:moveTo>
                      <a:pt x="2837" y="395"/>
                    </a:moveTo>
                    <a:lnTo>
                      <a:pt x="2941" y="516"/>
                    </a:lnTo>
                    <a:cubicBezTo>
                      <a:pt x="2955" y="533"/>
                      <a:pt x="2953" y="558"/>
                      <a:pt x="2936" y="573"/>
                    </a:cubicBezTo>
                    <a:cubicBezTo>
                      <a:pt x="2919" y="587"/>
                      <a:pt x="2894" y="585"/>
                      <a:pt x="2880" y="568"/>
                    </a:cubicBezTo>
                    <a:lnTo>
                      <a:pt x="2776" y="446"/>
                    </a:lnTo>
                    <a:cubicBezTo>
                      <a:pt x="2762" y="430"/>
                      <a:pt x="2764" y="404"/>
                      <a:pt x="2781" y="390"/>
                    </a:cubicBezTo>
                    <a:cubicBezTo>
                      <a:pt x="2797" y="376"/>
                      <a:pt x="2823" y="378"/>
                      <a:pt x="2837" y="395"/>
                    </a:cubicBezTo>
                    <a:close/>
                    <a:moveTo>
                      <a:pt x="3045" y="638"/>
                    </a:moveTo>
                    <a:lnTo>
                      <a:pt x="3127" y="735"/>
                    </a:lnTo>
                    <a:cubicBezTo>
                      <a:pt x="3129" y="737"/>
                      <a:pt x="3131" y="741"/>
                      <a:pt x="3133" y="744"/>
                    </a:cubicBezTo>
                    <a:lnTo>
                      <a:pt x="3147" y="774"/>
                    </a:lnTo>
                    <a:cubicBezTo>
                      <a:pt x="3156" y="794"/>
                      <a:pt x="3147" y="818"/>
                      <a:pt x="3127" y="827"/>
                    </a:cubicBezTo>
                    <a:cubicBezTo>
                      <a:pt x="3106" y="836"/>
                      <a:pt x="3083" y="827"/>
                      <a:pt x="3074" y="807"/>
                    </a:cubicBezTo>
                    <a:lnTo>
                      <a:pt x="3060" y="777"/>
                    </a:lnTo>
                    <a:lnTo>
                      <a:pt x="3066" y="786"/>
                    </a:lnTo>
                    <a:lnTo>
                      <a:pt x="2984" y="690"/>
                    </a:lnTo>
                    <a:cubicBezTo>
                      <a:pt x="2969" y="673"/>
                      <a:pt x="2971" y="648"/>
                      <a:pt x="2988" y="634"/>
                    </a:cubicBezTo>
                    <a:cubicBezTo>
                      <a:pt x="3005" y="619"/>
                      <a:pt x="3030" y="621"/>
                      <a:pt x="3045" y="638"/>
                    </a:cubicBezTo>
                    <a:close/>
                    <a:moveTo>
                      <a:pt x="3212" y="920"/>
                    </a:moveTo>
                    <a:lnTo>
                      <a:pt x="3278" y="1066"/>
                    </a:lnTo>
                    <a:cubicBezTo>
                      <a:pt x="3287" y="1086"/>
                      <a:pt x="3278" y="1110"/>
                      <a:pt x="3258" y="1119"/>
                    </a:cubicBezTo>
                    <a:cubicBezTo>
                      <a:pt x="3238" y="1128"/>
                      <a:pt x="3214" y="1119"/>
                      <a:pt x="3205" y="1099"/>
                    </a:cubicBezTo>
                    <a:lnTo>
                      <a:pt x="3140" y="953"/>
                    </a:lnTo>
                    <a:cubicBezTo>
                      <a:pt x="3130" y="933"/>
                      <a:pt x="3139" y="909"/>
                      <a:pt x="3160" y="900"/>
                    </a:cubicBezTo>
                    <a:cubicBezTo>
                      <a:pt x="3180" y="891"/>
                      <a:pt x="3203" y="900"/>
                      <a:pt x="3212" y="920"/>
                    </a:cubicBezTo>
                    <a:close/>
                    <a:moveTo>
                      <a:pt x="3344" y="1212"/>
                    </a:moveTo>
                    <a:lnTo>
                      <a:pt x="3410" y="1358"/>
                    </a:lnTo>
                    <a:cubicBezTo>
                      <a:pt x="3419" y="1378"/>
                      <a:pt x="3410" y="1401"/>
                      <a:pt x="3390" y="1410"/>
                    </a:cubicBezTo>
                    <a:cubicBezTo>
                      <a:pt x="3370" y="1420"/>
                      <a:pt x="3346" y="1411"/>
                      <a:pt x="3337" y="1390"/>
                    </a:cubicBezTo>
                    <a:lnTo>
                      <a:pt x="3271" y="1245"/>
                    </a:lnTo>
                    <a:cubicBezTo>
                      <a:pt x="3262" y="1224"/>
                      <a:pt x="3271" y="1201"/>
                      <a:pt x="3291" y="1192"/>
                    </a:cubicBezTo>
                    <a:cubicBezTo>
                      <a:pt x="3311" y="1183"/>
                      <a:pt x="3335" y="1192"/>
                      <a:pt x="3344" y="1212"/>
                    </a:cubicBezTo>
                    <a:close/>
                    <a:moveTo>
                      <a:pt x="3476" y="1503"/>
                    </a:moveTo>
                    <a:lnTo>
                      <a:pt x="3542" y="1649"/>
                    </a:lnTo>
                    <a:cubicBezTo>
                      <a:pt x="3551" y="1669"/>
                      <a:pt x="3542" y="1693"/>
                      <a:pt x="3522" y="1702"/>
                    </a:cubicBezTo>
                    <a:cubicBezTo>
                      <a:pt x="3502" y="1711"/>
                      <a:pt x="3478" y="1702"/>
                      <a:pt x="3469" y="1682"/>
                    </a:cubicBezTo>
                    <a:lnTo>
                      <a:pt x="3403" y="1536"/>
                    </a:lnTo>
                    <a:cubicBezTo>
                      <a:pt x="3394" y="1516"/>
                      <a:pt x="3403" y="1492"/>
                      <a:pt x="3423" y="1483"/>
                    </a:cubicBezTo>
                    <a:cubicBezTo>
                      <a:pt x="3443" y="1474"/>
                      <a:pt x="3467" y="1483"/>
                      <a:pt x="3476" y="1503"/>
                    </a:cubicBezTo>
                    <a:close/>
                    <a:moveTo>
                      <a:pt x="3612" y="1786"/>
                    </a:moveTo>
                    <a:lnTo>
                      <a:pt x="3697" y="1923"/>
                    </a:lnTo>
                    <a:cubicBezTo>
                      <a:pt x="3708" y="1941"/>
                      <a:pt x="3702" y="1966"/>
                      <a:pt x="3684" y="1978"/>
                    </a:cubicBezTo>
                    <a:cubicBezTo>
                      <a:pt x="3665" y="1989"/>
                      <a:pt x="3640" y="1983"/>
                      <a:pt x="3629" y="1965"/>
                    </a:cubicBezTo>
                    <a:lnTo>
                      <a:pt x="3544" y="1829"/>
                    </a:lnTo>
                    <a:cubicBezTo>
                      <a:pt x="3533" y="1810"/>
                      <a:pt x="3539" y="1785"/>
                      <a:pt x="3557" y="1773"/>
                    </a:cubicBezTo>
                    <a:cubicBezTo>
                      <a:pt x="3576" y="1762"/>
                      <a:pt x="3601" y="1768"/>
                      <a:pt x="3612" y="1786"/>
                    </a:cubicBezTo>
                    <a:close/>
                    <a:moveTo>
                      <a:pt x="3781" y="2059"/>
                    </a:moveTo>
                    <a:lnTo>
                      <a:pt x="3865" y="2195"/>
                    </a:lnTo>
                    <a:cubicBezTo>
                      <a:pt x="3876" y="2214"/>
                      <a:pt x="3871" y="2238"/>
                      <a:pt x="3852" y="2250"/>
                    </a:cubicBezTo>
                    <a:cubicBezTo>
                      <a:pt x="3833" y="2262"/>
                      <a:pt x="3808" y="2256"/>
                      <a:pt x="3797" y="2237"/>
                    </a:cubicBezTo>
                    <a:lnTo>
                      <a:pt x="3713" y="2101"/>
                    </a:lnTo>
                    <a:cubicBezTo>
                      <a:pt x="3701" y="2082"/>
                      <a:pt x="3707" y="2057"/>
                      <a:pt x="3726" y="2046"/>
                    </a:cubicBezTo>
                    <a:cubicBezTo>
                      <a:pt x="3744" y="2034"/>
                      <a:pt x="3769" y="2040"/>
                      <a:pt x="3781" y="2059"/>
                    </a:cubicBezTo>
                    <a:close/>
                    <a:moveTo>
                      <a:pt x="3948" y="2332"/>
                    </a:moveTo>
                    <a:lnTo>
                      <a:pt x="4031" y="2469"/>
                    </a:lnTo>
                    <a:cubicBezTo>
                      <a:pt x="4042" y="2488"/>
                      <a:pt x="4036" y="2513"/>
                      <a:pt x="4017" y="2524"/>
                    </a:cubicBezTo>
                    <a:cubicBezTo>
                      <a:pt x="3998" y="2535"/>
                      <a:pt x="3973" y="2529"/>
                      <a:pt x="3962" y="2510"/>
                    </a:cubicBezTo>
                    <a:lnTo>
                      <a:pt x="3880" y="2373"/>
                    </a:lnTo>
                    <a:cubicBezTo>
                      <a:pt x="3868" y="2354"/>
                      <a:pt x="3875" y="2330"/>
                      <a:pt x="3893" y="2318"/>
                    </a:cubicBezTo>
                    <a:cubicBezTo>
                      <a:pt x="3912" y="2307"/>
                      <a:pt x="3937" y="2313"/>
                      <a:pt x="3948" y="2332"/>
                    </a:cubicBezTo>
                    <a:close/>
                    <a:moveTo>
                      <a:pt x="4113" y="2606"/>
                    </a:moveTo>
                    <a:lnTo>
                      <a:pt x="4195" y="2743"/>
                    </a:lnTo>
                    <a:cubicBezTo>
                      <a:pt x="4207" y="2762"/>
                      <a:pt x="4201" y="2787"/>
                      <a:pt x="4182" y="2798"/>
                    </a:cubicBezTo>
                    <a:cubicBezTo>
                      <a:pt x="4163" y="2810"/>
                      <a:pt x="4138" y="2804"/>
                      <a:pt x="4127" y="2785"/>
                    </a:cubicBezTo>
                    <a:lnTo>
                      <a:pt x="4044" y="2647"/>
                    </a:lnTo>
                    <a:cubicBezTo>
                      <a:pt x="4033" y="2628"/>
                      <a:pt x="4039" y="2604"/>
                      <a:pt x="4058" y="2593"/>
                    </a:cubicBezTo>
                    <a:cubicBezTo>
                      <a:pt x="4077" y="2581"/>
                      <a:pt x="4102" y="2587"/>
                      <a:pt x="4113" y="2606"/>
                    </a:cubicBezTo>
                    <a:close/>
                    <a:moveTo>
                      <a:pt x="4277" y="2883"/>
                    </a:moveTo>
                    <a:lnTo>
                      <a:pt x="4353" y="3023"/>
                    </a:lnTo>
                    <a:cubicBezTo>
                      <a:pt x="4364" y="3043"/>
                      <a:pt x="4357" y="3067"/>
                      <a:pt x="4338" y="3078"/>
                    </a:cubicBezTo>
                    <a:cubicBezTo>
                      <a:pt x="4318" y="3088"/>
                      <a:pt x="4294" y="3081"/>
                      <a:pt x="4283" y="3062"/>
                    </a:cubicBezTo>
                    <a:lnTo>
                      <a:pt x="4206" y="2921"/>
                    </a:lnTo>
                    <a:cubicBezTo>
                      <a:pt x="4196" y="2902"/>
                      <a:pt x="4203" y="2878"/>
                      <a:pt x="4222" y="2867"/>
                    </a:cubicBezTo>
                    <a:cubicBezTo>
                      <a:pt x="4242" y="2857"/>
                      <a:pt x="4266" y="2864"/>
                      <a:pt x="4277" y="2883"/>
                    </a:cubicBezTo>
                    <a:close/>
                    <a:moveTo>
                      <a:pt x="4430" y="3164"/>
                    </a:moveTo>
                    <a:lnTo>
                      <a:pt x="4507" y="3304"/>
                    </a:lnTo>
                    <a:cubicBezTo>
                      <a:pt x="4518" y="3324"/>
                      <a:pt x="4511" y="3348"/>
                      <a:pt x="4491" y="3358"/>
                    </a:cubicBezTo>
                    <a:cubicBezTo>
                      <a:pt x="4472" y="3369"/>
                      <a:pt x="4447" y="3362"/>
                      <a:pt x="4437" y="3343"/>
                    </a:cubicBezTo>
                    <a:lnTo>
                      <a:pt x="4360" y="3202"/>
                    </a:lnTo>
                    <a:cubicBezTo>
                      <a:pt x="4349" y="3183"/>
                      <a:pt x="4357" y="3159"/>
                      <a:pt x="4376" y="3148"/>
                    </a:cubicBezTo>
                    <a:cubicBezTo>
                      <a:pt x="4395" y="3137"/>
                      <a:pt x="4420" y="3144"/>
                      <a:pt x="4430" y="3164"/>
                    </a:cubicBezTo>
                    <a:close/>
                    <a:moveTo>
                      <a:pt x="4584" y="3445"/>
                    </a:moveTo>
                    <a:lnTo>
                      <a:pt x="4661" y="3585"/>
                    </a:lnTo>
                    <a:cubicBezTo>
                      <a:pt x="4671" y="3604"/>
                      <a:pt x="4664" y="3629"/>
                      <a:pt x="4645" y="3639"/>
                    </a:cubicBezTo>
                    <a:cubicBezTo>
                      <a:pt x="4625" y="3650"/>
                      <a:pt x="4601" y="3643"/>
                      <a:pt x="4590" y="3623"/>
                    </a:cubicBezTo>
                    <a:lnTo>
                      <a:pt x="4514" y="3483"/>
                    </a:lnTo>
                    <a:cubicBezTo>
                      <a:pt x="4503" y="3464"/>
                      <a:pt x="4510" y="3439"/>
                      <a:pt x="4530" y="3429"/>
                    </a:cubicBezTo>
                    <a:cubicBezTo>
                      <a:pt x="4549" y="3418"/>
                      <a:pt x="4573" y="3425"/>
                      <a:pt x="4584" y="3445"/>
                    </a:cubicBezTo>
                    <a:close/>
                    <a:moveTo>
                      <a:pt x="4738" y="3723"/>
                    </a:moveTo>
                    <a:lnTo>
                      <a:pt x="4821" y="3860"/>
                    </a:lnTo>
                    <a:cubicBezTo>
                      <a:pt x="4832" y="3879"/>
                      <a:pt x="4826" y="3904"/>
                      <a:pt x="4807" y="3915"/>
                    </a:cubicBezTo>
                    <a:cubicBezTo>
                      <a:pt x="4788" y="3926"/>
                      <a:pt x="4763" y="3920"/>
                      <a:pt x="4752" y="3901"/>
                    </a:cubicBezTo>
                    <a:lnTo>
                      <a:pt x="4670" y="3764"/>
                    </a:lnTo>
                    <a:cubicBezTo>
                      <a:pt x="4658" y="3745"/>
                      <a:pt x="4664" y="3721"/>
                      <a:pt x="4683" y="3709"/>
                    </a:cubicBezTo>
                    <a:cubicBezTo>
                      <a:pt x="4702" y="3698"/>
                      <a:pt x="4727" y="3704"/>
                      <a:pt x="4738" y="3723"/>
                    </a:cubicBezTo>
                    <a:close/>
                    <a:moveTo>
                      <a:pt x="4903" y="3997"/>
                    </a:moveTo>
                    <a:lnTo>
                      <a:pt x="4985" y="4135"/>
                    </a:lnTo>
                    <a:cubicBezTo>
                      <a:pt x="4997" y="4154"/>
                      <a:pt x="4990" y="4178"/>
                      <a:pt x="4971" y="4189"/>
                    </a:cubicBezTo>
                    <a:cubicBezTo>
                      <a:pt x="4953" y="4201"/>
                      <a:pt x="4928" y="4195"/>
                      <a:pt x="4917" y="4176"/>
                    </a:cubicBezTo>
                    <a:lnTo>
                      <a:pt x="4834" y="4039"/>
                    </a:lnTo>
                    <a:cubicBezTo>
                      <a:pt x="4823" y="4020"/>
                      <a:pt x="4829" y="3995"/>
                      <a:pt x="4848" y="3984"/>
                    </a:cubicBezTo>
                    <a:cubicBezTo>
                      <a:pt x="4867" y="3972"/>
                      <a:pt x="4891" y="3978"/>
                      <a:pt x="4903" y="3997"/>
                    </a:cubicBezTo>
                    <a:close/>
                    <a:moveTo>
                      <a:pt x="5068" y="4269"/>
                    </a:moveTo>
                    <a:lnTo>
                      <a:pt x="5157" y="4402"/>
                    </a:lnTo>
                    <a:cubicBezTo>
                      <a:pt x="5169" y="4421"/>
                      <a:pt x="5164" y="4446"/>
                      <a:pt x="5145" y="4458"/>
                    </a:cubicBezTo>
                    <a:cubicBezTo>
                      <a:pt x="5127" y="4470"/>
                      <a:pt x="5102" y="4465"/>
                      <a:pt x="5090" y="4447"/>
                    </a:cubicBezTo>
                    <a:lnTo>
                      <a:pt x="5001" y="4314"/>
                    </a:lnTo>
                    <a:cubicBezTo>
                      <a:pt x="4989" y="4295"/>
                      <a:pt x="4994" y="4270"/>
                      <a:pt x="5012" y="4258"/>
                    </a:cubicBezTo>
                    <a:cubicBezTo>
                      <a:pt x="5031" y="4246"/>
                      <a:pt x="5056" y="4251"/>
                      <a:pt x="5068" y="4269"/>
                    </a:cubicBezTo>
                    <a:close/>
                    <a:moveTo>
                      <a:pt x="5245" y="4536"/>
                    </a:moveTo>
                    <a:lnTo>
                      <a:pt x="5334" y="4669"/>
                    </a:lnTo>
                    <a:cubicBezTo>
                      <a:pt x="5346" y="4687"/>
                      <a:pt x="5341" y="4712"/>
                      <a:pt x="5323" y="4724"/>
                    </a:cubicBezTo>
                    <a:cubicBezTo>
                      <a:pt x="5305" y="4736"/>
                      <a:pt x="5280" y="4731"/>
                      <a:pt x="5267" y="4713"/>
                    </a:cubicBezTo>
                    <a:lnTo>
                      <a:pt x="5179" y="4580"/>
                    </a:lnTo>
                    <a:cubicBezTo>
                      <a:pt x="5166" y="4562"/>
                      <a:pt x="5171" y="4537"/>
                      <a:pt x="5190" y="4524"/>
                    </a:cubicBezTo>
                    <a:cubicBezTo>
                      <a:pt x="5208" y="4512"/>
                      <a:pt x="5233" y="4517"/>
                      <a:pt x="5245" y="4536"/>
                    </a:cubicBezTo>
                    <a:close/>
                    <a:moveTo>
                      <a:pt x="5423" y="4802"/>
                    </a:moveTo>
                    <a:lnTo>
                      <a:pt x="5498" y="4914"/>
                    </a:lnTo>
                    <a:lnTo>
                      <a:pt x="5487" y="4903"/>
                    </a:lnTo>
                    <a:lnTo>
                      <a:pt x="5508" y="4917"/>
                    </a:lnTo>
                    <a:cubicBezTo>
                      <a:pt x="5526" y="4930"/>
                      <a:pt x="5531" y="4955"/>
                      <a:pt x="5518" y="4973"/>
                    </a:cubicBezTo>
                    <a:cubicBezTo>
                      <a:pt x="5506" y="4991"/>
                      <a:pt x="5481" y="4996"/>
                      <a:pt x="5462" y="4984"/>
                    </a:cubicBezTo>
                    <a:lnTo>
                      <a:pt x="5442" y="4970"/>
                    </a:lnTo>
                    <a:cubicBezTo>
                      <a:pt x="5438" y="4967"/>
                      <a:pt x="5434" y="4963"/>
                      <a:pt x="5431" y="4959"/>
                    </a:cubicBezTo>
                    <a:lnTo>
                      <a:pt x="5356" y="4846"/>
                    </a:lnTo>
                    <a:cubicBezTo>
                      <a:pt x="5344" y="4828"/>
                      <a:pt x="5349" y="4803"/>
                      <a:pt x="5367" y="4791"/>
                    </a:cubicBezTo>
                    <a:cubicBezTo>
                      <a:pt x="5386" y="4779"/>
                      <a:pt x="5411" y="4783"/>
                      <a:pt x="5423" y="4802"/>
                    </a:cubicBezTo>
                    <a:close/>
                    <a:moveTo>
                      <a:pt x="5640" y="5008"/>
                    </a:moveTo>
                    <a:lnTo>
                      <a:pt x="5772" y="5098"/>
                    </a:lnTo>
                    <a:cubicBezTo>
                      <a:pt x="5790" y="5110"/>
                      <a:pt x="5795" y="5135"/>
                      <a:pt x="5782" y="5153"/>
                    </a:cubicBezTo>
                    <a:cubicBezTo>
                      <a:pt x="5770" y="5172"/>
                      <a:pt x="5745" y="5176"/>
                      <a:pt x="5727" y="5164"/>
                    </a:cubicBezTo>
                    <a:lnTo>
                      <a:pt x="5595" y="5074"/>
                    </a:lnTo>
                    <a:cubicBezTo>
                      <a:pt x="5576" y="5061"/>
                      <a:pt x="5572" y="5036"/>
                      <a:pt x="5584" y="5018"/>
                    </a:cubicBezTo>
                    <a:cubicBezTo>
                      <a:pt x="5597" y="5000"/>
                      <a:pt x="5621" y="4995"/>
                      <a:pt x="5640" y="5008"/>
                    </a:cubicBezTo>
                    <a:close/>
                    <a:moveTo>
                      <a:pt x="5903" y="5192"/>
                    </a:moveTo>
                    <a:lnTo>
                      <a:pt x="6031" y="5289"/>
                    </a:lnTo>
                    <a:cubicBezTo>
                      <a:pt x="6048" y="5303"/>
                      <a:pt x="6052" y="5328"/>
                      <a:pt x="6038" y="5345"/>
                    </a:cubicBezTo>
                    <a:cubicBezTo>
                      <a:pt x="6025" y="5363"/>
                      <a:pt x="6000" y="5366"/>
                      <a:pt x="5982" y="5353"/>
                    </a:cubicBezTo>
                    <a:lnTo>
                      <a:pt x="5855" y="5256"/>
                    </a:lnTo>
                    <a:cubicBezTo>
                      <a:pt x="5837" y="5243"/>
                      <a:pt x="5834" y="5218"/>
                      <a:pt x="5847" y="5200"/>
                    </a:cubicBezTo>
                    <a:cubicBezTo>
                      <a:pt x="5861" y="5182"/>
                      <a:pt x="5886" y="5179"/>
                      <a:pt x="5903" y="5192"/>
                    </a:cubicBezTo>
                    <a:close/>
                    <a:moveTo>
                      <a:pt x="6158" y="5386"/>
                    </a:moveTo>
                    <a:lnTo>
                      <a:pt x="6177" y="5401"/>
                    </a:lnTo>
                    <a:lnTo>
                      <a:pt x="6152" y="5392"/>
                    </a:lnTo>
                    <a:lnTo>
                      <a:pt x="6264" y="5392"/>
                    </a:lnTo>
                    <a:cubicBezTo>
                      <a:pt x="6271" y="5392"/>
                      <a:pt x="6277" y="5394"/>
                      <a:pt x="6283" y="5397"/>
                    </a:cubicBezTo>
                    <a:lnTo>
                      <a:pt x="6305" y="5408"/>
                    </a:lnTo>
                    <a:cubicBezTo>
                      <a:pt x="6324" y="5419"/>
                      <a:pt x="6332" y="5443"/>
                      <a:pt x="6322" y="5462"/>
                    </a:cubicBezTo>
                    <a:cubicBezTo>
                      <a:pt x="6311" y="5482"/>
                      <a:pt x="6287" y="5489"/>
                      <a:pt x="6268" y="5479"/>
                    </a:cubicBezTo>
                    <a:lnTo>
                      <a:pt x="6246" y="5468"/>
                    </a:lnTo>
                    <a:lnTo>
                      <a:pt x="6264" y="5472"/>
                    </a:lnTo>
                    <a:lnTo>
                      <a:pt x="6152" y="5472"/>
                    </a:lnTo>
                    <a:cubicBezTo>
                      <a:pt x="6144" y="5472"/>
                      <a:pt x="6135" y="5470"/>
                      <a:pt x="6128" y="5464"/>
                    </a:cubicBezTo>
                    <a:lnTo>
                      <a:pt x="6109" y="5450"/>
                    </a:lnTo>
                    <a:cubicBezTo>
                      <a:pt x="6092" y="5437"/>
                      <a:pt x="6089" y="5412"/>
                      <a:pt x="6102" y="5394"/>
                    </a:cubicBezTo>
                    <a:cubicBezTo>
                      <a:pt x="6115" y="5376"/>
                      <a:pt x="6140" y="5373"/>
                      <a:pt x="6158" y="5386"/>
                    </a:cubicBezTo>
                    <a:close/>
                    <a:moveTo>
                      <a:pt x="6446" y="5483"/>
                    </a:moveTo>
                    <a:lnTo>
                      <a:pt x="6588" y="5557"/>
                    </a:lnTo>
                    <a:cubicBezTo>
                      <a:pt x="6608" y="5567"/>
                      <a:pt x="6615" y="5591"/>
                      <a:pt x="6605" y="5611"/>
                    </a:cubicBezTo>
                    <a:cubicBezTo>
                      <a:pt x="6595" y="5630"/>
                      <a:pt x="6571" y="5638"/>
                      <a:pt x="6551" y="5628"/>
                    </a:cubicBezTo>
                    <a:lnTo>
                      <a:pt x="6409" y="5553"/>
                    </a:lnTo>
                    <a:cubicBezTo>
                      <a:pt x="6390" y="5543"/>
                      <a:pt x="6382" y="5519"/>
                      <a:pt x="6392" y="5499"/>
                    </a:cubicBezTo>
                    <a:cubicBezTo>
                      <a:pt x="6403" y="5480"/>
                      <a:pt x="6427" y="5472"/>
                      <a:pt x="6446" y="5483"/>
                    </a:cubicBezTo>
                    <a:close/>
                    <a:moveTo>
                      <a:pt x="6726" y="5568"/>
                    </a:moveTo>
                    <a:lnTo>
                      <a:pt x="6886" y="5568"/>
                    </a:lnTo>
                    <a:cubicBezTo>
                      <a:pt x="6908" y="5568"/>
                      <a:pt x="6926" y="5586"/>
                      <a:pt x="6926" y="5608"/>
                    </a:cubicBezTo>
                    <a:cubicBezTo>
                      <a:pt x="6926" y="5631"/>
                      <a:pt x="6908" y="5648"/>
                      <a:pt x="6886" y="5648"/>
                    </a:cubicBezTo>
                    <a:lnTo>
                      <a:pt x="6726" y="5648"/>
                    </a:lnTo>
                    <a:cubicBezTo>
                      <a:pt x="6704" y="5648"/>
                      <a:pt x="6686" y="5631"/>
                      <a:pt x="6686" y="5608"/>
                    </a:cubicBezTo>
                    <a:cubicBezTo>
                      <a:pt x="6686" y="5586"/>
                      <a:pt x="6704" y="5568"/>
                      <a:pt x="6726" y="5568"/>
                    </a:cubicBezTo>
                    <a:close/>
                    <a:moveTo>
                      <a:pt x="7046" y="5568"/>
                    </a:moveTo>
                    <a:lnTo>
                      <a:pt x="7048" y="5568"/>
                    </a:lnTo>
                    <a:cubicBezTo>
                      <a:pt x="7071" y="5568"/>
                      <a:pt x="7088" y="5586"/>
                      <a:pt x="7088" y="5608"/>
                    </a:cubicBezTo>
                    <a:cubicBezTo>
                      <a:pt x="7088" y="5631"/>
                      <a:pt x="7071" y="5648"/>
                      <a:pt x="7048" y="5648"/>
                    </a:cubicBezTo>
                    <a:lnTo>
                      <a:pt x="7046" y="5648"/>
                    </a:lnTo>
                    <a:cubicBezTo>
                      <a:pt x="7024" y="5648"/>
                      <a:pt x="7006" y="5631"/>
                      <a:pt x="7006" y="5608"/>
                    </a:cubicBezTo>
                    <a:cubicBezTo>
                      <a:pt x="7006" y="5586"/>
                      <a:pt x="7024" y="5568"/>
                      <a:pt x="7046" y="5568"/>
                    </a:cubicBezTo>
                    <a:close/>
                  </a:path>
                </a:pathLst>
              </a:custGeom>
              <a:solidFill>
                <a:srgbClr val="333333"/>
              </a:solidFill>
              <a:ln w="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3" name="Freeform 51"/>
              <p:cNvSpPr>
                <a:spLocks/>
              </p:cNvSpPr>
              <p:nvPr/>
            </p:nvSpPr>
            <p:spPr bwMode="auto">
              <a:xfrm>
                <a:off x="2014538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4" name="Freeform 52"/>
              <p:cNvSpPr>
                <a:spLocks/>
              </p:cNvSpPr>
              <p:nvPr/>
            </p:nvSpPr>
            <p:spPr bwMode="auto">
              <a:xfrm>
                <a:off x="2014538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5" name="Freeform 53"/>
              <p:cNvSpPr>
                <a:spLocks/>
              </p:cNvSpPr>
              <p:nvPr/>
            </p:nvSpPr>
            <p:spPr bwMode="auto">
              <a:xfrm>
                <a:off x="2406651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6" name="Freeform 54"/>
              <p:cNvSpPr>
                <a:spLocks/>
              </p:cNvSpPr>
              <p:nvPr/>
            </p:nvSpPr>
            <p:spPr bwMode="auto">
              <a:xfrm>
                <a:off x="2406651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7" name="Freeform 55"/>
              <p:cNvSpPr>
                <a:spLocks/>
              </p:cNvSpPr>
              <p:nvPr/>
            </p:nvSpPr>
            <p:spPr bwMode="auto">
              <a:xfrm>
                <a:off x="2601913" y="1517651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6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8" name="Freeform 56"/>
              <p:cNvSpPr>
                <a:spLocks/>
              </p:cNvSpPr>
              <p:nvPr/>
            </p:nvSpPr>
            <p:spPr bwMode="auto">
              <a:xfrm>
                <a:off x="2601913" y="1517651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6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6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59" name="Freeform 57"/>
              <p:cNvSpPr>
                <a:spLocks/>
              </p:cNvSpPr>
              <p:nvPr/>
            </p:nvSpPr>
            <p:spPr bwMode="auto">
              <a:xfrm>
                <a:off x="2873376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0" name="Freeform 58"/>
              <p:cNvSpPr>
                <a:spLocks/>
              </p:cNvSpPr>
              <p:nvPr/>
            </p:nvSpPr>
            <p:spPr bwMode="auto">
              <a:xfrm>
                <a:off x="2873376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1" name="Freeform 59"/>
              <p:cNvSpPr>
                <a:spLocks/>
              </p:cNvSpPr>
              <p:nvPr/>
            </p:nvSpPr>
            <p:spPr bwMode="auto">
              <a:xfrm>
                <a:off x="3068638" y="1517651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6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2" name="Freeform 60"/>
              <p:cNvSpPr>
                <a:spLocks/>
              </p:cNvSpPr>
              <p:nvPr/>
            </p:nvSpPr>
            <p:spPr bwMode="auto">
              <a:xfrm>
                <a:off x="3068638" y="1517651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6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6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3" name="Freeform 61"/>
              <p:cNvSpPr>
                <a:spLocks/>
              </p:cNvSpPr>
              <p:nvPr/>
            </p:nvSpPr>
            <p:spPr bwMode="auto">
              <a:xfrm>
                <a:off x="3330576" y="15859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4" name="Freeform 62"/>
              <p:cNvSpPr>
                <a:spLocks/>
              </p:cNvSpPr>
              <p:nvPr/>
            </p:nvSpPr>
            <p:spPr bwMode="auto">
              <a:xfrm>
                <a:off x="3330576" y="15859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5" name="Freeform 63"/>
              <p:cNvSpPr>
                <a:spLocks/>
              </p:cNvSpPr>
              <p:nvPr/>
            </p:nvSpPr>
            <p:spPr bwMode="auto">
              <a:xfrm>
                <a:off x="3527426" y="1625601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6" name="Freeform 64"/>
              <p:cNvSpPr>
                <a:spLocks/>
              </p:cNvSpPr>
              <p:nvPr/>
            </p:nvSpPr>
            <p:spPr bwMode="auto">
              <a:xfrm>
                <a:off x="3527426" y="1625601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7" name="Freeform 65"/>
              <p:cNvSpPr>
                <a:spLocks/>
              </p:cNvSpPr>
              <p:nvPr/>
            </p:nvSpPr>
            <p:spPr bwMode="auto">
              <a:xfrm>
                <a:off x="3797301" y="1957388"/>
                <a:ext cx="112713" cy="115888"/>
              </a:xfrm>
              <a:custGeom>
                <a:avLst/>
                <a:gdLst>
                  <a:gd name="T0" fmla="*/ 35 w 71"/>
                  <a:gd name="T1" fmla="*/ 0 h 73"/>
                  <a:gd name="T2" fmla="*/ 71 w 71"/>
                  <a:gd name="T3" fmla="*/ 73 h 73"/>
                  <a:gd name="T4" fmla="*/ 0 w 71"/>
                  <a:gd name="T5" fmla="*/ 73 h 73"/>
                  <a:gd name="T6" fmla="*/ 35 w 71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3">
                    <a:moveTo>
                      <a:pt x="35" y="0"/>
                    </a:moveTo>
                    <a:lnTo>
                      <a:pt x="71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8" name="Freeform 66"/>
              <p:cNvSpPr>
                <a:spLocks/>
              </p:cNvSpPr>
              <p:nvPr/>
            </p:nvSpPr>
            <p:spPr bwMode="auto">
              <a:xfrm>
                <a:off x="3797301" y="1957388"/>
                <a:ext cx="112713" cy="115888"/>
              </a:xfrm>
              <a:custGeom>
                <a:avLst/>
                <a:gdLst>
                  <a:gd name="T0" fmla="*/ 35 w 71"/>
                  <a:gd name="T1" fmla="*/ 0 h 73"/>
                  <a:gd name="T2" fmla="*/ 71 w 71"/>
                  <a:gd name="T3" fmla="*/ 73 h 73"/>
                  <a:gd name="T4" fmla="*/ 0 w 71"/>
                  <a:gd name="T5" fmla="*/ 73 h 73"/>
                  <a:gd name="T6" fmla="*/ 35 w 71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3">
                    <a:moveTo>
                      <a:pt x="35" y="0"/>
                    </a:moveTo>
                    <a:lnTo>
                      <a:pt x="71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69" name="Freeform 67"/>
              <p:cNvSpPr>
                <a:spLocks/>
              </p:cNvSpPr>
              <p:nvPr/>
            </p:nvSpPr>
            <p:spPr bwMode="auto">
              <a:xfrm>
                <a:off x="4059238" y="2562226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0" name="Freeform 68"/>
              <p:cNvSpPr>
                <a:spLocks/>
              </p:cNvSpPr>
              <p:nvPr/>
            </p:nvSpPr>
            <p:spPr bwMode="auto">
              <a:xfrm>
                <a:off x="4059238" y="2562226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1" name="Freeform 69"/>
              <p:cNvSpPr>
                <a:spLocks/>
              </p:cNvSpPr>
              <p:nvPr/>
            </p:nvSpPr>
            <p:spPr bwMode="auto">
              <a:xfrm>
                <a:off x="4254501" y="2894013"/>
                <a:ext cx="112713" cy="115888"/>
              </a:xfrm>
              <a:custGeom>
                <a:avLst/>
                <a:gdLst>
                  <a:gd name="T0" fmla="*/ 35 w 71"/>
                  <a:gd name="T1" fmla="*/ 0 h 73"/>
                  <a:gd name="T2" fmla="*/ 71 w 71"/>
                  <a:gd name="T3" fmla="*/ 73 h 73"/>
                  <a:gd name="T4" fmla="*/ 0 w 71"/>
                  <a:gd name="T5" fmla="*/ 73 h 73"/>
                  <a:gd name="T6" fmla="*/ 35 w 71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3">
                    <a:moveTo>
                      <a:pt x="35" y="0"/>
                    </a:moveTo>
                    <a:lnTo>
                      <a:pt x="71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2" name="Freeform 70"/>
              <p:cNvSpPr>
                <a:spLocks/>
              </p:cNvSpPr>
              <p:nvPr/>
            </p:nvSpPr>
            <p:spPr bwMode="auto">
              <a:xfrm>
                <a:off x="4254501" y="2894013"/>
                <a:ext cx="112713" cy="115888"/>
              </a:xfrm>
              <a:custGeom>
                <a:avLst/>
                <a:gdLst>
                  <a:gd name="T0" fmla="*/ 35 w 71"/>
                  <a:gd name="T1" fmla="*/ 0 h 73"/>
                  <a:gd name="T2" fmla="*/ 71 w 71"/>
                  <a:gd name="T3" fmla="*/ 73 h 73"/>
                  <a:gd name="T4" fmla="*/ 0 w 71"/>
                  <a:gd name="T5" fmla="*/ 73 h 73"/>
                  <a:gd name="T6" fmla="*/ 35 w 71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3">
                    <a:moveTo>
                      <a:pt x="35" y="0"/>
                    </a:moveTo>
                    <a:lnTo>
                      <a:pt x="71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3" name="Freeform 71"/>
              <p:cNvSpPr>
                <a:spLocks/>
              </p:cNvSpPr>
              <p:nvPr/>
            </p:nvSpPr>
            <p:spPr bwMode="auto">
              <a:xfrm>
                <a:off x="4451351" y="3235326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4" name="Freeform 72"/>
              <p:cNvSpPr>
                <a:spLocks/>
              </p:cNvSpPr>
              <p:nvPr/>
            </p:nvSpPr>
            <p:spPr bwMode="auto">
              <a:xfrm>
                <a:off x="4451351" y="3235326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5" name="Freeform 73"/>
              <p:cNvSpPr>
                <a:spLocks/>
              </p:cNvSpPr>
              <p:nvPr/>
            </p:nvSpPr>
            <p:spPr bwMode="auto">
              <a:xfrm>
                <a:off x="4721226" y="3752851"/>
                <a:ext cx="112713" cy="115888"/>
              </a:xfrm>
              <a:custGeom>
                <a:avLst/>
                <a:gdLst>
                  <a:gd name="T0" fmla="*/ 35 w 71"/>
                  <a:gd name="T1" fmla="*/ 0 h 73"/>
                  <a:gd name="T2" fmla="*/ 71 w 71"/>
                  <a:gd name="T3" fmla="*/ 73 h 73"/>
                  <a:gd name="T4" fmla="*/ 0 w 71"/>
                  <a:gd name="T5" fmla="*/ 73 h 73"/>
                  <a:gd name="T6" fmla="*/ 35 w 71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3">
                    <a:moveTo>
                      <a:pt x="35" y="0"/>
                    </a:moveTo>
                    <a:lnTo>
                      <a:pt x="71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6" name="Freeform 74"/>
              <p:cNvSpPr>
                <a:spLocks/>
              </p:cNvSpPr>
              <p:nvPr/>
            </p:nvSpPr>
            <p:spPr bwMode="auto">
              <a:xfrm>
                <a:off x="4721226" y="3752851"/>
                <a:ext cx="112713" cy="115888"/>
              </a:xfrm>
              <a:custGeom>
                <a:avLst/>
                <a:gdLst>
                  <a:gd name="T0" fmla="*/ 35 w 71"/>
                  <a:gd name="T1" fmla="*/ 0 h 73"/>
                  <a:gd name="T2" fmla="*/ 71 w 71"/>
                  <a:gd name="T3" fmla="*/ 73 h 73"/>
                  <a:gd name="T4" fmla="*/ 0 w 71"/>
                  <a:gd name="T5" fmla="*/ 73 h 73"/>
                  <a:gd name="T6" fmla="*/ 35 w 71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3">
                    <a:moveTo>
                      <a:pt x="35" y="0"/>
                    </a:moveTo>
                    <a:lnTo>
                      <a:pt x="71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7" name="Freeform 75"/>
              <p:cNvSpPr>
                <a:spLocks/>
              </p:cNvSpPr>
              <p:nvPr/>
            </p:nvSpPr>
            <p:spPr bwMode="auto">
              <a:xfrm>
                <a:off x="4918076" y="4094163"/>
                <a:ext cx="111125" cy="115888"/>
              </a:xfrm>
              <a:custGeom>
                <a:avLst/>
                <a:gdLst>
                  <a:gd name="T0" fmla="*/ 35 w 70"/>
                  <a:gd name="T1" fmla="*/ 0 h 73"/>
                  <a:gd name="T2" fmla="*/ 70 w 70"/>
                  <a:gd name="T3" fmla="*/ 73 h 73"/>
                  <a:gd name="T4" fmla="*/ 0 w 70"/>
                  <a:gd name="T5" fmla="*/ 73 h 73"/>
                  <a:gd name="T6" fmla="*/ 35 w 70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3">
                    <a:moveTo>
                      <a:pt x="35" y="0"/>
                    </a:moveTo>
                    <a:lnTo>
                      <a:pt x="70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8" name="Freeform 76"/>
              <p:cNvSpPr>
                <a:spLocks/>
              </p:cNvSpPr>
              <p:nvPr/>
            </p:nvSpPr>
            <p:spPr bwMode="auto">
              <a:xfrm>
                <a:off x="4918076" y="4094163"/>
                <a:ext cx="111125" cy="115888"/>
              </a:xfrm>
              <a:custGeom>
                <a:avLst/>
                <a:gdLst>
                  <a:gd name="T0" fmla="*/ 35 w 70"/>
                  <a:gd name="T1" fmla="*/ 0 h 73"/>
                  <a:gd name="T2" fmla="*/ 70 w 70"/>
                  <a:gd name="T3" fmla="*/ 73 h 73"/>
                  <a:gd name="T4" fmla="*/ 0 w 70"/>
                  <a:gd name="T5" fmla="*/ 73 h 73"/>
                  <a:gd name="T6" fmla="*/ 35 w 70"/>
                  <a:gd name="T7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3">
                    <a:moveTo>
                      <a:pt x="35" y="0"/>
                    </a:moveTo>
                    <a:lnTo>
                      <a:pt x="70" y="73"/>
                    </a:lnTo>
                    <a:lnTo>
                      <a:pt x="0" y="73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79" name="Freeform 77"/>
              <p:cNvSpPr>
                <a:spLocks/>
              </p:cNvSpPr>
              <p:nvPr/>
            </p:nvSpPr>
            <p:spPr bwMode="auto">
              <a:xfrm>
                <a:off x="5178426" y="4503738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0" name="Freeform 78"/>
              <p:cNvSpPr>
                <a:spLocks/>
              </p:cNvSpPr>
              <p:nvPr/>
            </p:nvSpPr>
            <p:spPr bwMode="auto">
              <a:xfrm>
                <a:off x="5178426" y="4503738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1" name="Freeform 79"/>
              <p:cNvSpPr>
                <a:spLocks/>
              </p:cNvSpPr>
              <p:nvPr/>
            </p:nvSpPr>
            <p:spPr bwMode="auto">
              <a:xfrm>
                <a:off x="5384801" y="464978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2" name="Freeform 80"/>
              <p:cNvSpPr>
                <a:spLocks/>
              </p:cNvSpPr>
              <p:nvPr/>
            </p:nvSpPr>
            <p:spPr bwMode="auto">
              <a:xfrm>
                <a:off x="5384801" y="464978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3" name="Freeform 81"/>
              <p:cNvSpPr>
                <a:spLocks/>
              </p:cNvSpPr>
              <p:nvPr/>
            </p:nvSpPr>
            <p:spPr bwMode="auto">
              <a:xfrm>
                <a:off x="5580063" y="48053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4" name="Freeform 82"/>
              <p:cNvSpPr>
                <a:spLocks/>
              </p:cNvSpPr>
              <p:nvPr/>
            </p:nvSpPr>
            <p:spPr bwMode="auto">
              <a:xfrm>
                <a:off x="5580063" y="48053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5" name="Freeform 83"/>
              <p:cNvSpPr>
                <a:spLocks/>
              </p:cNvSpPr>
              <p:nvPr/>
            </p:nvSpPr>
            <p:spPr bwMode="auto">
              <a:xfrm>
                <a:off x="5645151" y="48053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6" name="Freeform 84"/>
              <p:cNvSpPr>
                <a:spLocks/>
              </p:cNvSpPr>
              <p:nvPr/>
            </p:nvSpPr>
            <p:spPr bwMode="auto">
              <a:xfrm>
                <a:off x="5645151" y="48053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5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7" name="Freeform 85"/>
              <p:cNvSpPr>
                <a:spLocks/>
              </p:cNvSpPr>
              <p:nvPr/>
            </p:nvSpPr>
            <p:spPr bwMode="auto">
              <a:xfrm>
                <a:off x="5842001" y="4913313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8" name="Freeform 86"/>
              <p:cNvSpPr>
                <a:spLocks/>
              </p:cNvSpPr>
              <p:nvPr/>
            </p:nvSpPr>
            <p:spPr bwMode="auto">
              <a:xfrm>
                <a:off x="5842001" y="4913313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74 h 74"/>
                  <a:gd name="T4" fmla="*/ 0 w 70"/>
                  <a:gd name="T5" fmla="*/ 74 h 74"/>
                  <a:gd name="T6" fmla="*/ 35 w 70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74"/>
                    </a:lnTo>
                    <a:lnTo>
                      <a:pt x="0" y="74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89" name="Freeform 87"/>
              <p:cNvSpPr>
                <a:spLocks/>
              </p:cNvSpPr>
              <p:nvPr/>
            </p:nvSpPr>
            <p:spPr bwMode="auto">
              <a:xfrm>
                <a:off x="6102351" y="4913313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6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0" name="Freeform 88"/>
              <p:cNvSpPr>
                <a:spLocks/>
              </p:cNvSpPr>
              <p:nvPr/>
            </p:nvSpPr>
            <p:spPr bwMode="auto">
              <a:xfrm>
                <a:off x="6102351" y="4913313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74 h 74"/>
                  <a:gd name="T4" fmla="*/ 0 w 71"/>
                  <a:gd name="T5" fmla="*/ 74 h 74"/>
                  <a:gd name="T6" fmla="*/ 36 w 71"/>
                  <a:gd name="T7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74"/>
                    </a:lnTo>
                    <a:lnTo>
                      <a:pt x="0" y="74"/>
                    </a:lnTo>
                    <a:lnTo>
                      <a:pt x="36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1" name="Freeform 89"/>
              <p:cNvSpPr>
                <a:spLocks/>
              </p:cNvSpPr>
              <p:nvPr/>
            </p:nvSpPr>
            <p:spPr bwMode="auto">
              <a:xfrm>
                <a:off x="2070101" y="1574801"/>
                <a:ext cx="4089400" cy="3395663"/>
              </a:xfrm>
              <a:custGeom>
                <a:avLst/>
                <a:gdLst>
                  <a:gd name="T0" fmla="*/ 0 w 2576"/>
                  <a:gd name="T1" fmla="*/ 0 h 2139"/>
                  <a:gd name="T2" fmla="*/ 247 w 2576"/>
                  <a:gd name="T3" fmla="*/ 0 h 2139"/>
                  <a:gd name="T4" fmla="*/ 371 w 2576"/>
                  <a:gd name="T5" fmla="*/ 0 h 2139"/>
                  <a:gd name="T6" fmla="*/ 541 w 2576"/>
                  <a:gd name="T7" fmla="*/ 0 h 2139"/>
                  <a:gd name="T8" fmla="*/ 665 w 2576"/>
                  <a:gd name="T9" fmla="*/ 43 h 2139"/>
                  <a:gd name="T10" fmla="*/ 829 w 2576"/>
                  <a:gd name="T11" fmla="*/ 43 h 2139"/>
                  <a:gd name="T12" fmla="*/ 953 w 2576"/>
                  <a:gd name="T13" fmla="*/ 68 h 2139"/>
                  <a:gd name="T14" fmla="*/ 1123 w 2576"/>
                  <a:gd name="T15" fmla="*/ 92 h 2139"/>
                  <a:gd name="T16" fmla="*/ 1288 w 2576"/>
                  <a:gd name="T17" fmla="*/ 142 h 2139"/>
                  <a:gd name="T18" fmla="*/ 1411 w 2576"/>
                  <a:gd name="T19" fmla="*/ 363 h 2139"/>
                  <a:gd name="T20" fmla="*/ 1535 w 2576"/>
                  <a:gd name="T21" fmla="*/ 461 h 2139"/>
                  <a:gd name="T22" fmla="*/ 1705 w 2576"/>
                  <a:gd name="T23" fmla="*/ 627 h 2139"/>
                  <a:gd name="T24" fmla="*/ 1829 w 2576"/>
                  <a:gd name="T25" fmla="*/ 701 h 2139"/>
                  <a:gd name="T26" fmla="*/ 1993 w 2576"/>
                  <a:gd name="T27" fmla="*/ 1143 h 2139"/>
                  <a:gd name="T28" fmla="*/ 2123 w 2576"/>
                  <a:gd name="T29" fmla="*/ 1506 h 2139"/>
                  <a:gd name="T30" fmla="*/ 2246 w 2576"/>
                  <a:gd name="T31" fmla="*/ 1942 h 2139"/>
                  <a:gd name="T32" fmla="*/ 2287 w 2576"/>
                  <a:gd name="T33" fmla="*/ 1967 h 2139"/>
                  <a:gd name="T34" fmla="*/ 2411 w 2576"/>
                  <a:gd name="T35" fmla="*/ 2065 h 2139"/>
                  <a:gd name="T36" fmla="*/ 2576 w 2576"/>
                  <a:gd name="T37" fmla="*/ 2139 h 213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</a:cxnLst>
                <a:rect l="0" t="0" r="r" b="b"/>
                <a:pathLst>
                  <a:path w="2576" h="2139">
                    <a:moveTo>
                      <a:pt x="0" y="0"/>
                    </a:moveTo>
                    <a:lnTo>
                      <a:pt x="247" y="0"/>
                    </a:lnTo>
                    <a:lnTo>
                      <a:pt x="371" y="0"/>
                    </a:lnTo>
                    <a:lnTo>
                      <a:pt x="541" y="0"/>
                    </a:lnTo>
                    <a:lnTo>
                      <a:pt x="665" y="43"/>
                    </a:lnTo>
                    <a:lnTo>
                      <a:pt x="829" y="43"/>
                    </a:lnTo>
                    <a:lnTo>
                      <a:pt x="953" y="68"/>
                    </a:lnTo>
                    <a:lnTo>
                      <a:pt x="1123" y="92"/>
                    </a:lnTo>
                    <a:lnTo>
                      <a:pt x="1288" y="142"/>
                    </a:lnTo>
                    <a:lnTo>
                      <a:pt x="1411" y="363"/>
                    </a:lnTo>
                    <a:lnTo>
                      <a:pt x="1535" y="461"/>
                    </a:lnTo>
                    <a:lnTo>
                      <a:pt x="1705" y="627"/>
                    </a:lnTo>
                    <a:lnTo>
                      <a:pt x="1829" y="701"/>
                    </a:lnTo>
                    <a:lnTo>
                      <a:pt x="1993" y="1143"/>
                    </a:lnTo>
                    <a:lnTo>
                      <a:pt x="2123" y="1506"/>
                    </a:lnTo>
                    <a:lnTo>
                      <a:pt x="2246" y="1942"/>
                    </a:lnTo>
                    <a:lnTo>
                      <a:pt x="2287" y="1967"/>
                    </a:lnTo>
                    <a:lnTo>
                      <a:pt x="2411" y="2065"/>
                    </a:lnTo>
                    <a:lnTo>
                      <a:pt x="2576" y="2139"/>
                    </a:lnTo>
                  </a:path>
                </a:pathLst>
              </a:custGeom>
              <a:noFill/>
              <a:ln w="460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2" name="Freeform 90"/>
              <p:cNvSpPr>
                <a:spLocks/>
              </p:cNvSpPr>
              <p:nvPr/>
            </p:nvSpPr>
            <p:spPr bwMode="auto">
              <a:xfrm>
                <a:off x="2014538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3" name="Freeform 91"/>
              <p:cNvSpPr>
                <a:spLocks/>
              </p:cNvSpPr>
              <p:nvPr/>
            </p:nvSpPr>
            <p:spPr bwMode="auto">
              <a:xfrm>
                <a:off x="2014538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4" name="Freeform 92"/>
              <p:cNvSpPr>
                <a:spLocks/>
              </p:cNvSpPr>
              <p:nvPr/>
            </p:nvSpPr>
            <p:spPr bwMode="auto">
              <a:xfrm>
                <a:off x="2406651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5" name="Freeform 93"/>
              <p:cNvSpPr>
                <a:spLocks/>
              </p:cNvSpPr>
              <p:nvPr/>
            </p:nvSpPr>
            <p:spPr bwMode="auto">
              <a:xfrm>
                <a:off x="2406651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6" name="Freeform 94"/>
              <p:cNvSpPr>
                <a:spLocks/>
              </p:cNvSpPr>
              <p:nvPr/>
            </p:nvSpPr>
            <p:spPr bwMode="auto">
              <a:xfrm>
                <a:off x="2601913" y="1517651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37 h 74"/>
                  <a:gd name="T4" fmla="*/ 36 w 71"/>
                  <a:gd name="T5" fmla="*/ 74 h 74"/>
                  <a:gd name="T6" fmla="*/ 0 w 71"/>
                  <a:gd name="T7" fmla="*/ 37 h 74"/>
                  <a:gd name="T8" fmla="*/ 36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37"/>
                    </a:lnTo>
                    <a:lnTo>
                      <a:pt x="36" y="74"/>
                    </a:lnTo>
                    <a:lnTo>
                      <a:pt x="0" y="37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7" name="Freeform 95"/>
              <p:cNvSpPr>
                <a:spLocks/>
              </p:cNvSpPr>
              <p:nvPr/>
            </p:nvSpPr>
            <p:spPr bwMode="auto">
              <a:xfrm>
                <a:off x="2601913" y="1517651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37 h 74"/>
                  <a:gd name="T4" fmla="*/ 36 w 71"/>
                  <a:gd name="T5" fmla="*/ 74 h 74"/>
                  <a:gd name="T6" fmla="*/ 0 w 71"/>
                  <a:gd name="T7" fmla="*/ 37 h 74"/>
                  <a:gd name="T8" fmla="*/ 36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37"/>
                    </a:lnTo>
                    <a:lnTo>
                      <a:pt x="36" y="74"/>
                    </a:lnTo>
                    <a:lnTo>
                      <a:pt x="0" y="37"/>
                    </a:lnTo>
                    <a:lnTo>
                      <a:pt x="36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8" name="Freeform 96"/>
              <p:cNvSpPr>
                <a:spLocks/>
              </p:cNvSpPr>
              <p:nvPr/>
            </p:nvSpPr>
            <p:spPr bwMode="auto">
              <a:xfrm>
                <a:off x="2873376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99" name="Freeform 97"/>
              <p:cNvSpPr>
                <a:spLocks/>
              </p:cNvSpPr>
              <p:nvPr/>
            </p:nvSpPr>
            <p:spPr bwMode="auto">
              <a:xfrm>
                <a:off x="2873376" y="151765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0" name="Freeform 98"/>
              <p:cNvSpPr>
                <a:spLocks/>
              </p:cNvSpPr>
              <p:nvPr/>
            </p:nvSpPr>
            <p:spPr bwMode="auto">
              <a:xfrm>
                <a:off x="3068638" y="1585913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37 h 74"/>
                  <a:gd name="T4" fmla="*/ 36 w 71"/>
                  <a:gd name="T5" fmla="*/ 74 h 74"/>
                  <a:gd name="T6" fmla="*/ 0 w 71"/>
                  <a:gd name="T7" fmla="*/ 37 h 74"/>
                  <a:gd name="T8" fmla="*/ 36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37"/>
                    </a:lnTo>
                    <a:lnTo>
                      <a:pt x="36" y="74"/>
                    </a:lnTo>
                    <a:lnTo>
                      <a:pt x="0" y="37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1" name="Freeform 99"/>
              <p:cNvSpPr>
                <a:spLocks/>
              </p:cNvSpPr>
              <p:nvPr/>
            </p:nvSpPr>
            <p:spPr bwMode="auto">
              <a:xfrm>
                <a:off x="3068638" y="1585913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37 h 74"/>
                  <a:gd name="T4" fmla="*/ 36 w 71"/>
                  <a:gd name="T5" fmla="*/ 74 h 74"/>
                  <a:gd name="T6" fmla="*/ 0 w 71"/>
                  <a:gd name="T7" fmla="*/ 37 h 74"/>
                  <a:gd name="T8" fmla="*/ 36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37"/>
                    </a:lnTo>
                    <a:lnTo>
                      <a:pt x="36" y="74"/>
                    </a:lnTo>
                    <a:lnTo>
                      <a:pt x="0" y="37"/>
                    </a:lnTo>
                    <a:lnTo>
                      <a:pt x="36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2" name="Freeform 100"/>
              <p:cNvSpPr>
                <a:spLocks/>
              </p:cNvSpPr>
              <p:nvPr/>
            </p:nvSpPr>
            <p:spPr bwMode="auto">
              <a:xfrm>
                <a:off x="3330576" y="15859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3" name="Freeform 101"/>
              <p:cNvSpPr>
                <a:spLocks/>
              </p:cNvSpPr>
              <p:nvPr/>
            </p:nvSpPr>
            <p:spPr bwMode="auto">
              <a:xfrm>
                <a:off x="3330576" y="15859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4" name="Freeform 102"/>
              <p:cNvSpPr>
                <a:spLocks/>
              </p:cNvSpPr>
              <p:nvPr/>
            </p:nvSpPr>
            <p:spPr bwMode="auto">
              <a:xfrm>
                <a:off x="3527426" y="1625601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5" name="Freeform 103"/>
              <p:cNvSpPr>
                <a:spLocks/>
              </p:cNvSpPr>
              <p:nvPr/>
            </p:nvSpPr>
            <p:spPr bwMode="auto">
              <a:xfrm>
                <a:off x="3527426" y="1625601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6" name="Freeform 104"/>
              <p:cNvSpPr>
                <a:spLocks/>
              </p:cNvSpPr>
              <p:nvPr/>
            </p:nvSpPr>
            <p:spPr bwMode="auto">
              <a:xfrm>
                <a:off x="3797301" y="166370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7" name="Freeform 105"/>
              <p:cNvSpPr>
                <a:spLocks/>
              </p:cNvSpPr>
              <p:nvPr/>
            </p:nvSpPr>
            <p:spPr bwMode="auto">
              <a:xfrm>
                <a:off x="3797301" y="1663701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8" name="Freeform 106"/>
              <p:cNvSpPr>
                <a:spLocks/>
              </p:cNvSpPr>
              <p:nvPr/>
            </p:nvSpPr>
            <p:spPr bwMode="auto">
              <a:xfrm>
                <a:off x="4059238" y="1743076"/>
                <a:ext cx="111125" cy="115888"/>
              </a:xfrm>
              <a:custGeom>
                <a:avLst/>
                <a:gdLst>
                  <a:gd name="T0" fmla="*/ 35 w 70"/>
                  <a:gd name="T1" fmla="*/ 0 h 73"/>
                  <a:gd name="T2" fmla="*/ 70 w 70"/>
                  <a:gd name="T3" fmla="*/ 36 h 73"/>
                  <a:gd name="T4" fmla="*/ 35 w 70"/>
                  <a:gd name="T5" fmla="*/ 73 h 73"/>
                  <a:gd name="T6" fmla="*/ 0 w 70"/>
                  <a:gd name="T7" fmla="*/ 36 h 73"/>
                  <a:gd name="T8" fmla="*/ 35 w 70"/>
                  <a:gd name="T9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3">
                    <a:moveTo>
                      <a:pt x="35" y="0"/>
                    </a:moveTo>
                    <a:lnTo>
                      <a:pt x="70" y="36"/>
                    </a:lnTo>
                    <a:lnTo>
                      <a:pt x="35" y="73"/>
                    </a:lnTo>
                    <a:lnTo>
                      <a:pt x="0" y="36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09" name="Freeform 107"/>
              <p:cNvSpPr>
                <a:spLocks/>
              </p:cNvSpPr>
              <p:nvPr/>
            </p:nvSpPr>
            <p:spPr bwMode="auto">
              <a:xfrm>
                <a:off x="4059238" y="1743076"/>
                <a:ext cx="111125" cy="115888"/>
              </a:xfrm>
              <a:custGeom>
                <a:avLst/>
                <a:gdLst>
                  <a:gd name="T0" fmla="*/ 35 w 70"/>
                  <a:gd name="T1" fmla="*/ 0 h 73"/>
                  <a:gd name="T2" fmla="*/ 70 w 70"/>
                  <a:gd name="T3" fmla="*/ 36 h 73"/>
                  <a:gd name="T4" fmla="*/ 35 w 70"/>
                  <a:gd name="T5" fmla="*/ 73 h 73"/>
                  <a:gd name="T6" fmla="*/ 0 w 70"/>
                  <a:gd name="T7" fmla="*/ 36 h 73"/>
                  <a:gd name="T8" fmla="*/ 35 w 70"/>
                  <a:gd name="T9" fmla="*/ 0 h 73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3">
                    <a:moveTo>
                      <a:pt x="35" y="0"/>
                    </a:moveTo>
                    <a:lnTo>
                      <a:pt x="70" y="36"/>
                    </a:lnTo>
                    <a:lnTo>
                      <a:pt x="35" y="73"/>
                    </a:lnTo>
                    <a:lnTo>
                      <a:pt x="0" y="36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0" name="Freeform 108"/>
              <p:cNvSpPr>
                <a:spLocks/>
              </p:cNvSpPr>
              <p:nvPr/>
            </p:nvSpPr>
            <p:spPr bwMode="auto">
              <a:xfrm>
                <a:off x="4254501" y="20939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1" name="Freeform 109"/>
              <p:cNvSpPr>
                <a:spLocks/>
              </p:cNvSpPr>
              <p:nvPr/>
            </p:nvSpPr>
            <p:spPr bwMode="auto">
              <a:xfrm>
                <a:off x="4254501" y="20939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2" name="Freeform 110"/>
              <p:cNvSpPr>
                <a:spLocks/>
              </p:cNvSpPr>
              <p:nvPr/>
            </p:nvSpPr>
            <p:spPr bwMode="auto">
              <a:xfrm>
                <a:off x="4451351" y="224948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3" name="Freeform 111"/>
              <p:cNvSpPr>
                <a:spLocks/>
              </p:cNvSpPr>
              <p:nvPr/>
            </p:nvSpPr>
            <p:spPr bwMode="auto">
              <a:xfrm>
                <a:off x="4451351" y="224948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4" name="Freeform 112"/>
              <p:cNvSpPr>
                <a:spLocks/>
              </p:cNvSpPr>
              <p:nvPr/>
            </p:nvSpPr>
            <p:spPr bwMode="auto">
              <a:xfrm>
                <a:off x="4721226" y="25130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5" name="Freeform 113"/>
              <p:cNvSpPr>
                <a:spLocks/>
              </p:cNvSpPr>
              <p:nvPr/>
            </p:nvSpPr>
            <p:spPr bwMode="auto">
              <a:xfrm>
                <a:off x="4721226" y="251301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6" name="Freeform 114"/>
              <p:cNvSpPr>
                <a:spLocks/>
              </p:cNvSpPr>
              <p:nvPr/>
            </p:nvSpPr>
            <p:spPr bwMode="auto">
              <a:xfrm>
                <a:off x="4918076" y="263048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7" name="Freeform 115"/>
              <p:cNvSpPr>
                <a:spLocks/>
              </p:cNvSpPr>
              <p:nvPr/>
            </p:nvSpPr>
            <p:spPr bwMode="auto">
              <a:xfrm>
                <a:off x="4918076" y="263048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8" name="Freeform 116"/>
              <p:cNvSpPr>
                <a:spLocks/>
              </p:cNvSpPr>
              <p:nvPr/>
            </p:nvSpPr>
            <p:spPr bwMode="auto">
              <a:xfrm>
                <a:off x="5178426" y="33321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19" name="Freeform 117"/>
              <p:cNvSpPr>
                <a:spLocks/>
              </p:cNvSpPr>
              <p:nvPr/>
            </p:nvSpPr>
            <p:spPr bwMode="auto">
              <a:xfrm>
                <a:off x="5178426" y="33321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0" name="Freeform 118"/>
              <p:cNvSpPr>
                <a:spLocks/>
              </p:cNvSpPr>
              <p:nvPr/>
            </p:nvSpPr>
            <p:spPr bwMode="auto">
              <a:xfrm>
                <a:off x="5384801" y="3908426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1" name="Freeform 119"/>
              <p:cNvSpPr>
                <a:spLocks/>
              </p:cNvSpPr>
              <p:nvPr/>
            </p:nvSpPr>
            <p:spPr bwMode="auto">
              <a:xfrm>
                <a:off x="5384801" y="3908426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2" name="Freeform 120"/>
              <p:cNvSpPr>
                <a:spLocks/>
              </p:cNvSpPr>
              <p:nvPr/>
            </p:nvSpPr>
            <p:spPr bwMode="auto">
              <a:xfrm>
                <a:off x="5580063" y="4600576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3" name="Freeform 121"/>
              <p:cNvSpPr>
                <a:spLocks/>
              </p:cNvSpPr>
              <p:nvPr/>
            </p:nvSpPr>
            <p:spPr bwMode="auto">
              <a:xfrm>
                <a:off x="5580063" y="4600576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4" name="Freeform 122"/>
              <p:cNvSpPr>
                <a:spLocks/>
              </p:cNvSpPr>
              <p:nvPr/>
            </p:nvSpPr>
            <p:spPr bwMode="auto">
              <a:xfrm>
                <a:off x="5645151" y="46402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5" name="Freeform 123"/>
              <p:cNvSpPr>
                <a:spLocks/>
              </p:cNvSpPr>
              <p:nvPr/>
            </p:nvSpPr>
            <p:spPr bwMode="auto">
              <a:xfrm>
                <a:off x="5645151" y="4640263"/>
                <a:ext cx="112713" cy="117475"/>
              </a:xfrm>
              <a:custGeom>
                <a:avLst/>
                <a:gdLst>
                  <a:gd name="T0" fmla="*/ 35 w 71"/>
                  <a:gd name="T1" fmla="*/ 0 h 74"/>
                  <a:gd name="T2" fmla="*/ 71 w 71"/>
                  <a:gd name="T3" fmla="*/ 37 h 74"/>
                  <a:gd name="T4" fmla="*/ 35 w 71"/>
                  <a:gd name="T5" fmla="*/ 74 h 74"/>
                  <a:gd name="T6" fmla="*/ 0 w 71"/>
                  <a:gd name="T7" fmla="*/ 37 h 74"/>
                  <a:gd name="T8" fmla="*/ 35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5" y="0"/>
                    </a:moveTo>
                    <a:lnTo>
                      <a:pt x="71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6" name="Freeform 124"/>
              <p:cNvSpPr>
                <a:spLocks/>
              </p:cNvSpPr>
              <p:nvPr/>
            </p:nvSpPr>
            <p:spPr bwMode="auto">
              <a:xfrm>
                <a:off x="5842001" y="479583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7" name="Freeform 125"/>
              <p:cNvSpPr>
                <a:spLocks/>
              </p:cNvSpPr>
              <p:nvPr/>
            </p:nvSpPr>
            <p:spPr bwMode="auto">
              <a:xfrm>
                <a:off x="5842001" y="4795838"/>
                <a:ext cx="111125" cy="117475"/>
              </a:xfrm>
              <a:custGeom>
                <a:avLst/>
                <a:gdLst>
                  <a:gd name="T0" fmla="*/ 35 w 70"/>
                  <a:gd name="T1" fmla="*/ 0 h 74"/>
                  <a:gd name="T2" fmla="*/ 70 w 70"/>
                  <a:gd name="T3" fmla="*/ 37 h 74"/>
                  <a:gd name="T4" fmla="*/ 35 w 70"/>
                  <a:gd name="T5" fmla="*/ 74 h 74"/>
                  <a:gd name="T6" fmla="*/ 0 w 70"/>
                  <a:gd name="T7" fmla="*/ 37 h 74"/>
                  <a:gd name="T8" fmla="*/ 35 w 70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0" h="74">
                    <a:moveTo>
                      <a:pt x="35" y="0"/>
                    </a:moveTo>
                    <a:lnTo>
                      <a:pt x="70" y="37"/>
                    </a:lnTo>
                    <a:lnTo>
                      <a:pt x="35" y="74"/>
                    </a:lnTo>
                    <a:lnTo>
                      <a:pt x="0" y="37"/>
                    </a:lnTo>
                    <a:lnTo>
                      <a:pt x="35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8" name="Freeform 126"/>
              <p:cNvSpPr>
                <a:spLocks/>
              </p:cNvSpPr>
              <p:nvPr/>
            </p:nvSpPr>
            <p:spPr bwMode="auto">
              <a:xfrm>
                <a:off x="6102351" y="4913313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37 h 74"/>
                  <a:gd name="T4" fmla="*/ 36 w 71"/>
                  <a:gd name="T5" fmla="*/ 74 h 74"/>
                  <a:gd name="T6" fmla="*/ 0 w 71"/>
                  <a:gd name="T7" fmla="*/ 37 h 74"/>
                  <a:gd name="T8" fmla="*/ 36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37"/>
                    </a:lnTo>
                    <a:lnTo>
                      <a:pt x="36" y="74"/>
                    </a:lnTo>
                    <a:lnTo>
                      <a:pt x="0" y="37"/>
                    </a:lnTo>
                    <a:lnTo>
                      <a:pt x="36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29" name="Freeform 127"/>
              <p:cNvSpPr>
                <a:spLocks/>
              </p:cNvSpPr>
              <p:nvPr/>
            </p:nvSpPr>
            <p:spPr bwMode="auto">
              <a:xfrm>
                <a:off x="6102351" y="4913313"/>
                <a:ext cx="112713" cy="117475"/>
              </a:xfrm>
              <a:custGeom>
                <a:avLst/>
                <a:gdLst>
                  <a:gd name="T0" fmla="*/ 36 w 71"/>
                  <a:gd name="T1" fmla="*/ 0 h 74"/>
                  <a:gd name="T2" fmla="*/ 71 w 71"/>
                  <a:gd name="T3" fmla="*/ 37 h 74"/>
                  <a:gd name="T4" fmla="*/ 36 w 71"/>
                  <a:gd name="T5" fmla="*/ 74 h 74"/>
                  <a:gd name="T6" fmla="*/ 0 w 71"/>
                  <a:gd name="T7" fmla="*/ 37 h 74"/>
                  <a:gd name="T8" fmla="*/ 36 w 71"/>
                  <a:gd name="T9" fmla="*/ 0 h 7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71" h="74">
                    <a:moveTo>
                      <a:pt x="36" y="0"/>
                    </a:moveTo>
                    <a:lnTo>
                      <a:pt x="71" y="37"/>
                    </a:lnTo>
                    <a:lnTo>
                      <a:pt x="36" y="74"/>
                    </a:lnTo>
                    <a:lnTo>
                      <a:pt x="0" y="37"/>
                    </a:lnTo>
                    <a:lnTo>
                      <a:pt x="36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30" name="Rectangle 128"/>
              <p:cNvSpPr>
                <a:spLocks noChangeArrowheads="1"/>
              </p:cNvSpPr>
              <p:nvPr/>
            </p:nvSpPr>
            <p:spPr bwMode="auto">
              <a:xfrm>
                <a:off x="1774826" y="4878388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1" name="Rectangle 129"/>
              <p:cNvSpPr>
                <a:spLocks noChangeArrowheads="1"/>
              </p:cNvSpPr>
              <p:nvPr/>
            </p:nvSpPr>
            <p:spPr bwMode="auto">
              <a:xfrm>
                <a:off x="1687513" y="453866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1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2" name="Rectangle 130"/>
              <p:cNvSpPr>
                <a:spLocks noChangeArrowheads="1"/>
              </p:cNvSpPr>
              <p:nvPr/>
            </p:nvSpPr>
            <p:spPr bwMode="auto">
              <a:xfrm>
                <a:off x="1687513" y="4198938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2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3" name="Rectangle 131"/>
              <p:cNvSpPr>
                <a:spLocks noChangeArrowheads="1"/>
              </p:cNvSpPr>
              <p:nvPr/>
            </p:nvSpPr>
            <p:spPr bwMode="auto">
              <a:xfrm>
                <a:off x="1687513" y="385921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3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4" name="Rectangle 132"/>
              <p:cNvSpPr>
                <a:spLocks noChangeArrowheads="1"/>
              </p:cNvSpPr>
              <p:nvPr/>
            </p:nvSpPr>
            <p:spPr bwMode="auto">
              <a:xfrm>
                <a:off x="1687513" y="3516313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4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5" name="Rectangle 133"/>
              <p:cNvSpPr>
                <a:spLocks noChangeArrowheads="1"/>
              </p:cNvSpPr>
              <p:nvPr/>
            </p:nvSpPr>
            <p:spPr bwMode="auto">
              <a:xfrm>
                <a:off x="1687513" y="3176588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5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6" name="Rectangle 134"/>
              <p:cNvSpPr>
                <a:spLocks noChangeArrowheads="1"/>
              </p:cNvSpPr>
              <p:nvPr/>
            </p:nvSpPr>
            <p:spPr bwMode="auto">
              <a:xfrm>
                <a:off x="1687513" y="2838451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6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7" name="Rectangle 135"/>
              <p:cNvSpPr>
                <a:spLocks noChangeArrowheads="1"/>
              </p:cNvSpPr>
              <p:nvPr/>
            </p:nvSpPr>
            <p:spPr bwMode="auto">
              <a:xfrm>
                <a:off x="1687513" y="2498726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7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8" name="Rectangle 136"/>
              <p:cNvSpPr>
                <a:spLocks noChangeArrowheads="1"/>
              </p:cNvSpPr>
              <p:nvPr/>
            </p:nvSpPr>
            <p:spPr bwMode="auto">
              <a:xfrm>
                <a:off x="1687513" y="2159001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8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39" name="Rectangle 137"/>
              <p:cNvSpPr>
                <a:spLocks noChangeArrowheads="1"/>
              </p:cNvSpPr>
              <p:nvPr/>
            </p:nvSpPr>
            <p:spPr bwMode="auto">
              <a:xfrm>
                <a:off x="1687513" y="1819276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9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0" name="Rectangle 138"/>
              <p:cNvSpPr>
                <a:spLocks noChangeArrowheads="1"/>
              </p:cNvSpPr>
              <p:nvPr/>
            </p:nvSpPr>
            <p:spPr bwMode="auto">
              <a:xfrm>
                <a:off x="1598613" y="1476376"/>
                <a:ext cx="25487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10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1" name="Rectangle 139"/>
              <p:cNvSpPr>
                <a:spLocks noChangeArrowheads="1"/>
              </p:cNvSpPr>
              <p:nvPr/>
            </p:nvSpPr>
            <p:spPr bwMode="auto">
              <a:xfrm>
                <a:off x="1962151" y="5080001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2" name="Rectangle 140"/>
              <p:cNvSpPr>
                <a:spLocks noChangeArrowheads="1"/>
              </p:cNvSpPr>
              <p:nvPr/>
            </p:nvSpPr>
            <p:spPr bwMode="auto">
              <a:xfrm>
                <a:off x="3238501" y="5080001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2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3" name="Rectangle 141"/>
              <p:cNvSpPr>
                <a:spLocks noChangeArrowheads="1"/>
              </p:cNvSpPr>
              <p:nvPr/>
            </p:nvSpPr>
            <p:spPr bwMode="auto">
              <a:xfrm>
                <a:off x="4559301" y="5080001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4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44" name="Rectangle 142"/>
              <p:cNvSpPr>
                <a:spLocks noChangeArrowheads="1"/>
              </p:cNvSpPr>
              <p:nvPr/>
            </p:nvSpPr>
            <p:spPr bwMode="auto">
              <a:xfrm>
                <a:off x="5881688" y="5080001"/>
                <a:ext cx="16991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zh-TW" altLang="zh-TW" sz="12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60</a:t>
                </a:r>
                <a:endParaRPr kumimoji="0" lang="zh-TW" altLang="zh-TW" sz="12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61" name="群組 160"/>
            <p:cNvGrpSpPr/>
            <p:nvPr/>
          </p:nvGrpSpPr>
          <p:grpSpPr>
            <a:xfrm>
              <a:off x="2817711" y="3857149"/>
              <a:ext cx="2273720" cy="887413"/>
              <a:chOff x="6542088" y="2824163"/>
              <a:chExt cx="2273720" cy="887413"/>
            </a:xfrm>
          </p:grpSpPr>
          <p:sp>
            <p:nvSpPr>
              <p:cNvPr id="145" name="Rectangle 143"/>
              <p:cNvSpPr>
                <a:spLocks noChangeArrowheads="1"/>
              </p:cNvSpPr>
              <p:nvPr/>
            </p:nvSpPr>
            <p:spPr bwMode="auto">
              <a:xfrm>
                <a:off x="6542088" y="2824163"/>
                <a:ext cx="1128713" cy="887413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47" name="Line 145"/>
              <p:cNvSpPr>
                <a:spLocks noChangeShapeType="1"/>
              </p:cNvSpPr>
              <p:nvPr/>
            </p:nvSpPr>
            <p:spPr bwMode="auto">
              <a:xfrm>
                <a:off x="6691313" y="2970213"/>
                <a:ext cx="392113" cy="0"/>
              </a:xfrm>
              <a:prstGeom prst="line">
                <a:avLst/>
              </a:prstGeom>
              <a:noFill/>
              <a:ln w="460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48" name="Rectangle 146"/>
              <p:cNvSpPr>
                <a:spLocks noChangeArrowheads="1"/>
              </p:cNvSpPr>
              <p:nvPr/>
            </p:nvSpPr>
            <p:spPr bwMode="auto">
              <a:xfrm>
                <a:off x="6840538" y="2921001"/>
                <a:ext cx="84138" cy="88900"/>
              </a:xfrm>
              <a:prstGeom prst="rect">
                <a:avLst/>
              </a:prstGeom>
              <a:solidFill>
                <a:srgbClr val="333333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49" name="Rectangle 147"/>
              <p:cNvSpPr>
                <a:spLocks noChangeArrowheads="1"/>
              </p:cNvSpPr>
              <p:nvPr/>
            </p:nvSpPr>
            <p:spPr bwMode="auto">
              <a:xfrm>
                <a:off x="6840538" y="2921001"/>
                <a:ext cx="84138" cy="88900"/>
              </a:xfrm>
              <a:prstGeom prst="rect">
                <a:avLst/>
              </a:prstGeom>
              <a:noFill/>
              <a:ln w="9525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0" name="Rectangle 148"/>
              <p:cNvSpPr>
                <a:spLocks noChangeArrowheads="1"/>
              </p:cNvSpPr>
              <p:nvPr/>
            </p:nvSpPr>
            <p:spPr bwMode="auto">
              <a:xfrm>
                <a:off x="7131051" y="2900363"/>
                <a:ext cx="1118896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zh-TW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EK(-) _W(CS10)</a:t>
                </a:r>
                <a:endParaRPr kumimoji="0" lang="zh-TW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1" name="Freeform 149"/>
              <p:cNvSpPr>
                <a:spLocks noEditPoints="1"/>
              </p:cNvSpPr>
              <p:nvPr/>
            </p:nvSpPr>
            <p:spPr bwMode="auto">
              <a:xfrm>
                <a:off x="6667501" y="3248026"/>
                <a:ext cx="438150" cy="49213"/>
              </a:xfrm>
              <a:custGeom>
                <a:avLst/>
                <a:gdLst>
                  <a:gd name="T0" fmla="*/ 40 w 752"/>
                  <a:gd name="T1" fmla="*/ 0 h 80"/>
                  <a:gd name="T2" fmla="*/ 200 w 752"/>
                  <a:gd name="T3" fmla="*/ 0 h 80"/>
                  <a:gd name="T4" fmla="*/ 240 w 752"/>
                  <a:gd name="T5" fmla="*/ 40 h 80"/>
                  <a:gd name="T6" fmla="*/ 200 w 752"/>
                  <a:gd name="T7" fmla="*/ 80 h 80"/>
                  <a:gd name="T8" fmla="*/ 40 w 752"/>
                  <a:gd name="T9" fmla="*/ 80 h 80"/>
                  <a:gd name="T10" fmla="*/ 0 w 752"/>
                  <a:gd name="T11" fmla="*/ 40 h 80"/>
                  <a:gd name="T12" fmla="*/ 40 w 752"/>
                  <a:gd name="T13" fmla="*/ 0 h 80"/>
                  <a:gd name="T14" fmla="*/ 360 w 752"/>
                  <a:gd name="T15" fmla="*/ 0 h 80"/>
                  <a:gd name="T16" fmla="*/ 520 w 752"/>
                  <a:gd name="T17" fmla="*/ 0 h 80"/>
                  <a:gd name="T18" fmla="*/ 560 w 752"/>
                  <a:gd name="T19" fmla="*/ 40 h 80"/>
                  <a:gd name="T20" fmla="*/ 520 w 752"/>
                  <a:gd name="T21" fmla="*/ 80 h 80"/>
                  <a:gd name="T22" fmla="*/ 360 w 752"/>
                  <a:gd name="T23" fmla="*/ 80 h 80"/>
                  <a:gd name="T24" fmla="*/ 320 w 752"/>
                  <a:gd name="T25" fmla="*/ 40 h 80"/>
                  <a:gd name="T26" fmla="*/ 360 w 752"/>
                  <a:gd name="T27" fmla="*/ 0 h 80"/>
                  <a:gd name="T28" fmla="*/ 680 w 752"/>
                  <a:gd name="T29" fmla="*/ 0 h 80"/>
                  <a:gd name="T30" fmla="*/ 712 w 752"/>
                  <a:gd name="T31" fmla="*/ 0 h 80"/>
                  <a:gd name="T32" fmla="*/ 752 w 752"/>
                  <a:gd name="T33" fmla="*/ 40 h 80"/>
                  <a:gd name="T34" fmla="*/ 712 w 752"/>
                  <a:gd name="T35" fmla="*/ 80 h 80"/>
                  <a:gd name="T36" fmla="*/ 680 w 752"/>
                  <a:gd name="T37" fmla="*/ 80 h 80"/>
                  <a:gd name="T38" fmla="*/ 640 w 752"/>
                  <a:gd name="T39" fmla="*/ 40 h 80"/>
                  <a:gd name="T40" fmla="*/ 680 w 752"/>
                  <a:gd name="T41" fmla="*/ 0 h 8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</a:cxnLst>
                <a:rect l="0" t="0" r="r" b="b"/>
                <a:pathLst>
                  <a:path w="752" h="80">
                    <a:moveTo>
                      <a:pt x="40" y="0"/>
                    </a:moveTo>
                    <a:lnTo>
                      <a:pt x="200" y="0"/>
                    </a:lnTo>
                    <a:cubicBezTo>
                      <a:pt x="223" y="0"/>
                      <a:pt x="240" y="18"/>
                      <a:pt x="240" y="40"/>
                    </a:cubicBezTo>
                    <a:cubicBezTo>
                      <a:pt x="240" y="63"/>
                      <a:pt x="223" y="80"/>
                      <a:pt x="200" y="80"/>
                    </a:cubicBezTo>
                    <a:lnTo>
                      <a:pt x="40" y="80"/>
                    </a:lnTo>
                    <a:cubicBezTo>
                      <a:pt x="18" y="80"/>
                      <a:pt x="0" y="63"/>
                      <a:pt x="0" y="40"/>
                    </a:cubicBezTo>
                    <a:cubicBezTo>
                      <a:pt x="0" y="18"/>
                      <a:pt x="18" y="0"/>
                      <a:pt x="40" y="0"/>
                    </a:cubicBezTo>
                    <a:close/>
                    <a:moveTo>
                      <a:pt x="360" y="0"/>
                    </a:moveTo>
                    <a:lnTo>
                      <a:pt x="520" y="0"/>
                    </a:lnTo>
                    <a:cubicBezTo>
                      <a:pt x="543" y="0"/>
                      <a:pt x="560" y="18"/>
                      <a:pt x="560" y="40"/>
                    </a:cubicBezTo>
                    <a:cubicBezTo>
                      <a:pt x="560" y="63"/>
                      <a:pt x="543" y="80"/>
                      <a:pt x="520" y="80"/>
                    </a:cubicBezTo>
                    <a:lnTo>
                      <a:pt x="360" y="80"/>
                    </a:lnTo>
                    <a:cubicBezTo>
                      <a:pt x="338" y="80"/>
                      <a:pt x="320" y="63"/>
                      <a:pt x="320" y="40"/>
                    </a:cubicBezTo>
                    <a:cubicBezTo>
                      <a:pt x="320" y="18"/>
                      <a:pt x="338" y="0"/>
                      <a:pt x="360" y="0"/>
                    </a:cubicBezTo>
                    <a:close/>
                    <a:moveTo>
                      <a:pt x="680" y="0"/>
                    </a:moveTo>
                    <a:lnTo>
                      <a:pt x="712" y="0"/>
                    </a:lnTo>
                    <a:cubicBezTo>
                      <a:pt x="735" y="0"/>
                      <a:pt x="752" y="18"/>
                      <a:pt x="752" y="40"/>
                    </a:cubicBezTo>
                    <a:cubicBezTo>
                      <a:pt x="752" y="63"/>
                      <a:pt x="735" y="80"/>
                      <a:pt x="712" y="80"/>
                    </a:cubicBezTo>
                    <a:lnTo>
                      <a:pt x="680" y="80"/>
                    </a:lnTo>
                    <a:cubicBezTo>
                      <a:pt x="658" y="80"/>
                      <a:pt x="640" y="63"/>
                      <a:pt x="640" y="40"/>
                    </a:cubicBezTo>
                    <a:cubicBezTo>
                      <a:pt x="640" y="18"/>
                      <a:pt x="658" y="0"/>
                      <a:pt x="680" y="0"/>
                    </a:cubicBezTo>
                    <a:close/>
                  </a:path>
                </a:pathLst>
              </a:custGeom>
              <a:solidFill>
                <a:srgbClr val="333333"/>
              </a:solidFill>
              <a:ln w="0" cap="flat">
                <a:solidFill>
                  <a:srgbClr val="333333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2" name="Freeform 150"/>
              <p:cNvSpPr>
                <a:spLocks/>
              </p:cNvSpPr>
              <p:nvPr/>
            </p:nvSpPr>
            <p:spPr bwMode="auto">
              <a:xfrm>
                <a:off x="6840538" y="3224213"/>
                <a:ext cx="93663" cy="96838"/>
              </a:xfrm>
              <a:custGeom>
                <a:avLst/>
                <a:gdLst>
                  <a:gd name="T0" fmla="*/ 29 w 59"/>
                  <a:gd name="T1" fmla="*/ 0 h 61"/>
                  <a:gd name="T2" fmla="*/ 59 w 59"/>
                  <a:gd name="T3" fmla="*/ 61 h 61"/>
                  <a:gd name="T4" fmla="*/ 0 w 59"/>
                  <a:gd name="T5" fmla="*/ 61 h 61"/>
                  <a:gd name="T6" fmla="*/ 29 w 59"/>
                  <a:gd name="T7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9" h="61">
                    <a:moveTo>
                      <a:pt x="29" y="0"/>
                    </a:moveTo>
                    <a:lnTo>
                      <a:pt x="59" y="61"/>
                    </a:lnTo>
                    <a:lnTo>
                      <a:pt x="0" y="61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C0C0C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3" name="Freeform 151"/>
              <p:cNvSpPr>
                <a:spLocks/>
              </p:cNvSpPr>
              <p:nvPr/>
            </p:nvSpPr>
            <p:spPr bwMode="auto">
              <a:xfrm>
                <a:off x="6840538" y="3224213"/>
                <a:ext cx="93663" cy="96838"/>
              </a:xfrm>
              <a:custGeom>
                <a:avLst/>
                <a:gdLst>
                  <a:gd name="T0" fmla="*/ 29 w 59"/>
                  <a:gd name="T1" fmla="*/ 0 h 61"/>
                  <a:gd name="T2" fmla="*/ 59 w 59"/>
                  <a:gd name="T3" fmla="*/ 61 h 61"/>
                  <a:gd name="T4" fmla="*/ 0 w 59"/>
                  <a:gd name="T5" fmla="*/ 61 h 61"/>
                  <a:gd name="T6" fmla="*/ 29 w 59"/>
                  <a:gd name="T7" fmla="*/ 0 h 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59" h="61">
                    <a:moveTo>
                      <a:pt x="29" y="0"/>
                    </a:moveTo>
                    <a:lnTo>
                      <a:pt x="59" y="61"/>
                    </a:lnTo>
                    <a:lnTo>
                      <a:pt x="0" y="61"/>
                    </a:lnTo>
                    <a:lnTo>
                      <a:pt x="29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C0C0C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4" name="Rectangle 152"/>
              <p:cNvSpPr>
                <a:spLocks noChangeArrowheads="1"/>
              </p:cNvSpPr>
              <p:nvPr/>
            </p:nvSpPr>
            <p:spPr bwMode="auto">
              <a:xfrm>
                <a:off x="7131051" y="3195638"/>
                <a:ext cx="168475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TW" altLang="zh-TW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E</a:t>
                </a:r>
                <a:r>
                  <a:rPr kumimoji="0" lang="en-US" altLang="zh-TW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K</a:t>
                </a:r>
                <a:r>
                  <a:rPr lang="el-GR" altLang="zh-TW" sz="1200" dirty="0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 </a:t>
                </a:r>
                <a:r>
                  <a:rPr lang="en-US" altLang="zh-TW" sz="1200" dirty="0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1</a:t>
                </a:r>
                <a:r>
                  <a:rPr lang="el-GR" altLang="zh-TW" sz="1200" dirty="0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25 </a:t>
                </a:r>
                <a:r>
                  <a:rPr lang="el-GR" altLang="zh-TW" sz="12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μ</a:t>
                </a:r>
                <a:r>
                  <a:rPr lang="en-US" altLang="zh-TW" sz="1200" dirty="0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g/ml _W(CS10)</a:t>
                </a:r>
                <a:endParaRPr kumimoji="0" lang="zh-TW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55" name="Line 153"/>
              <p:cNvSpPr>
                <a:spLocks noChangeShapeType="1"/>
              </p:cNvSpPr>
              <p:nvPr/>
            </p:nvSpPr>
            <p:spPr bwMode="auto">
              <a:xfrm>
                <a:off x="6691313" y="3565526"/>
                <a:ext cx="392113" cy="0"/>
              </a:xfrm>
              <a:prstGeom prst="line">
                <a:avLst/>
              </a:prstGeom>
              <a:noFill/>
              <a:ln w="46038" cap="rnd">
                <a:solidFill>
                  <a:srgbClr val="333333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6" name="Freeform 154"/>
              <p:cNvSpPr>
                <a:spLocks/>
              </p:cNvSpPr>
              <p:nvPr/>
            </p:nvSpPr>
            <p:spPr bwMode="auto">
              <a:xfrm>
                <a:off x="6840538" y="3516313"/>
                <a:ext cx="93663" cy="98425"/>
              </a:xfrm>
              <a:custGeom>
                <a:avLst/>
                <a:gdLst>
                  <a:gd name="T0" fmla="*/ 29 w 59"/>
                  <a:gd name="T1" fmla="*/ 0 h 62"/>
                  <a:gd name="T2" fmla="*/ 59 w 59"/>
                  <a:gd name="T3" fmla="*/ 31 h 62"/>
                  <a:gd name="T4" fmla="*/ 29 w 59"/>
                  <a:gd name="T5" fmla="*/ 62 h 62"/>
                  <a:gd name="T6" fmla="*/ 0 w 59"/>
                  <a:gd name="T7" fmla="*/ 31 h 62"/>
                  <a:gd name="T8" fmla="*/ 29 w 59"/>
                  <a:gd name="T9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9" h="62">
                    <a:moveTo>
                      <a:pt x="29" y="0"/>
                    </a:moveTo>
                    <a:lnTo>
                      <a:pt x="59" y="31"/>
                    </a:lnTo>
                    <a:lnTo>
                      <a:pt x="29" y="62"/>
                    </a:lnTo>
                    <a:lnTo>
                      <a:pt x="0" y="31"/>
                    </a:lnTo>
                    <a:lnTo>
                      <a:pt x="29" y="0"/>
                    </a:lnTo>
                    <a:close/>
                  </a:path>
                </a:pathLst>
              </a:custGeom>
              <a:solidFill>
                <a:srgbClr val="96969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7" name="Freeform 155"/>
              <p:cNvSpPr>
                <a:spLocks/>
              </p:cNvSpPr>
              <p:nvPr/>
            </p:nvSpPr>
            <p:spPr bwMode="auto">
              <a:xfrm>
                <a:off x="6840538" y="3516313"/>
                <a:ext cx="93663" cy="98425"/>
              </a:xfrm>
              <a:custGeom>
                <a:avLst/>
                <a:gdLst>
                  <a:gd name="T0" fmla="*/ 29 w 59"/>
                  <a:gd name="T1" fmla="*/ 0 h 62"/>
                  <a:gd name="T2" fmla="*/ 59 w 59"/>
                  <a:gd name="T3" fmla="*/ 31 h 62"/>
                  <a:gd name="T4" fmla="*/ 29 w 59"/>
                  <a:gd name="T5" fmla="*/ 62 h 62"/>
                  <a:gd name="T6" fmla="*/ 0 w 59"/>
                  <a:gd name="T7" fmla="*/ 31 h 62"/>
                  <a:gd name="T8" fmla="*/ 29 w 59"/>
                  <a:gd name="T9" fmla="*/ 0 h 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59" h="62">
                    <a:moveTo>
                      <a:pt x="29" y="0"/>
                    </a:moveTo>
                    <a:lnTo>
                      <a:pt x="59" y="31"/>
                    </a:lnTo>
                    <a:lnTo>
                      <a:pt x="29" y="62"/>
                    </a:lnTo>
                    <a:lnTo>
                      <a:pt x="0" y="31"/>
                    </a:lnTo>
                    <a:lnTo>
                      <a:pt x="29" y="0"/>
                    </a:lnTo>
                    <a:close/>
                  </a:path>
                </a:pathLst>
              </a:custGeom>
              <a:noFill/>
              <a:ln w="9525" cap="flat">
                <a:solidFill>
                  <a:srgbClr val="969696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TW" altLang="en-US"/>
              </a:p>
            </p:txBody>
          </p:sp>
          <p:sp>
            <p:nvSpPr>
              <p:cNvPr id="158" name="Rectangle 156"/>
              <p:cNvSpPr>
                <a:spLocks noChangeArrowheads="1"/>
              </p:cNvSpPr>
              <p:nvPr/>
            </p:nvSpPr>
            <p:spPr bwMode="auto">
              <a:xfrm>
                <a:off x="7131051" y="3490913"/>
                <a:ext cx="168475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lvl="0"/>
                <a:r>
                  <a:rPr kumimoji="0" lang="zh-TW" altLang="zh-TW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E</a:t>
                </a:r>
                <a:r>
                  <a:rPr kumimoji="0" lang="en-US" altLang="zh-TW" sz="12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ea typeface="新細明體" panose="02020500000000000000" pitchFamily="18" charset="-120"/>
                    <a:cs typeface="Arial" panose="020B0604020202020204" pitchFamily="34" charset="0"/>
                  </a:rPr>
                  <a:t>K</a:t>
                </a:r>
                <a:r>
                  <a:rPr lang="en-US" altLang="zh-TW" sz="1200" dirty="0">
                    <a:solidFill>
                      <a:srgbClr val="000000"/>
                    </a:solidFill>
                    <a:ea typeface="新細明體" panose="02020500000000000000" pitchFamily="18" charset="-120"/>
                    <a:cs typeface="Arial" panose="020B0604020202020204" pitchFamily="34" charset="0"/>
                  </a:rPr>
                  <a:t> </a:t>
                </a:r>
                <a:r>
                  <a:rPr lang="el-GR" altLang="zh-TW" sz="1200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 250 μ</a:t>
                </a:r>
                <a:r>
                  <a:rPr lang="en-US" altLang="zh-TW" sz="1200" dirty="0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g/</a:t>
                </a:r>
                <a:r>
                  <a:rPr lang="en-US" altLang="zh-TW" sz="1200" dirty="0" err="1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ml_W</a:t>
                </a:r>
                <a:r>
                  <a:rPr lang="en-US" altLang="zh-TW" sz="1200" dirty="0" smtClean="0">
                    <a:solidFill>
                      <a:srgbClr val="000000"/>
                    </a:solidFill>
                    <a:cs typeface="Arial" panose="020B0604020202020204" pitchFamily="34" charset="0"/>
                  </a:rPr>
                  <a:t>(CS10)</a:t>
                </a:r>
                <a:endParaRPr kumimoji="0" lang="zh-TW" altLang="zh-TW" sz="12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63" name="文字方塊 162"/>
            <p:cNvSpPr txBox="1"/>
            <p:nvPr/>
          </p:nvSpPr>
          <p:spPr>
            <a:xfrm>
              <a:off x="4426204" y="5161281"/>
              <a:ext cx="6478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endParaRPr lang="zh-TW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文字方塊 163"/>
            <p:cNvSpPr txBox="1"/>
            <p:nvPr/>
          </p:nvSpPr>
          <p:spPr>
            <a:xfrm rot="16200000">
              <a:off x="1224538" y="2835692"/>
              <a:ext cx="16121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rvival rate (%)</a:t>
              </a:r>
              <a:endParaRPr lang="zh-TW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002679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Freeform 6"/>
          <p:cNvSpPr>
            <a:spLocks noEditPoints="1"/>
          </p:cNvSpPr>
          <p:nvPr/>
        </p:nvSpPr>
        <p:spPr bwMode="auto">
          <a:xfrm>
            <a:off x="2368551" y="2398713"/>
            <a:ext cx="4611688" cy="2432050"/>
          </a:xfrm>
          <a:custGeom>
            <a:avLst/>
            <a:gdLst>
              <a:gd name="T0" fmla="*/ 0 w 2905"/>
              <a:gd name="T1" fmla="*/ 603 h 1532"/>
              <a:gd name="T2" fmla="*/ 124 w 2905"/>
              <a:gd name="T3" fmla="*/ 603 h 1532"/>
              <a:gd name="T4" fmla="*/ 124 w 2905"/>
              <a:gd name="T5" fmla="*/ 1532 h 1532"/>
              <a:gd name="T6" fmla="*/ 0 w 2905"/>
              <a:gd name="T7" fmla="*/ 1532 h 1532"/>
              <a:gd name="T8" fmla="*/ 0 w 2905"/>
              <a:gd name="T9" fmla="*/ 603 h 1532"/>
              <a:gd name="T10" fmla="*/ 394 w 2905"/>
              <a:gd name="T11" fmla="*/ 904 h 1532"/>
              <a:gd name="T12" fmla="*/ 524 w 2905"/>
              <a:gd name="T13" fmla="*/ 904 h 1532"/>
              <a:gd name="T14" fmla="*/ 524 w 2905"/>
              <a:gd name="T15" fmla="*/ 1532 h 1532"/>
              <a:gd name="T16" fmla="*/ 394 w 2905"/>
              <a:gd name="T17" fmla="*/ 1532 h 1532"/>
              <a:gd name="T18" fmla="*/ 394 w 2905"/>
              <a:gd name="T19" fmla="*/ 904 h 1532"/>
              <a:gd name="T20" fmla="*/ 794 w 2905"/>
              <a:gd name="T21" fmla="*/ 0 h 1532"/>
              <a:gd name="T22" fmla="*/ 918 w 2905"/>
              <a:gd name="T23" fmla="*/ 0 h 1532"/>
              <a:gd name="T24" fmla="*/ 918 w 2905"/>
              <a:gd name="T25" fmla="*/ 1532 h 1532"/>
              <a:gd name="T26" fmla="*/ 794 w 2905"/>
              <a:gd name="T27" fmla="*/ 1532 h 1532"/>
              <a:gd name="T28" fmla="*/ 794 w 2905"/>
              <a:gd name="T29" fmla="*/ 0 h 1532"/>
              <a:gd name="T30" fmla="*/ 1988 w 2905"/>
              <a:gd name="T31" fmla="*/ 1396 h 1532"/>
              <a:gd name="T32" fmla="*/ 2111 w 2905"/>
              <a:gd name="T33" fmla="*/ 1396 h 1532"/>
              <a:gd name="T34" fmla="*/ 2111 w 2905"/>
              <a:gd name="T35" fmla="*/ 1532 h 1532"/>
              <a:gd name="T36" fmla="*/ 1988 w 2905"/>
              <a:gd name="T37" fmla="*/ 1532 h 1532"/>
              <a:gd name="T38" fmla="*/ 1988 w 2905"/>
              <a:gd name="T39" fmla="*/ 1396 h 1532"/>
              <a:gd name="T40" fmla="*/ 2388 w 2905"/>
              <a:gd name="T41" fmla="*/ 1323 h 1532"/>
              <a:gd name="T42" fmla="*/ 2511 w 2905"/>
              <a:gd name="T43" fmla="*/ 1323 h 1532"/>
              <a:gd name="T44" fmla="*/ 2511 w 2905"/>
              <a:gd name="T45" fmla="*/ 1532 h 1532"/>
              <a:gd name="T46" fmla="*/ 2388 w 2905"/>
              <a:gd name="T47" fmla="*/ 1532 h 1532"/>
              <a:gd name="T48" fmla="*/ 2388 w 2905"/>
              <a:gd name="T49" fmla="*/ 1323 h 1532"/>
              <a:gd name="T50" fmla="*/ 2782 w 2905"/>
              <a:gd name="T51" fmla="*/ 394 h 1532"/>
              <a:gd name="T52" fmla="*/ 2905 w 2905"/>
              <a:gd name="T53" fmla="*/ 394 h 1532"/>
              <a:gd name="T54" fmla="*/ 2905 w 2905"/>
              <a:gd name="T55" fmla="*/ 1532 h 1532"/>
              <a:gd name="T56" fmla="*/ 2782 w 2905"/>
              <a:gd name="T57" fmla="*/ 1532 h 1532"/>
              <a:gd name="T58" fmla="*/ 2782 w 2905"/>
              <a:gd name="T59" fmla="*/ 394 h 15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  <a:cxn ang="0">
                <a:pos x="T32" y="T33"/>
              </a:cxn>
              <a:cxn ang="0">
                <a:pos x="T34" y="T35"/>
              </a:cxn>
              <a:cxn ang="0">
                <a:pos x="T36" y="T37"/>
              </a:cxn>
              <a:cxn ang="0">
                <a:pos x="T38" y="T39"/>
              </a:cxn>
              <a:cxn ang="0">
                <a:pos x="T40" y="T41"/>
              </a:cxn>
              <a:cxn ang="0">
                <a:pos x="T42" y="T43"/>
              </a:cxn>
              <a:cxn ang="0">
                <a:pos x="T44" y="T45"/>
              </a:cxn>
              <a:cxn ang="0">
                <a:pos x="T46" y="T47"/>
              </a:cxn>
              <a:cxn ang="0">
                <a:pos x="T48" y="T49"/>
              </a:cxn>
              <a:cxn ang="0">
                <a:pos x="T50" y="T51"/>
              </a:cxn>
              <a:cxn ang="0">
                <a:pos x="T52" y="T53"/>
              </a:cxn>
              <a:cxn ang="0">
                <a:pos x="T54" y="T55"/>
              </a:cxn>
              <a:cxn ang="0">
                <a:pos x="T56" y="T57"/>
              </a:cxn>
              <a:cxn ang="0">
                <a:pos x="T58" y="T59"/>
              </a:cxn>
            </a:cxnLst>
            <a:rect l="0" t="0" r="r" b="b"/>
            <a:pathLst>
              <a:path w="2905" h="1532">
                <a:moveTo>
                  <a:pt x="0" y="603"/>
                </a:moveTo>
                <a:lnTo>
                  <a:pt x="124" y="603"/>
                </a:lnTo>
                <a:lnTo>
                  <a:pt x="124" y="1532"/>
                </a:lnTo>
                <a:lnTo>
                  <a:pt x="0" y="1532"/>
                </a:lnTo>
                <a:lnTo>
                  <a:pt x="0" y="603"/>
                </a:lnTo>
                <a:close/>
                <a:moveTo>
                  <a:pt x="394" y="904"/>
                </a:moveTo>
                <a:lnTo>
                  <a:pt x="524" y="904"/>
                </a:lnTo>
                <a:lnTo>
                  <a:pt x="524" y="1532"/>
                </a:lnTo>
                <a:lnTo>
                  <a:pt x="394" y="1532"/>
                </a:lnTo>
                <a:lnTo>
                  <a:pt x="394" y="904"/>
                </a:lnTo>
                <a:close/>
                <a:moveTo>
                  <a:pt x="794" y="0"/>
                </a:moveTo>
                <a:lnTo>
                  <a:pt x="918" y="0"/>
                </a:lnTo>
                <a:lnTo>
                  <a:pt x="918" y="1532"/>
                </a:lnTo>
                <a:lnTo>
                  <a:pt x="794" y="1532"/>
                </a:lnTo>
                <a:lnTo>
                  <a:pt x="794" y="0"/>
                </a:lnTo>
                <a:close/>
                <a:moveTo>
                  <a:pt x="1988" y="1396"/>
                </a:moveTo>
                <a:lnTo>
                  <a:pt x="2111" y="1396"/>
                </a:lnTo>
                <a:lnTo>
                  <a:pt x="2111" y="1532"/>
                </a:lnTo>
                <a:lnTo>
                  <a:pt x="1988" y="1532"/>
                </a:lnTo>
                <a:lnTo>
                  <a:pt x="1988" y="1396"/>
                </a:lnTo>
                <a:close/>
                <a:moveTo>
                  <a:pt x="2388" y="1323"/>
                </a:moveTo>
                <a:lnTo>
                  <a:pt x="2511" y="1323"/>
                </a:lnTo>
                <a:lnTo>
                  <a:pt x="2511" y="1532"/>
                </a:lnTo>
                <a:lnTo>
                  <a:pt x="2388" y="1532"/>
                </a:lnTo>
                <a:lnTo>
                  <a:pt x="2388" y="1323"/>
                </a:lnTo>
                <a:close/>
                <a:moveTo>
                  <a:pt x="2782" y="394"/>
                </a:moveTo>
                <a:lnTo>
                  <a:pt x="2905" y="394"/>
                </a:lnTo>
                <a:lnTo>
                  <a:pt x="2905" y="1532"/>
                </a:lnTo>
                <a:lnTo>
                  <a:pt x="2782" y="1532"/>
                </a:lnTo>
                <a:lnTo>
                  <a:pt x="2782" y="394"/>
                </a:lnTo>
                <a:close/>
              </a:path>
            </a:pathLst>
          </a:custGeom>
          <a:solidFill>
            <a:srgbClr val="5B9BD5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9" name="Freeform 7"/>
          <p:cNvSpPr>
            <a:spLocks noEditPoints="1"/>
          </p:cNvSpPr>
          <p:nvPr/>
        </p:nvSpPr>
        <p:spPr bwMode="auto">
          <a:xfrm>
            <a:off x="2430463" y="3184526"/>
            <a:ext cx="65088" cy="342900"/>
          </a:xfrm>
          <a:custGeom>
            <a:avLst/>
            <a:gdLst>
              <a:gd name="T0" fmla="*/ 23 w 41"/>
              <a:gd name="T1" fmla="*/ 111 h 216"/>
              <a:gd name="T2" fmla="*/ 23 w 41"/>
              <a:gd name="T3" fmla="*/ 216 h 216"/>
              <a:gd name="T4" fmla="*/ 23 w 41"/>
              <a:gd name="T5" fmla="*/ 111 h 216"/>
              <a:gd name="T6" fmla="*/ 23 w 41"/>
              <a:gd name="T7" fmla="*/ 0 h 216"/>
              <a:gd name="T8" fmla="*/ 0 w 41"/>
              <a:gd name="T9" fmla="*/ 216 h 216"/>
              <a:gd name="T10" fmla="*/ 41 w 41"/>
              <a:gd name="T11" fmla="*/ 216 h 216"/>
              <a:gd name="T12" fmla="*/ 0 w 41"/>
              <a:gd name="T13" fmla="*/ 0 h 216"/>
              <a:gd name="T14" fmla="*/ 41 w 41"/>
              <a:gd name="T15" fmla="*/ 0 h 2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1" h="216">
                <a:moveTo>
                  <a:pt x="23" y="111"/>
                </a:moveTo>
                <a:lnTo>
                  <a:pt x="23" y="216"/>
                </a:lnTo>
                <a:moveTo>
                  <a:pt x="23" y="111"/>
                </a:moveTo>
                <a:lnTo>
                  <a:pt x="23" y="0"/>
                </a:lnTo>
                <a:moveTo>
                  <a:pt x="0" y="216"/>
                </a:moveTo>
                <a:lnTo>
                  <a:pt x="41" y="216"/>
                </a:lnTo>
                <a:moveTo>
                  <a:pt x="0" y="0"/>
                </a:moveTo>
                <a:lnTo>
                  <a:pt x="41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0" name="Freeform 8"/>
          <p:cNvSpPr>
            <a:spLocks noEditPoints="1"/>
          </p:cNvSpPr>
          <p:nvPr/>
        </p:nvSpPr>
        <p:spPr bwMode="auto">
          <a:xfrm>
            <a:off x="3063876" y="3536951"/>
            <a:ext cx="66675" cy="585788"/>
          </a:xfrm>
          <a:custGeom>
            <a:avLst/>
            <a:gdLst>
              <a:gd name="T0" fmla="*/ 18 w 42"/>
              <a:gd name="T1" fmla="*/ 184 h 369"/>
              <a:gd name="T2" fmla="*/ 18 w 42"/>
              <a:gd name="T3" fmla="*/ 369 h 369"/>
              <a:gd name="T4" fmla="*/ 18 w 42"/>
              <a:gd name="T5" fmla="*/ 184 h 369"/>
              <a:gd name="T6" fmla="*/ 18 w 42"/>
              <a:gd name="T7" fmla="*/ 0 h 369"/>
              <a:gd name="T8" fmla="*/ 0 w 42"/>
              <a:gd name="T9" fmla="*/ 369 h 369"/>
              <a:gd name="T10" fmla="*/ 42 w 42"/>
              <a:gd name="T11" fmla="*/ 369 h 369"/>
              <a:gd name="T12" fmla="*/ 0 w 42"/>
              <a:gd name="T13" fmla="*/ 0 h 369"/>
              <a:gd name="T14" fmla="*/ 42 w 42"/>
              <a:gd name="T15" fmla="*/ 0 h 3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2" h="369">
                <a:moveTo>
                  <a:pt x="18" y="184"/>
                </a:moveTo>
                <a:lnTo>
                  <a:pt x="18" y="369"/>
                </a:lnTo>
                <a:moveTo>
                  <a:pt x="18" y="184"/>
                </a:moveTo>
                <a:lnTo>
                  <a:pt x="18" y="0"/>
                </a:lnTo>
                <a:moveTo>
                  <a:pt x="0" y="369"/>
                </a:moveTo>
                <a:lnTo>
                  <a:pt x="42" y="369"/>
                </a:lnTo>
                <a:moveTo>
                  <a:pt x="0" y="0"/>
                </a:moveTo>
                <a:lnTo>
                  <a:pt x="42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1" name="Freeform 9"/>
          <p:cNvSpPr>
            <a:spLocks noEditPoints="1"/>
          </p:cNvSpPr>
          <p:nvPr/>
        </p:nvSpPr>
        <p:spPr bwMode="auto">
          <a:xfrm>
            <a:off x="3689351" y="2325688"/>
            <a:ext cx="74613" cy="146050"/>
          </a:xfrm>
          <a:custGeom>
            <a:avLst/>
            <a:gdLst>
              <a:gd name="T0" fmla="*/ 24 w 47"/>
              <a:gd name="T1" fmla="*/ 49 h 92"/>
              <a:gd name="T2" fmla="*/ 24 w 47"/>
              <a:gd name="T3" fmla="*/ 92 h 92"/>
              <a:gd name="T4" fmla="*/ 24 w 47"/>
              <a:gd name="T5" fmla="*/ 49 h 92"/>
              <a:gd name="T6" fmla="*/ 24 w 47"/>
              <a:gd name="T7" fmla="*/ 0 h 92"/>
              <a:gd name="T8" fmla="*/ 0 w 47"/>
              <a:gd name="T9" fmla="*/ 92 h 92"/>
              <a:gd name="T10" fmla="*/ 47 w 47"/>
              <a:gd name="T11" fmla="*/ 92 h 92"/>
              <a:gd name="T12" fmla="*/ 0 w 47"/>
              <a:gd name="T13" fmla="*/ 0 h 92"/>
              <a:gd name="T14" fmla="*/ 47 w 47"/>
              <a:gd name="T15" fmla="*/ 0 h 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7" h="92">
                <a:moveTo>
                  <a:pt x="24" y="49"/>
                </a:moveTo>
                <a:lnTo>
                  <a:pt x="24" y="92"/>
                </a:lnTo>
                <a:moveTo>
                  <a:pt x="24" y="49"/>
                </a:moveTo>
                <a:lnTo>
                  <a:pt x="24" y="0"/>
                </a:lnTo>
                <a:moveTo>
                  <a:pt x="0" y="92"/>
                </a:moveTo>
                <a:lnTo>
                  <a:pt x="47" y="92"/>
                </a:lnTo>
                <a:moveTo>
                  <a:pt x="0" y="0"/>
                </a:moveTo>
                <a:lnTo>
                  <a:pt x="4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2" name="Freeform 10"/>
          <p:cNvSpPr>
            <a:spLocks noEditPoints="1"/>
          </p:cNvSpPr>
          <p:nvPr/>
        </p:nvSpPr>
        <p:spPr bwMode="auto">
          <a:xfrm>
            <a:off x="5584826" y="4473576"/>
            <a:ext cx="74613" cy="282575"/>
          </a:xfrm>
          <a:custGeom>
            <a:avLst/>
            <a:gdLst>
              <a:gd name="T0" fmla="*/ 24 w 47"/>
              <a:gd name="T1" fmla="*/ 92 h 178"/>
              <a:gd name="T2" fmla="*/ 24 w 47"/>
              <a:gd name="T3" fmla="*/ 178 h 178"/>
              <a:gd name="T4" fmla="*/ 24 w 47"/>
              <a:gd name="T5" fmla="*/ 92 h 178"/>
              <a:gd name="T6" fmla="*/ 24 w 47"/>
              <a:gd name="T7" fmla="*/ 0 h 178"/>
              <a:gd name="T8" fmla="*/ 0 w 47"/>
              <a:gd name="T9" fmla="*/ 178 h 178"/>
              <a:gd name="T10" fmla="*/ 47 w 47"/>
              <a:gd name="T11" fmla="*/ 178 h 178"/>
              <a:gd name="T12" fmla="*/ 0 w 47"/>
              <a:gd name="T13" fmla="*/ 0 h 178"/>
              <a:gd name="T14" fmla="*/ 47 w 47"/>
              <a:gd name="T15" fmla="*/ 0 h 1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7" h="178">
                <a:moveTo>
                  <a:pt x="24" y="92"/>
                </a:moveTo>
                <a:lnTo>
                  <a:pt x="24" y="178"/>
                </a:lnTo>
                <a:moveTo>
                  <a:pt x="24" y="92"/>
                </a:moveTo>
                <a:lnTo>
                  <a:pt x="24" y="0"/>
                </a:lnTo>
                <a:moveTo>
                  <a:pt x="0" y="178"/>
                </a:moveTo>
                <a:lnTo>
                  <a:pt x="47" y="178"/>
                </a:lnTo>
                <a:moveTo>
                  <a:pt x="0" y="0"/>
                </a:moveTo>
                <a:lnTo>
                  <a:pt x="47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3" name="Freeform 11"/>
          <p:cNvSpPr>
            <a:spLocks noEditPoints="1"/>
          </p:cNvSpPr>
          <p:nvPr/>
        </p:nvSpPr>
        <p:spPr bwMode="auto">
          <a:xfrm>
            <a:off x="6219826" y="4395788"/>
            <a:ext cx="65088" cy="214313"/>
          </a:xfrm>
          <a:custGeom>
            <a:avLst/>
            <a:gdLst>
              <a:gd name="T0" fmla="*/ 23 w 41"/>
              <a:gd name="T1" fmla="*/ 68 h 135"/>
              <a:gd name="T2" fmla="*/ 23 w 41"/>
              <a:gd name="T3" fmla="*/ 135 h 135"/>
              <a:gd name="T4" fmla="*/ 23 w 41"/>
              <a:gd name="T5" fmla="*/ 68 h 135"/>
              <a:gd name="T6" fmla="*/ 23 w 41"/>
              <a:gd name="T7" fmla="*/ 0 h 135"/>
              <a:gd name="T8" fmla="*/ 0 w 41"/>
              <a:gd name="T9" fmla="*/ 135 h 135"/>
              <a:gd name="T10" fmla="*/ 41 w 41"/>
              <a:gd name="T11" fmla="*/ 135 h 135"/>
              <a:gd name="T12" fmla="*/ 0 w 41"/>
              <a:gd name="T13" fmla="*/ 0 h 135"/>
              <a:gd name="T14" fmla="*/ 41 w 41"/>
              <a:gd name="T15" fmla="*/ 0 h 13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1" h="135">
                <a:moveTo>
                  <a:pt x="23" y="68"/>
                </a:moveTo>
                <a:lnTo>
                  <a:pt x="23" y="135"/>
                </a:lnTo>
                <a:moveTo>
                  <a:pt x="23" y="68"/>
                </a:moveTo>
                <a:lnTo>
                  <a:pt x="23" y="0"/>
                </a:lnTo>
                <a:moveTo>
                  <a:pt x="0" y="135"/>
                </a:moveTo>
                <a:lnTo>
                  <a:pt x="41" y="135"/>
                </a:lnTo>
                <a:moveTo>
                  <a:pt x="0" y="0"/>
                </a:moveTo>
                <a:lnTo>
                  <a:pt x="41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4" name="Freeform 12"/>
          <p:cNvSpPr>
            <a:spLocks noEditPoints="1"/>
          </p:cNvSpPr>
          <p:nvPr/>
        </p:nvSpPr>
        <p:spPr bwMode="auto">
          <a:xfrm>
            <a:off x="6854826" y="2970213"/>
            <a:ext cx="65088" cy="107950"/>
          </a:xfrm>
          <a:custGeom>
            <a:avLst/>
            <a:gdLst>
              <a:gd name="T0" fmla="*/ 17 w 41"/>
              <a:gd name="T1" fmla="*/ 31 h 68"/>
              <a:gd name="T2" fmla="*/ 17 w 41"/>
              <a:gd name="T3" fmla="*/ 68 h 68"/>
              <a:gd name="T4" fmla="*/ 17 w 41"/>
              <a:gd name="T5" fmla="*/ 31 h 68"/>
              <a:gd name="T6" fmla="*/ 17 w 41"/>
              <a:gd name="T7" fmla="*/ 0 h 68"/>
              <a:gd name="T8" fmla="*/ 0 w 41"/>
              <a:gd name="T9" fmla="*/ 68 h 68"/>
              <a:gd name="T10" fmla="*/ 41 w 41"/>
              <a:gd name="T11" fmla="*/ 68 h 68"/>
              <a:gd name="T12" fmla="*/ 0 w 41"/>
              <a:gd name="T13" fmla="*/ 0 h 68"/>
              <a:gd name="T14" fmla="*/ 41 w 41"/>
              <a:gd name="T15" fmla="*/ 0 h 6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1" h="68">
                <a:moveTo>
                  <a:pt x="17" y="31"/>
                </a:moveTo>
                <a:lnTo>
                  <a:pt x="17" y="68"/>
                </a:lnTo>
                <a:moveTo>
                  <a:pt x="17" y="31"/>
                </a:moveTo>
                <a:lnTo>
                  <a:pt x="17" y="0"/>
                </a:lnTo>
                <a:moveTo>
                  <a:pt x="0" y="68"/>
                </a:moveTo>
                <a:lnTo>
                  <a:pt x="41" y="68"/>
                </a:lnTo>
                <a:moveTo>
                  <a:pt x="0" y="0"/>
                </a:moveTo>
                <a:lnTo>
                  <a:pt x="41" y="0"/>
                </a:lnTo>
              </a:path>
            </a:pathLst>
          </a:custGeom>
          <a:noFill/>
          <a:ln w="9525" cap="flat">
            <a:solidFill>
              <a:srgbClr val="595959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5" name="Line 13"/>
          <p:cNvSpPr>
            <a:spLocks noChangeShapeType="1"/>
          </p:cNvSpPr>
          <p:nvPr/>
        </p:nvSpPr>
        <p:spPr bwMode="auto">
          <a:xfrm flipV="1">
            <a:off x="2144713" y="1852613"/>
            <a:ext cx="0" cy="297815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6" name="Freeform 14"/>
          <p:cNvSpPr>
            <a:spLocks noEditPoints="1"/>
          </p:cNvSpPr>
          <p:nvPr/>
        </p:nvSpPr>
        <p:spPr bwMode="auto">
          <a:xfrm>
            <a:off x="2108201" y="1852613"/>
            <a:ext cx="36513" cy="2978150"/>
          </a:xfrm>
          <a:custGeom>
            <a:avLst/>
            <a:gdLst>
              <a:gd name="T0" fmla="*/ 0 w 23"/>
              <a:gd name="T1" fmla="*/ 1876 h 1876"/>
              <a:gd name="T2" fmla="*/ 23 w 23"/>
              <a:gd name="T3" fmla="*/ 1876 h 1876"/>
              <a:gd name="T4" fmla="*/ 0 w 23"/>
              <a:gd name="T5" fmla="*/ 1562 h 1876"/>
              <a:gd name="T6" fmla="*/ 23 w 23"/>
              <a:gd name="T7" fmla="*/ 1562 h 1876"/>
              <a:gd name="T8" fmla="*/ 0 w 23"/>
              <a:gd name="T9" fmla="*/ 1254 h 1876"/>
              <a:gd name="T10" fmla="*/ 23 w 23"/>
              <a:gd name="T11" fmla="*/ 1254 h 1876"/>
              <a:gd name="T12" fmla="*/ 0 w 23"/>
              <a:gd name="T13" fmla="*/ 941 h 1876"/>
              <a:gd name="T14" fmla="*/ 23 w 23"/>
              <a:gd name="T15" fmla="*/ 941 h 1876"/>
              <a:gd name="T16" fmla="*/ 0 w 23"/>
              <a:gd name="T17" fmla="*/ 627 h 1876"/>
              <a:gd name="T18" fmla="*/ 23 w 23"/>
              <a:gd name="T19" fmla="*/ 627 h 1876"/>
              <a:gd name="T20" fmla="*/ 0 w 23"/>
              <a:gd name="T21" fmla="*/ 313 h 1876"/>
              <a:gd name="T22" fmla="*/ 23 w 23"/>
              <a:gd name="T23" fmla="*/ 313 h 1876"/>
              <a:gd name="T24" fmla="*/ 0 w 23"/>
              <a:gd name="T25" fmla="*/ 0 h 1876"/>
              <a:gd name="T26" fmla="*/ 23 w 23"/>
              <a:gd name="T27" fmla="*/ 0 h 18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3" h="1876">
                <a:moveTo>
                  <a:pt x="0" y="1876"/>
                </a:moveTo>
                <a:lnTo>
                  <a:pt x="23" y="1876"/>
                </a:lnTo>
                <a:moveTo>
                  <a:pt x="0" y="1562"/>
                </a:moveTo>
                <a:lnTo>
                  <a:pt x="23" y="1562"/>
                </a:lnTo>
                <a:moveTo>
                  <a:pt x="0" y="1254"/>
                </a:moveTo>
                <a:lnTo>
                  <a:pt x="23" y="1254"/>
                </a:lnTo>
                <a:moveTo>
                  <a:pt x="0" y="941"/>
                </a:moveTo>
                <a:lnTo>
                  <a:pt x="23" y="941"/>
                </a:lnTo>
                <a:moveTo>
                  <a:pt x="0" y="627"/>
                </a:moveTo>
                <a:lnTo>
                  <a:pt x="23" y="627"/>
                </a:lnTo>
                <a:moveTo>
                  <a:pt x="0" y="313"/>
                </a:moveTo>
                <a:lnTo>
                  <a:pt x="23" y="313"/>
                </a:lnTo>
                <a:moveTo>
                  <a:pt x="0" y="0"/>
                </a:moveTo>
                <a:lnTo>
                  <a:pt x="23" y="0"/>
                </a:lnTo>
              </a:path>
            </a:pathLst>
          </a:cu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7" name="Line 15"/>
          <p:cNvSpPr>
            <a:spLocks noChangeShapeType="1"/>
          </p:cNvSpPr>
          <p:nvPr/>
        </p:nvSpPr>
        <p:spPr bwMode="auto">
          <a:xfrm>
            <a:off x="2144713" y="4830763"/>
            <a:ext cx="5059363" cy="0"/>
          </a:xfrm>
          <a:prstGeom prst="line">
            <a:avLst/>
          </a:prstGeom>
          <a:noFill/>
          <a:ln w="19050" cap="flat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zh-TW" altLang="en-US"/>
          </a:p>
        </p:txBody>
      </p:sp>
      <p:sp>
        <p:nvSpPr>
          <p:cNvPr id="18" name="Rectangle 16"/>
          <p:cNvSpPr>
            <a:spLocks noChangeArrowheads="1"/>
          </p:cNvSpPr>
          <p:nvPr/>
        </p:nvSpPr>
        <p:spPr bwMode="auto">
          <a:xfrm>
            <a:off x="1955801" y="4760913"/>
            <a:ext cx="1492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Rectangle 17"/>
          <p:cNvSpPr>
            <a:spLocks noChangeArrowheads="1"/>
          </p:cNvSpPr>
          <p:nvPr/>
        </p:nvSpPr>
        <p:spPr bwMode="auto">
          <a:xfrm>
            <a:off x="1878013" y="4265613"/>
            <a:ext cx="23336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0" name="Rectangle 18"/>
          <p:cNvSpPr>
            <a:spLocks noChangeArrowheads="1"/>
          </p:cNvSpPr>
          <p:nvPr/>
        </p:nvSpPr>
        <p:spPr bwMode="auto">
          <a:xfrm>
            <a:off x="1878013" y="3768726"/>
            <a:ext cx="23336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2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1" name="Rectangle 19"/>
          <p:cNvSpPr>
            <a:spLocks noChangeArrowheads="1"/>
          </p:cNvSpPr>
          <p:nvPr/>
        </p:nvSpPr>
        <p:spPr bwMode="auto">
          <a:xfrm>
            <a:off x="1878013" y="3271838"/>
            <a:ext cx="2333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3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2" name="Rectangle 20"/>
          <p:cNvSpPr>
            <a:spLocks noChangeArrowheads="1"/>
          </p:cNvSpPr>
          <p:nvPr/>
        </p:nvSpPr>
        <p:spPr bwMode="auto">
          <a:xfrm>
            <a:off x="1878013" y="2776538"/>
            <a:ext cx="23336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4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3" name="Rectangle 21"/>
          <p:cNvSpPr>
            <a:spLocks noChangeArrowheads="1"/>
          </p:cNvSpPr>
          <p:nvPr/>
        </p:nvSpPr>
        <p:spPr bwMode="auto">
          <a:xfrm>
            <a:off x="1878013" y="2279651"/>
            <a:ext cx="233363" cy="2143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5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4" name="Rectangle 22"/>
          <p:cNvSpPr>
            <a:spLocks noChangeArrowheads="1"/>
          </p:cNvSpPr>
          <p:nvPr/>
        </p:nvSpPr>
        <p:spPr bwMode="auto">
          <a:xfrm>
            <a:off x="1878013" y="1782763"/>
            <a:ext cx="233363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zh-TW" altLang="zh-TW" sz="12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60</a:t>
            </a:r>
            <a:endParaRPr kumimoji="0" lang="zh-TW" altLang="zh-TW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" name="文字方塊 31"/>
          <p:cNvSpPr txBox="1"/>
          <p:nvPr/>
        </p:nvSpPr>
        <p:spPr>
          <a:xfrm>
            <a:off x="7042419" y="0"/>
            <a:ext cx="2101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upplementary Fig 2</a:t>
            </a:r>
            <a:endParaRPr lang="zh-TW" altLang="en-US" dirty="0"/>
          </a:p>
        </p:txBody>
      </p:sp>
      <p:sp>
        <p:nvSpPr>
          <p:cNvPr id="33" name="文字方塊 32"/>
          <p:cNvSpPr txBox="1"/>
          <p:nvPr/>
        </p:nvSpPr>
        <p:spPr>
          <a:xfrm rot="16200000">
            <a:off x="457387" y="3101813"/>
            <a:ext cx="21588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limbing percentage (%)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" name="群組 37"/>
          <p:cNvGrpSpPr/>
          <p:nvPr/>
        </p:nvGrpSpPr>
        <p:grpSpPr>
          <a:xfrm>
            <a:off x="2325158" y="5003026"/>
            <a:ext cx="1712201" cy="307777"/>
            <a:chOff x="2325158" y="5003026"/>
            <a:chExt cx="1712201" cy="307777"/>
          </a:xfrm>
        </p:grpSpPr>
        <p:sp>
          <p:nvSpPr>
            <p:cNvPr id="34" name="Rectangle 148"/>
            <p:cNvSpPr>
              <a:spLocks noChangeArrowheads="1"/>
            </p:cNvSpPr>
            <p:nvPr/>
          </p:nvSpPr>
          <p:spPr bwMode="auto">
            <a:xfrm>
              <a:off x="2325158" y="5003026"/>
              <a:ext cx="2997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EK(-)</a:t>
              </a:r>
              <a:endParaRPr kumimoji="0" lang="zh-TW" altLang="zh-TW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5" name="Rectangle 152"/>
            <p:cNvSpPr>
              <a:spLocks noChangeArrowheads="1"/>
            </p:cNvSpPr>
            <p:nvPr/>
          </p:nvSpPr>
          <p:spPr bwMode="auto">
            <a:xfrm>
              <a:off x="2809633" y="5003026"/>
              <a:ext cx="56265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kumimoji="0" lang="zh-TW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E</a:t>
              </a:r>
              <a:r>
                <a:rPr kumimoji="0" lang="en-US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K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en-US" altLang="zh-TW" sz="1000" dirty="0" smtClean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lvl="0" algn="ctr"/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25 </a:t>
              </a:r>
              <a:r>
                <a:rPr lang="el-GR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μ</a:t>
              </a:r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g/ml</a:t>
              </a:r>
              <a:endParaRPr kumimoji="0" lang="zh-TW" altLang="zh-TW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7" name="Rectangle 152"/>
            <p:cNvSpPr>
              <a:spLocks noChangeArrowheads="1"/>
            </p:cNvSpPr>
            <p:nvPr/>
          </p:nvSpPr>
          <p:spPr bwMode="auto">
            <a:xfrm>
              <a:off x="3474704" y="5003026"/>
              <a:ext cx="56265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kumimoji="0" lang="zh-TW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E</a:t>
              </a:r>
              <a:r>
                <a:rPr kumimoji="0" lang="en-US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K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en-US" altLang="zh-TW" sz="1000" dirty="0" smtClean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lvl="0" algn="ctr"/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25</a:t>
              </a:r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l-GR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μ</a:t>
              </a:r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g/ml</a:t>
              </a:r>
              <a:endParaRPr kumimoji="0" lang="zh-TW" altLang="zh-TW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39" name="群組 38"/>
          <p:cNvGrpSpPr/>
          <p:nvPr/>
        </p:nvGrpSpPr>
        <p:grpSpPr>
          <a:xfrm>
            <a:off x="5485934" y="4999978"/>
            <a:ext cx="1712201" cy="307777"/>
            <a:chOff x="2325158" y="5003026"/>
            <a:chExt cx="1712201" cy="307777"/>
          </a:xfrm>
        </p:grpSpPr>
        <p:sp>
          <p:nvSpPr>
            <p:cNvPr id="40" name="Rectangle 148"/>
            <p:cNvSpPr>
              <a:spLocks noChangeArrowheads="1"/>
            </p:cNvSpPr>
            <p:nvPr/>
          </p:nvSpPr>
          <p:spPr bwMode="auto">
            <a:xfrm>
              <a:off x="2325158" y="5003026"/>
              <a:ext cx="29976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EK(-)</a:t>
              </a:r>
              <a:endParaRPr kumimoji="0" lang="zh-TW" altLang="zh-TW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1" name="Rectangle 152"/>
            <p:cNvSpPr>
              <a:spLocks noChangeArrowheads="1"/>
            </p:cNvSpPr>
            <p:nvPr/>
          </p:nvSpPr>
          <p:spPr bwMode="auto">
            <a:xfrm>
              <a:off x="2809633" y="5003026"/>
              <a:ext cx="562654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kumimoji="0" lang="zh-TW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E</a:t>
              </a:r>
              <a:r>
                <a:rPr kumimoji="0" lang="en-US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K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en-US" altLang="zh-TW" sz="1000" dirty="0" smtClean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lvl="0" algn="ctr"/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1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25 </a:t>
              </a:r>
              <a:r>
                <a:rPr lang="el-GR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μ</a:t>
              </a:r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g/ml</a:t>
              </a:r>
              <a:endParaRPr kumimoji="0" lang="zh-TW" altLang="zh-TW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42" name="Rectangle 152"/>
            <p:cNvSpPr>
              <a:spLocks noChangeArrowheads="1"/>
            </p:cNvSpPr>
            <p:nvPr/>
          </p:nvSpPr>
          <p:spPr bwMode="auto">
            <a:xfrm>
              <a:off x="3474704" y="5003026"/>
              <a:ext cx="56265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lvl="0" algn="ctr"/>
              <a:r>
                <a:rPr kumimoji="0" lang="zh-TW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E</a:t>
              </a:r>
              <a:r>
                <a:rPr kumimoji="0" lang="en-US" altLang="zh-TW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ea typeface="新細明體" panose="02020500000000000000" pitchFamily="18" charset="-120"/>
                  <a:cs typeface="Arial" panose="020B0604020202020204" pitchFamily="34" charset="0"/>
                </a:rPr>
                <a:t>K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endParaRPr lang="en-US" altLang="zh-TW" sz="1000" dirty="0" smtClean="0">
                <a:solidFill>
                  <a:srgbClr val="000000"/>
                </a:solidFill>
                <a:cs typeface="Arial" panose="020B0604020202020204" pitchFamily="34" charset="0"/>
              </a:endParaRPr>
            </a:p>
            <a:p>
              <a:pPr lvl="0" algn="ctr"/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25</a:t>
              </a:r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r>
                <a:rPr lang="el-GR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</a:t>
              </a:r>
              <a:r>
                <a:rPr lang="el-GR" altLang="zh-TW" sz="1000" dirty="0">
                  <a:solidFill>
                    <a:srgbClr val="000000"/>
                  </a:solidFill>
                  <a:cs typeface="Arial" panose="020B0604020202020204" pitchFamily="34" charset="0"/>
                </a:rPr>
                <a:t>μ</a:t>
              </a:r>
              <a:r>
                <a:rPr lang="en-US" altLang="zh-TW" sz="10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g/ml</a:t>
              </a:r>
              <a:endParaRPr kumimoji="0" lang="zh-TW" altLang="zh-TW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sp>
        <p:nvSpPr>
          <p:cNvPr id="43" name="文字方塊 42"/>
          <p:cNvSpPr txBox="1"/>
          <p:nvPr/>
        </p:nvSpPr>
        <p:spPr>
          <a:xfrm>
            <a:off x="2727337" y="5438203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ay 36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字方塊 43"/>
          <p:cNvSpPr txBox="1"/>
          <p:nvPr/>
        </p:nvSpPr>
        <p:spPr>
          <a:xfrm>
            <a:off x="5878969" y="5444299"/>
            <a:ext cx="762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Day 40</a:t>
            </a:r>
            <a:endParaRPr lang="zh-TW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6" name="直線接點 45"/>
          <p:cNvCxnSpPr/>
          <p:nvPr/>
        </p:nvCxnSpPr>
        <p:spPr>
          <a:xfrm>
            <a:off x="2190433" y="5422392"/>
            <a:ext cx="189264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接點 48"/>
          <p:cNvCxnSpPr/>
          <p:nvPr/>
        </p:nvCxnSpPr>
        <p:spPr>
          <a:xfrm>
            <a:off x="5342065" y="5419344"/>
            <a:ext cx="189264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文字方塊 49"/>
          <p:cNvSpPr txBox="1"/>
          <p:nvPr/>
        </p:nvSpPr>
        <p:spPr>
          <a:xfrm>
            <a:off x="3525913" y="2048256"/>
            <a:ext cx="4334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**</a:t>
            </a:r>
            <a:endParaRPr lang="zh-TW" altLang="en-US" dirty="0"/>
          </a:p>
        </p:txBody>
      </p:sp>
      <p:sp>
        <p:nvSpPr>
          <p:cNvPr id="51" name="文字方塊 50"/>
          <p:cNvSpPr txBox="1"/>
          <p:nvPr/>
        </p:nvSpPr>
        <p:spPr>
          <a:xfrm>
            <a:off x="6622681" y="2657856"/>
            <a:ext cx="6163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***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9427864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群組 42"/>
          <p:cNvGrpSpPr/>
          <p:nvPr/>
        </p:nvGrpSpPr>
        <p:grpSpPr>
          <a:xfrm>
            <a:off x="1468536" y="1523614"/>
            <a:ext cx="5756534" cy="4034663"/>
            <a:chOff x="1468536" y="1523614"/>
            <a:chExt cx="5756534" cy="4034663"/>
          </a:xfrm>
        </p:grpSpPr>
        <p:sp>
          <p:nvSpPr>
            <p:cNvPr id="8" name="Freeform 6"/>
            <p:cNvSpPr>
              <a:spLocks noEditPoints="1"/>
            </p:cNvSpPr>
            <p:nvPr/>
          </p:nvSpPr>
          <p:spPr bwMode="auto">
            <a:xfrm>
              <a:off x="2471738" y="2233613"/>
              <a:ext cx="4443413" cy="2576513"/>
            </a:xfrm>
            <a:custGeom>
              <a:avLst/>
              <a:gdLst>
                <a:gd name="T0" fmla="*/ 0 w 2799"/>
                <a:gd name="T1" fmla="*/ 0 h 1623"/>
                <a:gd name="T2" fmla="*/ 165 w 2799"/>
                <a:gd name="T3" fmla="*/ 0 h 1623"/>
                <a:gd name="T4" fmla="*/ 165 w 2799"/>
                <a:gd name="T5" fmla="*/ 1623 h 1623"/>
                <a:gd name="T6" fmla="*/ 0 w 2799"/>
                <a:gd name="T7" fmla="*/ 1623 h 1623"/>
                <a:gd name="T8" fmla="*/ 0 w 2799"/>
                <a:gd name="T9" fmla="*/ 0 h 1623"/>
                <a:gd name="T10" fmla="*/ 523 w 2799"/>
                <a:gd name="T11" fmla="*/ 0 h 1623"/>
                <a:gd name="T12" fmla="*/ 688 w 2799"/>
                <a:gd name="T13" fmla="*/ 0 h 1623"/>
                <a:gd name="T14" fmla="*/ 688 w 2799"/>
                <a:gd name="T15" fmla="*/ 1623 h 1623"/>
                <a:gd name="T16" fmla="*/ 523 w 2799"/>
                <a:gd name="T17" fmla="*/ 1623 h 1623"/>
                <a:gd name="T18" fmla="*/ 523 w 2799"/>
                <a:gd name="T19" fmla="*/ 0 h 1623"/>
                <a:gd name="T20" fmla="*/ 2105 w 2799"/>
                <a:gd name="T21" fmla="*/ 30 h 1623"/>
                <a:gd name="T22" fmla="*/ 2270 w 2799"/>
                <a:gd name="T23" fmla="*/ 30 h 1623"/>
                <a:gd name="T24" fmla="*/ 2270 w 2799"/>
                <a:gd name="T25" fmla="*/ 1623 h 1623"/>
                <a:gd name="T26" fmla="*/ 2105 w 2799"/>
                <a:gd name="T27" fmla="*/ 1623 h 1623"/>
                <a:gd name="T28" fmla="*/ 2105 w 2799"/>
                <a:gd name="T29" fmla="*/ 30 h 1623"/>
                <a:gd name="T30" fmla="*/ 2634 w 2799"/>
                <a:gd name="T31" fmla="*/ 264 h 1623"/>
                <a:gd name="T32" fmla="*/ 2799 w 2799"/>
                <a:gd name="T33" fmla="*/ 264 h 1623"/>
                <a:gd name="T34" fmla="*/ 2799 w 2799"/>
                <a:gd name="T35" fmla="*/ 1623 h 1623"/>
                <a:gd name="T36" fmla="*/ 2634 w 2799"/>
                <a:gd name="T37" fmla="*/ 1623 h 1623"/>
                <a:gd name="T38" fmla="*/ 2634 w 2799"/>
                <a:gd name="T39" fmla="*/ 264 h 16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2799" h="1623">
                  <a:moveTo>
                    <a:pt x="0" y="0"/>
                  </a:moveTo>
                  <a:lnTo>
                    <a:pt x="165" y="0"/>
                  </a:lnTo>
                  <a:lnTo>
                    <a:pt x="165" y="1623"/>
                  </a:lnTo>
                  <a:lnTo>
                    <a:pt x="0" y="1623"/>
                  </a:lnTo>
                  <a:lnTo>
                    <a:pt x="0" y="0"/>
                  </a:lnTo>
                  <a:close/>
                  <a:moveTo>
                    <a:pt x="523" y="0"/>
                  </a:moveTo>
                  <a:lnTo>
                    <a:pt x="688" y="0"/>
                  </a:lnTo>
                  <a:lnTo>
                    <a:pt x="688" y="1623"/>
                  </a:lnTo>
                  <a:lnTo>
                    <a:pt x="523" y="1623"/>
                  </a:lnTo>
                  <a:lnTo>
                    <a:pt x="523" y="0"/>
                  </a:lnTo>
                  <a:close/>
                  <a:moveTo>
                    <a:pt x="2105" y="30"/>
                  </a:moveTo>
                  <a:lnTo>
                    <a:pt x="2270" y="30"/>
                  </a:lnTo>
                  <a:lnTo>
                    <a:pt x="2270" y="1623"/>
                  </a:lnTo>
                  <a:lnTo>
                    <a:pt x="2105" y="1623"/>
                  </a:lnTo>
                  <a:lnTo>
                    <a:pt x="2105" y="30"/>
                  </a:lnTo>
                  <a:close/>
                  <a:moveTo>
                    <a:pt x="2634" y="264"/>
                  </a:moveTo>
                  <a:lnTo>
                    <a:pt x="2799" y="264"/>
                  </a:lnTo>
                  <a:lnTo>
                    <a:pt x="2799" y="1623"/>
                  </a:lnTo>
                  <a:lnTo>
                    <a:pt x="2634" y="1623"/>
                  </a:lnTo>
                  <a:lnTo>
                    <a:pt x="2634" y="264"/>
                  </a:lnTo>
                  <a:close/>
                </a:path>
              </a:pathLst>
            </a:custGeom>
            <a:solidFill>
              <a:srgbClr val="5B9BD5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9" name="Freeform 7"/>
            <p:cNvSpPr>
              <a:spLocks noEditPoints="1"/>
            </p:cNvSpPr>
            <p:nvPr/>
          </p:nvSpPr>
          <p:spPr bwMode="auto">
            <a:xfrm>
              <a:off x="2560638" y="2090738"/>
              <a:ext cx="74613" cy="274638"/>
            </a:xfrm>
            <a:custGeom>
              <a:avLst/>
              <a:gdLst>
                <a:gd name="T0" fmla="*/ 23 w 47"/>
                <a:gd name="T1" fmla="*/ 87 h 173"/>
                <a:gd name="T2" fmla="*/ 23 w 47"/>
                <a:gd name="T3" fmla="*/ 173 h 173"/>
                <a:gd name="T4" fmla="*/ 23 w 47"/>
                <a:gd name="T5" fmla="*/ 87 h 173"/>
                <a:gd name="T6" fmla="*/ 23 w 47"/>
                <a:gd name="T7" fmla="*/ 0 h 173"/>
                <a:gd name="T8" fmla="*/ 0 w 47"/>
                <a:gd name="T9" fmla="*/ 173 h 173"/>
                <a:gd name="T10" fmla="*/ 47 w 47"/>
                <a:gd name="T11" fmla="*/ 173 h 173"/>
                <a:gd name="T12" fmla="*/ 0 w 47"/>
                <a:gd name="T13" fmla="*/ 0 h 173"/>
                <a:gd name="T14" fmla="*/ 47 w 47"/>
                <a:gd name="T15" fmla="*/ 0 h 1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7" h="173">
                  <a:moveTo>
                    <a:pt x="23" y="87"/>
                  </a:moveTo>
                  <a:lnTo>
                    <a:pt x="23" y="173"/>
                  </a:lnTo>
                  <a:moveTo>
                    <a:pt x="23" y="87"/>
                  </a:moveTo>
                  <a:lnTo>
                    <a:pt x="23" y="0"/>
                  </a:lnTo>
                  <a:moveTo>
                    <a:pt x="0" y="173"/>
                  </a:moveTo>
                  <a:lnTo>
                    <a:pt x="47" y="173"/>
                  </a:lnTo>
                  <a:moveTo>
                    <a:pt x="0" y="0"/>
                  </a:moveTo>
                  <a:lnTo>
                    <a:pt x="47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0" name="Freeform 8"/>
            <p:cNvSpPr>
              <a:spLocks noEditPoints="1"/>
            </p:cNvSpPr>
            <p:nvPr/>
          </p:nvSpPr>
          <p:spPr bwMode="auto">
            <a:xfrm>
              <a:off x="3400426" y="2012951"/>
              <a:ext cx="65088" cy="449263"/>
            </a:xfrm>
            <a:custGeom>
              <a:avLst/>
              <a:gdLst>
                <a:gd name="T0" fmla="*/ 24 w 41"/>
                <a:gd name="T1" fmla="*/ 142 h 283"/>
                <a:gd name="T2" fmla="*/ 24 w 41"/>
                <a:gd name="T3" fmla="*/ 283 h 283"/>
                <a:gd name="T4" fmla="*/ 24 w 41"/>
                <a:gd name="T5" fmla="*/ 142 h 283"/>
                <a:gd name="T6" fmla="*/ 24 w 41"/>
                <a:gd name="T7" fmla="*/ 0 h 283"/>
                <a:gd name="T8" fmla="*/ 0 w 41"/>
                <a:gd name="T9" fmla="*/ 283 h 283"/>
                <a:gd name="T10" fmla="*/ 41 w 41"/>
                <a:gd name="T11" fmla="*/ 283 h 283"/>
                <a:gd name="T12" fmla="*/ 0 w 41"/>
                <a:gd name="T13" fmla="*/ 0 h 283"/>
                <a:gd name="T14" fmla="*/ 41 w 41"/>
                <a:gd name="T15" fmla="*/ 0 h 2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1" h="283">
                  <a:moveTo>
                    <a:pt x="24" y="142"/>
                  </a:moveTo>
                  <a:lnTo>
                    <a:pt x="24" y="283"/>
                  </a:lnTo>
                  <a:moveTo>
                    <a:pt x="24" y="142"/>
                  </a:moveTo>
                  <a:lnTo>
                    <a:pt x="24" y="0"/>
                  </a:lnTo>
                  <a:moveTo>
                    <a:pt x="0" y="283"/>
                  </a:moveTo>
                  <a:lnTo>
                    <a:pt x="41" y="283"/>
                  </a:lnTo>
                  <a:moveTo>
                    <a:pt x="0" y="0"/>
                  </a:moveTo>
                  <a:lnTo>
                    <a:pt x="41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1" name="Freeform 9"/>
            <p:cNvSpPr>
              <a:spLocks noEditPoints="1"/>
            </p:cNvSpPr>
            <p:nvPr/>
          </p:nvSpPr>
          <p:spPr bwMode="auto">
            <a:xfrm>
              <a:off x="5911851" y="2062163"/>
              <a:ext cx="65088" cy="449263"/>
            </a:xfrm>
            <a:custGeom>
              <a:avLst/>
              <a:gdLst>
                <a:gd name="T0" fmla="*/ 23 w 41"/>
                <a:gd name="T1" fmla="*/ 141 h 283"/>
                <a:gd name="T2" fmla="*/ 23 w 41"/>
                <a:gd name="T3" fmla="*/ 283 h 283"/>
                <a:gd name="T4" fmla="*/ 23 w 41"/>
                <a:gd name="T5" fmla="*/ 141 h 283"/>
                <a:gd name="T6" fmla="*/ 23 w 41"/>
                <a:gd name="T7" fmla="*/ 0 h 283"/>
                <a:gd name="T8" fmla="*/ 0 w 41"/>
                <a:gd name="T9" fmla="*/ 283 h 283"/>
                <a:gd name="T10" fmla="*/ 41 w 41"/>
                <a:gd name="T11" fmla="*/ 283 h 283"/>
                <a:gd name="T12" fmla="*/ 0 w 41"/>
                <a:gd name="T13" fmla="*/ 0 h 283"/>
                <a:gd name="T14" fmla="*/ 41 w 41"/>
                <a:gd name="T15" fmla="*/ 0 h 2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1" h="283">
                  <a:moveTo>
                    <a:pt x="23" y="141"/>
                  </a:moveTo>
                  <a:lnTo>
                    <a:pt x="23" y="283"/>
                  </a:lnTo>
                  <a:moveTo>
                    <a:pt x="23" y="141"/>
                  </a:moveTo>
                  <a:lnTo>
                    <a:pt x="23" y="0"/>
                  </a:lnTo>
                  <a:moveTo>
                    <a:pt x="0" y="283"/>
                  </a:moveTo>
                  <a:lnTo>
                    <a:pt x="41" y="283"/>
                  </a:lnTo>
                  <a:moveTo>
                    <a:pt x="0" y="0"/>
                  </a:moveTo>
                  <a:lnTo>
                    <a:pt x="41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2" name="Freeform 10"/>
            <p:cNvSpPr>
              <a:spLocks noEditPoints="1"/>
            </p:cNvSpPr>
            <p:nvPr/>
          </p:nvSpPr>
          <p:spPr bwMode="auto">
            <a:xfrm>
              <a:off x="6751638" y="2316163"/>
              <a:ext cx="65088" cy="673100"/>
            </a:xfrm>
            <a:custGeom>
              <a:avLst/>
              <a:gdLst>
                <a:gd name="T0" fmla="*/ 18 w 41"/>
                <a:gd name="T1" fmla="*/ 215 h 424"/>
                <a:gd name="T2" fmla="*/ 18 w 41"/>
                <a:gd name="T3" fmla="*/ 424 h 424"/>
                <a:gd name="T4" fmla="*/ 18 w 41"/>
                <a:gd name="T5" fmla="*/ 215 h 424"/>
                <a:gd name="T6" fmla="*/ 18 w 41"/>
                <a:gd name="T7" fmla="*/ 0 h 424"/>
                <a:gd name="T8" fmla="*/ 0 w 41"/>
                <a:gd name="T9" fmla="*/ 424 h 424"/>
                <a:gd name="T10" fmla="*/ 41 w 41"/>
                <a:gd name="T11" fmla="*/ 424 h 424"/>
                <a:gd name="T12" fmla="*/ 0 w 41"/>
                <a:gd name="T13" fmla="*/ 0 h 424"/>
                <a:gd name="T14" fmla="*/ 41 w 41"/>
                <a:gd name="T15" fmla="*/ 0 h 4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41" h="424">
                  <a:moveTo>
                    <a:pt x="18" y="215"/>
                  </a:moveTo>
                  <a:lnTo>
                    <a:pt x="18" y="424"/>
                  </a:lnTo>
                  <a:moveTo>
                    <a:pt x="18" y="215"/>
                  </a:moveTo>
                  <a:lnTo>
                    <a:pt x="18" y="0"/>
                  </a:lnTo>
                  <a:moveTo>
                    <a:pt x="0" y="424"/>
                  </a:moveTo>
                  <a:lnTo>
                    <a:pt x="41" y="424"/>
                  </a:lnTo>
                  <a:moveTo>
                    <a:pt x="0" y="0"/>
                  </a:moveTo>
                  <a:lnTo>
                    <a:pt x="41" y="0"/>
                  </a:lnTo>
                </a:path>
              </a:pathLst>
            </a:custGeom>
            <a:noFill/>
            <a:ln w="9525" cap="flat">
              <a:solidFill>
                <a:srgbClr val="59595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3" name="Line 11"/>
            <p:cNvSpPr>
              <a:spLocks noChangeShapeType="1"/>
            </p:cNvSpPr>
            <p:nvPr/>
          </p:nvSpPr>
          <p:spPr bwMode="auto">
            <a:xfrm flipV="1">
              <a:off x="2182813" y="1852613"/>
              <a:ext cx="0" cy="2957513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4" name="Freeform 12"/>
            <p:cNvSpPr>
              <a:spLocks noEditPoints="1"/>
            </p:cNvSpPr>
            <p:nvPr/>
          </p:nvSpPr>
          <p:spPr bwMode="auto">
            <a:xfrm>
              <a:off x="2135188" y="1852613"/>
              <a:ext cx="47625" cy="2957513"/>
            </a:xfrm>
            <a:custGeom>
              <a:avLst/>
              <a:gdLst>
                <a:gd name="T0" fmla="*/ 0 w 30"/>
                <a:gd name="T1" fmla="*/ 1863 h 1863"/>
                <a:gd name="T2" fmla="*/ 30 w 30"/>
                <a:gd name="T3" fmla="*/ 1863 h 1863"/>
                <a:gd name="T4" fmla="*/ 0 w 30"/>
                <a:gd name="T5" fmla="*/ 1679 h 1863"/>
                <a:gd name="T6" fmla="*/ 30 w 30"/>
                <a:gd name="T7" fmla="*/ 1679 h 1863"/>
                <a:gd name="T8" fmla="*/ 0 w 30"/>
                <a:gd name="T9" fmla="*/ 1488 h 1863"/>
                <a:gd name="T10" fmla="*/ 30 w 30"/>
                <a:gd name="T11" fmla="*/ 1488 h 1863"/>
                <a:gd name="T12" fmla="*/ 0 w 30"/>
                <a:gd name="T13" fmla="*/ 1304 h 1863"/>
                <a:gd name="T14" fmla="*/ 30 w 30"/>
                <a:gd name="T15" fmla="*/ 1304 h 1863"/>
                <a:gd name="T16" fmla="*/ 0 w 30"/>
                <a:gd name="T17" fmla="*/ 1119 h 1863"/>
                <a:gd name="T18" fmla="*/ 30 w 30"/>
                <a:gd name="T19" fmla="*/ 1119 h 1863"/>
                <a:gd name="T20" fmla="*/ 0 w 30"/>
                <a:gd name="T21" fmla="*/ 928 h 1863"/>
                <a:gd name="T22" fmla="*/ 30 w 30"/>
                <a:gd name="T23" fmla="*/ 928 h 1863"/>
                <a:gd name="T24" fmla="*/ 0 w 30"/>
                <a:gd name="T25" fmla="*/ 744 h 1863"/>
                <a:gd name="T26" fmla="*/ 30 w 30"/>
                <a:gd name="T27" fmla="*/ 744 h 1863"/>
                <a:gd name="T28" fmla="*/ 0 w 30"/>
                <a:gd name="T29" fmla="*/ 559 h 1863"/>
                <a:gd name="T30" fmla="*/ 30 w 30"/>
                <a:gd name="T31" fmla="*/ 559 h 1863"/>
                <a:gd name="T32" fmla="*/ 0 w 30"/>
                <a:gd name="T33" fmla="*/ 369 h 1863"/>
                <a:gd name="T34" fmla="*/ 30 w 30"/>
                <a:gd name="T35" fmla="*/ 369 h 1863"/>
                <a:gd name="T36" fmla="*/ 0 w 30"/>
                <a:gd name="T37" fmla="*/ 184 h 1863"/>
                <a:gd name="T38" fmla="*/ 30 w 30"/>
                <a:gd name="T39" fmla="*/ 184 h 1863"/>
                <a:gd name="T40" fmla="*/ 0 w 30"/>
                <a:gd name="T41" fmla="*/ 0 h 1863"/>
                <a:gd name="T42" fmla="*/ 30 w 30"/>
                <a:gd name="T43" fmla="*/ 0 h 186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30" h="1863">
                  <a:moveTo>
                    <a:pt x="0" y="1863"/>
                  </a:moveTo>
                  <a:lnTo>
                    <a:pt x="30" y="1863"/>
                  </a:lnTo>
                  <a:moveTo>
                    <a:pt x="0" y="1679"/>
                  </a:moveTo>
                  <a:lnTo>
                    <a:pt x="30" y="1679"/>
                  </a:lnTo>
                  <a:moveTo>
                    <a:pt x="0" y="1488"/>
                  </a:moveTo>
                  <a:lnTo>
                    <a:pt x="30" y="1488"/>
                  </a:lnTo>
                  <a:moveTo>
                    <a:pt x="0" y="1304"/>
                  </a:moveTo>
                  <a:lnTo>
                    <a:pt x="30" y="1304"/>
                  </a:lnTo>
                  <a:moveTo>
                    <a:pt x="0" y="1119"/>
                  </a:moveTo>
                  <a:lnTo>
                    <a:pt x="30" y="1119"/>
                  </a:lnTo>
                  <a:moveTo>
                    <a:pt x="0" y="928"/>
                  </a:moveTo>
                  <a:lnTo>
                    <a:pt x="30" y="928"/>
                  </a:lnTo>
                  <a:moveTo>
                    <a:pt x="0" y="744"/>
                  </a:moveTo>
                  <a:lnTo>
                    <a:pt x="30" y="744"/>
                  </a:lnTo>
                  <a:moveTo>
                    <a:pt x="0" y="559"/>
                  </a:moveTo>
                  <a:lnTo>
                    <a:pt x="30" y="559"/>
                  </a:lnTo>
                  <a:moveTo>
                    <a:pt x="0" y="369"/>
                  </a:moveTo>
                  <a:lnTo>
                    <a:pt x="30" y="369"/>
                  </a:lnTo>
                  <a:moveTo>
                    <a:pt x="0" y="184"/>
                  </a:moveTo>
                  <a:lnTo>
                    <a:pt x="30" y="184"/>
                  </a:lnTo>
                  <a:moveTo>
                    <a:pt x="0" y="0"/>
                  </a:moveTo>
                  <a:lnTo>
                    <a:pt x="30" y="0"/>
                  </a:lnTo>
                </a:path>
              </a:pathLst>
            </a:cu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5" name="Line 13"/>
            <p:cNvSpPr>
              <a:spLocks noChangeShapeType="1"/>
            </p:cNvSpPr>
            <p:nvPr/>
          </p:nvSpPr>
          <p:spPr bwMode="auto">
            <a:xfrm>
              <a:off x="2182813" y="4810126"/>
              <a:ext cx="5021263" cy="0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16" name="Rectangle 14"/>
            <p:cNvSpPr>
              <a:spLocks noChangeArrowheads="1"/>
            </p:cNvSpPr>
            <p:nvPr/>
          </p:nvSpPr>
          <p:spPr bwMode="auto">
            <a:xfrm>
              <a:off x="1984376" y="471646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" name="Rectangle 15"/>
            <p:cNvSpPr>
              <a:spLocks noChangeArrowheads="1"/>
            </p:cNvSpPr>
            <p:nvPr/>
          </p:nvSpPr>
          <p:spPr bwMode="auto">
            <a:xfrm>
              <a:off x="1878013" y="4421188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1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" name="Rectangle 16"/>
            <p:cNvSpPr>
              <a:spLocks noChangeArrowheads="1"/>
            </p:cNvSpPr>
            <p:nvPr/>
          </p:nvSpPr>
          <p:spPr bwMode="auto">
            <a:xfrm>
              <a:off x="1878013" y="4122738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2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Rectangle 17"/>
            <p:cNvSpPr>
              <a:spLocks noChangeArrowheads="1"/>
            </p:cNvSpPr>
            <p:nvPr/>
          </p:nvSpPr>
          <p:spPr bwMode="auto">
            <a:xfrm>
              <a:off x="1878013" y="3829051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3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" name="Rectangle 18"/>
            <p:cNvSpPr>
              <a:spLocks noChangeArrowheads="1"/>
            </p:cNvSpPr>
            <p:nvPr/>
          </p:nvSpPr>
          <p:spPr bwMode="auto">
            <a:xfrm>
              <a:off x="1878013" y="3533776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4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Rectangle 19"/>
            <p:cNvSpPr>
              <a:spLocks noChangeArrowheads="1"/>
            </p:cNvSpPr>
            <p:nvPr/>
          </p:nvSpPr>
          <p:spPr bwMode="auto">
            <a:xfrm>
              <a:off x="1878013" y="3236913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5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" name="Rectangle 20"/>
            <p:cNvSpPr>
              <a:spLocks noChangeArrowheads="1"/>
            </p:cNvSpPr>
            <p:nvPr/>
          </p:nvSpPr>
          <p:spPr bwMode="auto">
            <a:xfrm>
              <a:off x="1878013" y="2941638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6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Rectangle 21"/>
            <p:cNvSpPr>
              <a:spLocks noChangeArrowheads="1"/>
            </p:cNvSpPr>
            <p:nvPr/>
          </p:nvSpPr>
          <p:spPr bwMode="auto">
            <a:xfrm>
              <a:off x="1878013" y="2646363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7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" name="Rectangle 22"/>
            <p:cNvSpPr>
              <a:spLocks noChangeArrowheads="1"/>
            </p:cNvSpPr>
            <p:nvPr/>
          </p:nvSpPr>
          <p:spPr bwMode="auto">
            <a:xfrm>
              <a:off x="1878013" y="2349501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8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23"/>
            <p:cNvSpPr>
              <a:spLocks noChangeArrowheads="1"/>
            </p:cNvSpPr>
            <p:nvPr/>
          </p:nvSpPr>
          <p:spPr bwMode="auto">
            <a:xfrm>
              <a:off x="1878013" y="2054226"/>
              <a:ext cx="2132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0.9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6" name="Rectangle 24"/>
            <p:cNvSpPr>
              <a:spLocks noChangeArrowheads="1"/>
            </p:cNvSpPr>
            <p:nvPr/>
          </p:nvSpPr>
          <p:spPr bwMode="auto">
            <a:xfrm>
              <a:off x="1984376" y="1758951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1</a:t>
              </a:r>
              <a:endParaRPr kumimoji="0" lang="zh-TW" altLang="zh-TW" sz="1800" b="0" i="0" u="none" strike="noStrike" cap="none" normalizeH="0" baseline="0" smtClean="0">
                <a:ln>
                  <a:noFill/>
                </a:ln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7" name="Rectangle 25"/>
            <p:cNvSpPr>
              <a:spLocks noChangeArrowheads="1"/>
            </p:cNvSpPr>
            <p:nvPr/>
          </p:nvSpPr>
          <p:spPr bwMode="auto">
            <a:xfrm>
              <a:off x="2368551" y="4906963"/>
              <a:ext cx="61555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D EK(-)</a:t>
              </a:r>
            </a:p>
          </p:txBody>
        </p:sp>
        <p:sp>
          <p:nvSpPr>
            <p:cNvPr id="28" name="Rectangle 26"/>
            <p:cNvSpPr>
              <a:spLocks noChangeArrowheads="1"/>
            </p:cNvSpPr>
            <p:nvPr/>
          </p:nvSpPr>
          <p:spPr bwMode="auto">
            <a:xfrm>
              <a:off x="3192463" y="4906963"/>
              <a:ext cx="65402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D EK(+)</a:t>
              </a:r>
            </a:p>
          </p:txBody>
        </p:sp>
        <p:sp>
          <p:nvSpPr>
            <p:cNvPr id="29" name="Rectangle 27"/>
            <p:cNvSpPr>
              <a:spLocks noChangeArrowheads="1"/>
            </p:cNvSpPr>
            <p:nvPr/>
          </p:nvSpPr>
          <p:spPr bwMode="auto">
            <a:xfrm>
              <a:off x="5716588" y="4906963"/>
              <a:ext cx="61555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D EK(-)</a:t>
              </a:r>
            </a:p>
          </p:txBody>
        </p:sp>
        <p:sp>
          <p:nvSpPr>
            <p:cNvPr id="30" name="Rectangle 28"/>
            <p:cNvSpPr>
              <a:spLocks noChangeArrowheads="1"/>
            </p:cNvSpPr>
            <p:nvPr/>
          </p:nvSpPr>
          <p:spPr bwMode="auto">
            <a:xfrm>
              <a:off x="6540501" y="4906963"/>
              <a:ext cx="65402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TW" altLang="zh-TW" sz="1200" b="0" i="0" u="none" strike="noStrike" cap="none" normalizeH="0" baseline="0" smtClean="0">
                  <a:ln>
                    <a:noFill/>
                  </a:ln>
                  <a:effectLst/>
                  <a:cs typeface="Arial" panose="020B0604020202020204" pitchFamily="34" charset="0"/>
                </a:rPr>
                <a:t>AD EK(+)</a:t>
              </a:r>
            </a:p>
          </p:txBody>
        </p:sp>
        <p:sp>
          <p:nvSpPr>
            <p:cNvPr id="32" name="文字方塊 31"/>
            <p:cNvSpPr txBox="1"/>
            <p:nvPr/>
          </p:nvSpPr>
          <p:spPr>
            <a:xfrm rot="16200000">
              <a:off x="868045" y="2920782"/>
              <a:ext cx="15087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versive Index</a:t>
              </a:r>
              <a:endParaRPr lang="zh-TW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線接點 33"/>
            <p:cNvCxnSpPr/>
            <p:nvPr/>
          </p:nvCxnSpPr>
          <p:spPr>
            <a:xfrm>
              <a:off x="2341119" y="5230368"/>
              <a:ext cx="147793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字方塊 34"/>
            <p:cNvSpPr txBox="1"/>
            <p:nvPr/>
          </p:nvSpPr>
          <p:spPr>
            <a:xfrm>
              <a:off x="2723770" y="5281278"/>
              <a:ext cx="7132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H</a:t>
              </a:r>
              <a:endParaRPr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" name="直線接點 35"/>
            <p:cNvCxnSpPr/>
            <p:nvPr/>
          </p:nvCxnSpPr>
          <p:spPr>
            <a:xfrm>
              <a:off x="5747133" y="5230368"/>
              <a:ext cx="147793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文字方塊 36"/>
            <p:cNvSpPr txBox="1"/>
            <p:nvPr/>
          </p:nvSpPr>
          <p:spPr>
            <a:xfrm>
              <a:off x="6093208" y="5281278"/>
              <a:ext cx="7132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CT</a:t>
              </a:r>
              <a:endParaRPr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9" name="直線接點 38"/>
            <p:cNvCxnSpPr/>
            <p:nvPr/>
          </p:nvCxnSpPr>
          <p:spPr>
            <a:xfrm>
              <a:off x="2508314" y="1852613"/>
              <a:ext cx="9937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" name="文字方塊 39"/>
            <p:cNvSpPr txBox="1"/>
            <p:nvPr/>
          </p:nvSpPr>
          <p:spPr>
            <a:xfrm>
              <a:off x="2803335" y="1523614"/>
              <a:ext cx="4037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altLang="zh-TW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" name="直線接點 40"/>
            <p:cNvCxnSpPr/>
            <p:nvPr/>
          </p:nvCxnSpPr>
          <p:spPr>
            <a:xfrm>
              <a:off x="5835253" y="1943617"/>
              <a:ext cx="99377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文字方塊 41"/>
            <p:cNvSpPr txBox="1"/>
            <p:nvPr/>
          </p:nvSpPr>
          <p:spPr>
            <a:xfrm>
              <a:off x="6130274" y="1614618"/>
              <a:ext cx="40373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altLang="zh-TW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zh-TW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4" name="文字方塊 43"/>
          <p:cNvSpPr txBox="1"/>
          <p:nvPr/>
        </p:nvSpPr>
        <p:spPr>
          <a:xfrm>
            <a:off x="7042419" y="0"/>
            <a:ext cx="21015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upplementary Fig 3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6785872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</TotalTime>
  <Words>143</Words>
  <Application>Microsoft Office PowerPoint</Application>
  <PresentationFormat>如螢幕大小 (4:3)</PresentationFormat>
  <Paragraphs>65</Paragraphs>
  <Slides>4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Windows 使用者</dc:creator>
  <cp:lastModifiedBy>Windows 使用者</cp:lastModifiedBy>
  <cp:revision>8</cp:revision>
  <dcterms:created xsi:type="dcterms:W3CDTF">2021-08-18T03:40:21Z</dcterms:created>
  <dcterms:modified xsi:type="dcterms:W3CDTF">2021-08-18T06:30:07Z</dcterms:modified>
</cp:coreProperties>
</file>